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ppt/charts/chart4.xml" ContentType="application/vnd.openxmlformats-officedocument.drawingml.chart+xml"/>
  <Override PartName="/ppt/drawings/drawing1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drawings/drawing2.xml" ContentType="application/vnd.openxmlformats-officedocument.drawingml.chartshapes+xml"/>
  <Override PartName="/ppt/notesSlides/notesSlide3.xml" ContentType="application/vnd.openxmlformats-officedocument.presentationml.notesSlide+xml"/>
  <Override PartName="/ppt/charts/chart6.xml" ContentType="application/vnd.openxmlformats-officedocument.drawingml.char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7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83" r:id="rId2"/>
    <p:sldId id="282" r:id="rId3"/>
    <p:sldId id="284" r:id="rId4"/>
    <p:sldId id="285" r:id="rId5"/>
    <p:sldId id="259" r:id="rId6"/>
    <p:sldId id="260" r:id="rId7"/>
    <p:sldId id="261" r:id="rId8"/>
    <p:sldId id="262" r:id="rId9"/>
    <p:sldId id="277" r:id="rId10"/>
    <p:sldId id="268" r:id="rId11"/>
    <p:sldId id="279" r:id="rId12"/>
    <p:sldId id="264" r:id="rId13"/>
    <p:sldId id="275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00"/>
    <a:srgbClr val="23F913"/>
    <a:srgbClr val="FF9933"/>
    <a:srgbClr val="FF6600"/>
    <a:srgbClr val="FF33CC"/>
    <a:srgbClr val="800080"/>
    <a:srgbClr val="99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47" autoAdjust="0"/>
    <p:restoredTop sz="94660"/>
  </p:normalViewPr>
  <p:slideViewPr>
    <p:cSldViewPr>
      <p:cViewPr varScale="1">
        <p:scale>
          <a:sx n="84" d="100"/>
          <a:sy n="84" d="100"/>
        </p:scale>
        <p:origin x="1454" y="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usha%202019%20folder\USHA%20FOLDER\MS_STG_PBJ18_FTR2019\2019\STGFM_TABLES_UK0401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HA%20%20ALL%20FOLDERS\DATA%20PHD\USHA_PHD\2018\APRIL_STG%20FM%20MS2018\ICRISAT%20daily%20weather%20dataE1E2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HA%20%20ALL%20FOLDERS\DATA%20PHD\USHA_PHD\2018\APRIL_STG%20FM%20MS2018\ICRISAT%20daily%20weather%20dataE1E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HA%20%20ALL%20FOLDERS\DATA%20PHD\USHA_PHD\2015\MS_Stg%20fine%20map_GWAS_dec2015\tables_supples_finemapStg_2015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HA%20%20ALL%20FOLDERS\DATA%20PHD\USHA_PHD\USHA%20THESIS\RESULTS\MEAN%20PERFORMANCES_GENVSPHY_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Table 1 '!$D$21</c:f>
              <c:strCache>
                <c:ptCount val="1"/>
                <c:pt idx="0">
                  <c:v>RSG04008-6</c:v>
                </c:pt>
              </c:strCache>
            </c:strRef>
          </c:tx>
          <c:spPr>
            <a:solidFill>
              <a:srgbClr val="45A709"/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>
                <a:solidFill>
                  <a:schemeClr val="tx2">
                    <a:lumMod val="75000"/>
                  </a:schemeClr>
                </a:solidFill>
                <a:round/>
              </a:ln>
              <a:effectLst/>
            </c:spPr>
          </c:errBars>
          <c:cat>
            <c:strRef>
              <c:f>'Table 1 '!$C$22:$C$42</c:f>
              <c:strCache>
                <c:ptCount val="21"/>
                <c:pt idx="0">
                  <c:v>%GL 7 DAF_E1</c:v>
                </c:pt>
                <c:pt idx="1">
                  <c:v>%GL 14 DAF_E1</c:v>
                </c:pt>
                <c:pt idx="2">
                  <c:v>%GL 21 DAF_E1</c:v>
                </c:pt>
                <c:pt idx="3">
                  <c:v>%GL 28 DAF_E1</c:v>
                </c:pt>
                <c:pt idx="4">
                  <c:v>%GL 35 DAF_E1</c:v>
                </c:pt>
                <c:pt idx="5">
                  <c:v>%GL 42 DAF_E1</c:v>
                </c:pt>
                <c:pt idx="6">
                  <c:v>%GL 49 DAF_E1</c:v>
                </c:pt>
                <c:pt idx="7">
                  <c:v>%GL 7 DAF_E2</c:v>
                </c:pt>
                <c:pt idx="8">
                  <c:v>%GL 14 DAF_E2</c:v>
                </c:pt>
                <c:pt idx="9">
                  <c:v>%GL 21 DAF_E2</c:v>
                </c:pt>
                <c:pt idx="10">
                  <c:v>%GL 28 DAF_E2</c:v>
                </c:pt>
                <c:pt idx="11">
                  <c:v>%GL 35 DAF_E2</c:v>
                </c:pt>
                <c:pt idx="12">
                  <c:v>%GL 42 DAF_E2</c:v>
                </c:pt>
                <c:pt idx="13">
                  <c:v>%GL 49 DAF_E2</c:v>
                </c:pt>
                <c:pt idx="14">
                  <c:v>%GL 7 DAF_across</c:v>
                </c:pt>
                <c:pt idx="15">
                  <c:v>%GL 14 DAF_across</c:v>
                </c:pt>
                <c:pt idx="16">
                  <c:v>%GL 21 DAF_across</c:v>
                </c:pt>
                <c:pt idx="17">
                  <c:v>%GL 28 DAF_across</c:v>
                </c:pt>
                <c:pt idx="18">
                  <c:v>%GL 35 DAF_across</c:v>
                </c:pt>
                <c:pt idx="19">
                  <c:v>%GL 42 DAF_across</c:v>
                </c:pt>
                <c:pt idx="20">
                  <c:v>%GL 49 DAF_across</c:v>
                </c:pt>
              </c:strCache>
            </c:strRef>
          </c:cat>
          <c:val>
            <c:numRef>
              <c:f>'Table 1 '!$D$22:$D$42</c:f>
              <c:numCache>
                <c:formatCode>0.00</c:formatCode>
                <c:ptCount val="21"/>
                <c:pt idx="0">
                  <c:v>88.38</c:v>
                </c:pt>
                <c:pt idx="1">
                  <c:v>79.180000000000007</c:v>
                </c:pt>
                <c:pt idx="2">
                  <c:v>62.52</c:v>
                </c:pt>
                <c:pt idx="3">
                  <c:v>47</c:v>
                </c:pt>
                <c:pt idx="4">
                  <c:v>34.46</c:v>
                </c:pt>
                <c:pt idx="5">
                  <c:v>23.44</c:v>
                </c:pt>
                <c:pt idx="6">
                  <c:v>17.12</c:v>
                </c:pt>
                <c:pt idx="7" formatCode="General">
                  <c:v>99.03</c:v>
                </c:pt>
                <c:pt idx="8" formatCode="General">
                  <c:v>84.22</c:v>
                </c:pt>
                <c:pt idx="9" formatCode="General">
                  <c:v>74.39</c:v>
                </c:pt>
                <c:pt idx="10" formatCode="General">
                  <c:v>66.489999999999995</c:v>
                </c:pt>
                <c:pt idx="11" formatCode="General">
                  <c:v>54.17</c:v>
                </c:pt>
                <c:pt idx="12" formatCode="General">
                  <c:v>25.96</c:v>
                </c:pt>
                <c:pt idx="13" formatCode="General">
                  <c:v>11.68</c:v>
                </c:pt>
                <c:pt idx="14">
                  <c:v>93.86</c:v>
                </c:pt>
                <c:pt idx="15">
                  <c:v>81.709999999999994</c:v>
                </c:pt>
                <c:pt idx="16">
                  <c:v>68.430000000000007</c:v>
                </c:pt>
                <c:pt idx="17">
                  <c:v>56.83</c:v>
                </c:pt>
                <c:pt idx="18">
                  <c:v>44.39</c:v>
                </c:pt>
                <c:pt idx="19">
                  <c:v>25.28</c:v>
                </c:pt>
                <c:pt idx="20">
                  <c:v>14.67</c:v>
                </c:pt>
              </c:numCache>
            </c:numRef>
          </c:val>
        </c:ser>
        <c:ser>
          <c:idx val="1"/>
          <c:order val="1"/>
          <c:tx>
            <c:strRef>
              <c:f>'Table 1 '!$E$21</c:f>
              <c:strCache>
                <c:ptCount val="1"/>
                <c:pt idx="0">
                  <c:v>F4 progen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>
                <a:solidFill>
                  <a:schemeClr val="tx2">
                    <a:lumMod val="75000"/>
                  </a:schemeClr>
                </a:solidFill>
                <a:round/>
              </a:ln>
              <a:effectLst/>
            </c:spPr>
          </c:errBars>
          <c:cat>
            <c:strRef>
              <c:f>'Table 1 '!$C$22:$C$42</c:f>
              <c:strCache>
                <c:ptCount val="21"/>
                <c:pt idx="0">
                  <c:v>%GL 7 DAF_E1</c:v>
                </c:pt>
                <c:pt idx="1">
                  <c:v>%GL 14 DAF_E1</c:v>
                </c:pt>
                <c:pt idx="2">
                  <c:v>%GL 21 DAF_E1</c:v>
                </c:pt>
                <c:pt idx="3">
                  <c:v>%GL 28 DAF_E1</c:v>
                </c:pt>
                <c:pt idx="4">
                  <c:v>%GL 35 DAF_E1</c:v>
                </c:pt>
                <c:pt idx="5">
                  <c:v>%GL 42 DAF_E1</c:v>
                </c:pt>
                <c:pt idx="6">
                  <c:v>%GL 49 DAF_E1</c:v>
                </c:pt>
                <c:pt idx="7">
                  <c:v>%GL 7 DAF_E2</c:v>
                </c:pt>
                <c:pt idx="8">
                  <c:v>%GL 14 DAF_E2</c:v>
                </c:pt>
                <c:pt idx="9">
                  <c:v>%GL 21 DAF_E2</c:v>
                </c:pt>
                <c:pt idx="10">
                  <c:v>%GL 28 DAF_E2</c:v>
                </c:pt>
                <c:pt idx="11">
                  <c:v>%GL 35 DAF_E2</c:v>
                </c:pt>
                <c:pt idx="12">
                  <c:v>%GL 42 DAF_E2</c:v>
                </c:pt>
                <c:pt idx="13">
                  <c:v>%GL 49 DAF_E2</c:v>
                </c:pt>
                <c:pt idx="14">
                  <c:v>%GL 7 DAF_across</c:v>
                </c:pt>
                <c:pt idx="15">
                  <c:v>%GL 14 DAF_across</c:v>
                </c:pt>
                <c:pt idx="16">
                  <c:v>%GL 21 DAF_across</c:v>
                </c:pt>
                <c:pt idx="17">
                  <c:v>%GL 28 DAF_across</c:v>
                </c:pt>
                <c:pt idx="18">
                  <c:v>%GL 35 DAF_across</c:v>
                </c:pt>
                <c:pt idx="19">
                  <c:v>%GL 42 DAF_across</c:v>
                </c:pt>
                <c:pt idx="20">
                  <c:v>%GL 49 DAF_across</c:v>
                </c:pt>
              </c:strCache>
            </c:strRef>
          </c:cat>
          <c:val>
            <c:numRef>
              <c:f>'Table 1 '!$E$22:$E$42</c:f>
              <c:numCache>
                <c:formatCode>General</c:formatCode>
                <c:ptCount val="21"/>
                <c:pt idx="0">
                  <c:v>88.67</c:v>
                </c:pt>
                <c:pt idx="1">
                  <c:v>79.58</c:v>
                </c:pt>
                <c:pt idx="2">
                  <c:v>65.959999999999994</c:v>
                </c:pt>
                <c:pt idx="3">
                  <c:v>50.72</c:v>
                </c:pt>
                <c:pt idx="4">
                  <c:v>39.49</c:v>
                </c:pt>
                <c:pt idx="5">
                  <c:v>29.41</c:v>
                </c:pt>
                <c:pt idx="6">
                  <c:v>18.559999999999999</c:v>
                </c:pt>
                <c:pt idx="7">
                  <c:v>96.05</c:v>
                </c:pt>
                <c:pt idx="8">
                  <c:v>84.29</c:v>
                </c:pt>
                <c:pt idx="9">
                  <c:v>73.73</c:v>
                </c:pt>
                <c:pt idx="10">
                  <c:v>65.03</c:v>
                </c:pt>
                <c:pt idx="11">
                  <c:v>51.57</c:v>
                </c:pt>
                <c:pt idx="12">
                  <c:v>39.729999999999997</c:v>
                </c:pt>
                <c:pt idx="13">
                  <c:v>29.07</c:v>
                </c:pt>
                <c:pt idx="14" formatCode="0.00">
                  <c:v>92.36</c:v>
                </c:pt>
                <c:pt idx="15" formatCode="0.00">
                  <c:v>81.94</c:v>
                </c:pt>
                <c:pt idx="16" formatCode="0.00">
                  <c:v>69.849999999999994</c:v>
                </c:pt>
                <c:pt idx="17" formatCode="0.00">
                  <c:v>57.88</c:v>
                </c:pt>
                <c:pt idx="18" formatCode="0.00">
                  <c:v>45.53</c:v>
                </c:pt>
                <c:pt idx="19" formatCode="0.00">
                  <c:v>34.71</c:v>
                </c:pt>
                <c:pt idx="20" formatCode="0.00">
                  <c:v>24.01</c:v>
                </c:pt>
              </c:numCache>
            </c:numRef>
          </c:val>
        </c:ser>
        <c:ser>
          <c:idx val="2"/>
          <c:order val="2"/>
          <c:tx>
            <c:strRef>
              <c:f>'Table 1 '!$F$21</c:f>
              <c:strCache>
                <c:ptCount val="1"/>
                <c:pt idx="0">
                  <c:v>J2614-11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>
                <a:solidFill>
                  <a:schemeClr val="tx2">
                    <a:lumMod val="75000"/>
                  </a:schemeClr>
                </a:solidFill>
                <a:round/>
              </a:ln>
              <a:effectLst/>
            </c:spPr>
          </c:errBars>
          <c:cat>
            <c:strRef>
              <c:f>'Table 1 '!$C$22:$C$42</c:f>
              <c:strCache>
                <c:ptCount val="21"/>
                <c:pt idx="0">
                  <c:v>%GL 7 DAF_E1</c:v>
                </c:pt>
                <c:pt idx="1">
                  <c:v>%GL 14 DAF_E1</c:v>
                </c:pt>
                <c:pt idx="2">
                  <c:v>%GL 21 DAF_E1</c:v>
                </c:pt>
                <c:pt idx="3">
                  <c:v>%GL 28 DAF_E1</c:v>
                </c:pt>
                <c:pt idx="4">
                  <c:v>%GL 35 DAF_E1</c:v>
                </c:pt>
                <c:pt idx="5">
                  <c:v>%GL 42 DAF_E1</c:v>
                </c:pt>
                <c:pt idx="6">
                  <c:v>%GL 49 DAF_E1</c:v>
                </c:pt>
                <c:pt idx="7">
                  <c:v>%GL 7 DAF_E2</c:v>
                </c:pt>
                <c:pt idx="8">
                  <c:v>%GL 14 DAF_E2</c:v>
                </c:pt>
                <c:pt idx="9">
                  <c:v>%GL 21 DAF_E2</c:v>
                </c:pt>
                <c:pt idx="10">
                  <c:v>%GL 28 DAF_E2</c:v>
                </c:pt>
                <c:pt idx="11">
                  <c:v>%GL 35 DAF_E2</c:v>
                </c:pt>
                <c:pt idx="12">
                  <c:v>%GL 42 DAF_E2</c:v>
                </c:pt>
                <c:pt idx="13">
                  <c:v>%GL 49 DAF_E2</c:v>
                </c:pt>
                <c:pt idx="14">
                  <c:v>%GL 7 DAF_across</c:v>
                </c:pt>
                <c:pt idx="15">
                  <c:v>%GL 14 DAF_across</c:v>
                </c:pt>
                <c:pt idx="16">
                  <c:v>%GL 21 DAF_across</c:v>
                </c:pt>
                <c:pt idx="17">
                  <c:v>%GL 28 DAF_across</c:v>
                </c:pt>
                <c:pt idx="18">
                  <c:v>%GL 35 DAF_across</c:v>
                </c:pt>
                <c:pt idx="19">
                  <c:v>%GL 42 DAF_across</c:v>
                </c:pt>
                <c:pt idx="20">
                  <c:v>%GL 49 DAF_across</c:v>
                </c:pt>
              </c:strCache>
            </c:strRef>
          </c:cat>
          <c:val>
            <c:numRef>
              <c:f>'Table 1 '!$F$22:$F$42</c:f>
              <c:numCache>
                <c:formatCode>General</c:formatCode>
                <c:ptCount val="21"/>
                <c:pt idx="0">
                  <c:v>83.68</c:v>
                </c:pt>
                <c:pt idx="1">
                  <c:v>72.06</c:v>
                </c:pt>
                <c:pt idx="2">
                  <c:v>61.88</c:v>
                </c:pt>
                <c:pt idx="3">
                  <c:v>47.68</c:v>
                </c:pt>
                <c:pt idx="4">
                  <c:v>37.72</c:v>
                </c:pt>
                <c:pt idx="5">
                  <c:v>30.73</c:v>
                </c:pt>
                <c:pt idx="6">
                  <c:v>20.329999999999998</c:v>
                </c:pt>
                <c:pt idx="7">
                  <c:v>95.24</c:v>
                </c:pt>
                <c:pt idx="8">
                  <c:v>85.26</c:v>
                </c:pt>
                <c:pt idx="9">
                  <c:v>75.05</c:v>
                </c:pt>
                <c:pt idx="10">
                  <c:v>64.040000000000006</c:v>
                </c:pt>
                <c:pt idx="11">
                  <c:v>50.54</c:v>
                </c:pt>
                <c:pt idx="12">
                  <c:v>40.1</c:v>
                </c:pt>
                <c:pt idx="13">
                  <c:v>28.4</c:v>
                </c:pt>
                <c:pt idx="14" formatCode="0.00">
                  <c:v>89.56</c:v>
                </c:pt>
                <c:pt idx="15" formatCode="0.00">
                  <c:v>78.650000000000006</c:v>
                </c:pt>
                <c:pt idx="16" formatCode="0.00">
                  <c:v>68.48</c:v>
                </c:pt>
                <c:pt idx="17" formatCode="0.00">
                  <c:v>55.78</c:v>
                </c:pt>
                <c:pt idx="18" formatCode="0.00">
                  <c:v>44.19</c:v>
                </c:pt>
                <c:pt idx="19" formatCode="0.00">
                  <c:v>35.25</c:v>
                </c:pt>
                <c:pt idx="20" formatCode="0.00">
                  <c:v>24.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56005752"/>
        <c:axId val="456007712"/>
      </c:barChart>
      <c:catAx>
        <c:axId val="456005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07712"/>
        <c:crosses val="autoZero"/>
        <c:auto val="1"/>
        <c:lblAlgn val="ctr"/>
        <c:lblOffset val="100"/>
        <c:noMultiLvlLbl val="0"/>
      </c:catAx>
      <c:valAx>
        <c:axId val="456007712"/>
        <c:scaling>
          <c:orientation val="minMax"/>
          <c:max val="300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05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8351381335065079"/>
          <c:y val="0.93581957497248325"/>
          <c:w val="0.30582460697567443"/>
          <c:h val="4.536322072644145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2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%</a:t>
            </a:r>
            <a:r>
              <a:rPr lang="en-US" sz="1200" b="0" dirty="0" smtClean="0">
                <a:latin typeface="Times New Roman" pitchFamily="18" charset="0"/>
                <a:cs typeface="Times New Roman" pitchFamily="18" charset="0"/>
              </a:rPr>
              <a:t>GL </a:t>
            </a:r>
            <a:r>
              <a:rPr lang="en-US" sz="1200" b="0" dirty="0" err="1">
                <a:latin typeface="Times New Roman" pitchFamily="18" charset="0"/>
                <a:cs typeface="Times New Roman" pitchFamily="18" charset="0"/>
              </a:rPr>
              <a:t>inrelation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 to days to </a:t>
            </a:r>
            <a:r>
              <a:rPr lang="en-US" sz="1200" b="0" dirty="0" smtClean="0">
                <a:latin typeface="Times New Roman" pitchFamily="18" charset="0"/>
                <a:cs typeface="Times New Roman" pitchFamily="18" charset="0"/>
              </a:rPr>
              <a:t>flowering_E1</a:t>
            </a:r>
            <a:endParaRPr lang="en-US" sz="1200" b="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11081672223404507"/>
          <c:y val="4.015373078365205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2231916956325"/>
          <c:y val="0.28473378327709037"/>
          <c:w val="0.6100094582771759"/>
          <c:h val="0.56328412073490752"/>
        </c:manualLayout>
      </c:layout>
      <c:lineChart>
        <c:grouping val="standard"/>
        <c:varyColors val="0"/>
        <c:ser>
          <c:idx val="0"/>
          <c:order val="0"/>
          <c:tx>
            <c:strRef>
              <c:f>'4 stgn means'!$D$16</c:f>
              <c:strCache>
                <c:ptCount val="1"/>
                <c:pt idx="0">
                  <c:v>RSG04008-6_R13</c:v>
                </c:pt>
              </c:strCache>
            </c:strRef>
          </c:tx>
          <c:spPr>
            <a:ln>
              <a:solidFill>
                <a:srgbClr val="23F913"/>
              </a:solidFill>
            </a:ln>
          </c:spPr>
          <c:marker>
            <c:symbol val="diamond"/>
            <c:size val="4"/>
            <c:spPr>
              <a:solidFill>
                <a:srgbClr val="23F913"/>
              </a:solidFill>
              <a:ln>
                <a:solidFill>
                  <a:srgbClr val="23F913"/>
                </a:solidFill>
              </a:ln>
            </c:spPr>
          </c:marker>
          <c:cat>
            <c:numRef>
              <c:f>'4 stgn means'!$C$17:$C$23</c:f>
              <c:numCache>
                <c:formatCode>General</c:formatCode>
                <c:ptCount val="7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  <c:pt idx="4">
                  <c:v>35</c:v>
                </c:pt>
                <c:pt idx="5">
                  <c:v>42</c:v>
                </c:pt>
                <c:pt idx="6">
                  <c:v>49</c:v>
                </c:pt>
              </c:numCache>
            </c:numRef>
          </c:cat>
          <c:val>
            <c:numRef>
              <c:f>'4 stgn means'!$D$17:$D$23</c:f>
              <c:numCache>
                <c:formatCode>0.00</c:formatCode>
                <c:ptCount val="7"/>
                <c:pt idx="0">
                  <c:v>88.38</c:v>
                </c:pt>
                <c:pt idx="1">
                  <c:v>79.179999999999978</c:v>
                </c:pt>
                <c:pt idx="2">
                  <c:v>62.52</c:v>
                </c:pt>
                <c:pt idx="3">
                  <c:v>47</c:v>
                </c:pt>
                <c:pt idx="4">
                  <c:v>34.46</c:v>
                </c:pt>
                <c:pt idx="5">
                  <c:v>23.439999999999987</c:v>
                </c:pt>
                <c:pt idx="6">
                  <c:v>17.1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95B-41F1-A37F-78C5424F7998}"/>
            </c:ext>
          </c:extLst>
        </c:ser>
        <c:ser>
          <c:idx val="1"/>
          <c:order val="1"/>
          <c:tx>
            <c:strRef>
              <c:f>'4 stgn means'!$E$16</c:f>
              <c:strCache>
                <c:ptCount val="1"/>
                <c:pt idx="0">
                  <c:v>J2614-11_R1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rgbClr val="00B0F0"/>
                </a:solidFill>
              </a:ln>
            </c:spPr>
          </c:marker>
          <c:cat>
            <c:numRef>
              <c:f>'4 stgn means'!$C$17:$C$23</c:f>
              <c:numCache>
                <c:formatCode>General</c:formatCode>
                <c:ptCount val="7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  <c:pt idx="4">
                  <c:v>35</c:v>
                </c:pt>
                <c:pt idx="5">
                  <c:v>42</c:v>
                </c:pt>
                <c:pt idx="6">
                  <c:v>49</c:v>
                </c:pt>
              </c:numCache>
            </c:numRef>
          </c:cat>
          <c:val>
            <c:numRef>
              <c:f>'4 stgn means'!$E$17:$E$23</c:f>
              <c:numCache>
                <c:formatCode>General</c:formatCode>
                <c:ptCount val="7"/>
                <c:pt idx="0">
                  <c:v>83.679999999999978</c:v>
                </c:pt>
                <c:pt idx="1">
                  <c:v>72.06</c:v>
                </c:pt>
                <c:pt idx="2">
                  <c:v>61.879999999999995</c:v>
                </c:pt>
                <c:pt idx="3">
                  <c:v>47.68</c:v>
                </c:pt>
                <c:pt idx="4">
                  <c:v>37.720000000000013</c:v>
                </c:pt>
                <c:pt idx="5">
                  <c:v>30.73</c:v>
                </c:pt>
                <c:pt idx="6">
                  <c:v>20.32999999999998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95B-41F1-A37F-78C5424F7998}"/>
            </c:ext>
          </c:extLst>
        </c:ser>
        <c:ser>
          <c:idx val="2"/>
          <c:order val="2"/>
          <c:tx>
            <c:strRef>
              <c:f>'4 stgn means'!$F$16</c:f>
              <c:strCache>
                <c:ptCount val="1"/>
                <c:pt idx="0">
                  <c:v>F4 Progeny_R13</c:v>
                </c:pt>
              </c:strCache>
            </c:strRef>
          </c:tx>
          <c:spPr>
            <a:ln>
              <a:solidFill>
                <a:schemeClr val="tx1"/>
              </a:solidFill>
              <a:prstDash val="sysDot"/>
            </a:ln>
          </c:spPr>
          <c:marker>
            <c:symbol val="triangle"/>
            <c:size val="4"/>
            <c:spPr>
              <a:solidFill>
                <a:srgbClr val="00FF00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val>
            <c:numRef>
              <c:f>'4 stgn means'!$F$17:$F$23</c:f>
              <c:numCache>
                <c:formatCode>General</c:formatCode>
                <c:ptCount val="7"/>
                <c:pt idx="0">
                  <c:v>85.054999999999993</c:v>
                </c:pt>
                <c:pt idx="1">
                  <c:v>77.684999999999988</c:v>
                </c:pt>
                <c:pt idx="2">
                  <c:v>68.53</c:v>
                </c:pt>
                <c:pt idx="3">
                  <c:v>54.015000000000001</c:v>
                </c:pt>
                <c:pt idx="4">
                  <c:v>42.575000000000003</c:v>
                </c:pt>
                <c:pt idx="5">
                  <c:v>31.535000000000004</c:v>
                </c:pt>
                <c:pt idx="6">
                  <c:v>20.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095B-41F1-A37F-78C5424F79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6011240"/>
        <c:axId val="456006144"/>
      </c:lineChart>
      <c:catAx>
        <c:axId val="4560112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Weeks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73752500532028142"/>
              <c:y val="0.89758905136857958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456006144"/>
        <c:crosses val="autoZero"/>
        <c:auto val="1"/>
        <c:lblAlgn val="ctr"/>
        <c:lblOffset val="100"/>
        <c:noMultiLvlLbl val="0"/>
      </c:catAx>
      <c:valAx>
        <c:axId val="45600614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  <a:r>
                  <a:rPr lang="en-US" sz="12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</a:t>
                </a:r>
                <a:endParaRPr lang="en-US" sz="12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0.00" sourceLinked="1"/>
        <c:majorTickMark val="none"/>
        <c:minorTickMark val="none"/>
        <c:tickLblPos val="nextTo"/>
        <c:crossAx val="4560112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663616372277751"/>
          <c:y val="0.1451912260967379"/>
          <c:w val="0.24256815870989118"/>
          <c:h val="0.13805633670791168"/>
        </c:manualLayout>
      </c:layout>
      <c:overlay val="0"/>
      <c:txPr>
        <a:bodyPr/>
        <a:lstStyle/>
        <a:p>
          <a:pPr>
            <a:defRPr sz="6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25400" cap="flat" cmpd="sng" algn="ctr">
      <a:solidFill>
        <a:schemeClr val="dk1"/>
      </a:solidFill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%</a:t>
            </a:r>
            <a:r>
              <a:rPr lang="en-US" sz="1200" b="0" dirty="0" smtClean="0">
                <a:latin typeface="Times New Roman" pitchFamily="18" charset="0"/>
                <a:cs typeface="Times New Roman" pitchFamily="18" charset="0"/>
              </a:rPr>
              <a:t>GL </a:t>
            </a:r>
            <a:r>
              <a:rPr lang="en-US" sz="1200" b="0" dirty="0" err="1">
                <a:latin typeface="Times New Roman" pitchFamily="18" charset="0"/>
                <a:cs typeface="Times New Roman" pitchFamily="18" charset="0"/>
              </a:rPr>
              <a:t>inrelation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 to </a:t>
            </a:r>
            <a:r>
              <a:rPr lang="en-US" sz="1200" b="0" dirty="0" smtClean="0">
                <a:latin typeface="Times New Roman" pitchFamily="18" charset="0"/>
                <a:cs typeface="Times New Roman" pitchFamily="18" charset="0"/>
              </a:rPr>
              <a:t>days 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to flowering </a:t>
            </a:r>
            <a:r>
              <a:rPr lang="en-US" sz="1200" b="0" dirty="0" smtClean="0">
                <a:latin typeface="Times New Roman" pitchFamily="18" charset="0"/>
                <a:cs typeface="Times New Roman" pitchFamily="18" charset="0"/>
              </a:rPr>
              <a:t>_E2</a:t>
            </a:r>
            <a:endParaRPr lang="en-US" sz="1200" b="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10093093093093101"/>
          <c:y val="3.571428571428571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570830673192899"/>
          <c:y val="0.24941976002999647"/>
          <c:w val="0.57549289446927265"/>
          <c:h val="0.59429040119984999"/>
        </c:manualLayout>
      </c:layout>
      <c:lineChart>
        <c:grouping val="standard"/>
        <c:varyColors val="0"/>
        <c:ser>
          <c:idx val="0"/>
          <c:order val="0"/>
          <c:tx>
            <c:strRef>
              <c:f>'4 stgn means'!$D$25</c:f>
              <c:strCache>
                <c:ptCount val="1"/>
                <c:pt idx="0">
                  <c:v>RSG04008-6_R14</c:v>
                </c:pt>
              </c:strCache>
            </c:strRef>
          </c:tx>
          <c:spPr>
            <a:ln>
              <a:solidFill>
                <a:srgbClr val="23F913"/>
              </a:solidFill>
            </a:ln>
          </c:spPr>
          <c:marker>
            <c:symbol val="diamond"/>
            <c:size val="4"/>
            <c:spPr>
              <a:solidFill>
                <a:srgbClr val="FF0066"/>
              </a:solidFill>
              <a:ln>
                <a:solidFill>
                  <a:srgbClr val="23F913"/>
                </a:solidFill>
              </a:ln>
            </c:spPr>
          </c:marker>
          <c:cat>
            <c:numRef>
              <c:f>'4 stgn means'!$C$26:$C$32</c:f>
              <c:numCache>
                <c:formatCode>General</c:formatCode>
                <c:ptCount val="7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  <c:pt idx="4">
                  <c:v>35</c:v>
                </c:pt>
                <c:pt idx="5">
                  <c:v>42</c:v>
                </c:pt>
                <c:pt idx="6">
                  <c:v>49</c:v>
                </c:pt>
              </c:numCache>
            </c:numRef>
          </c:cat>
          <c:val>
            <c:numRef>
              <c:f>'4 stgn means'!$D$26:$D$32</c:f>
              <c:numCache>
                <c:formatCode>General</c:formatCode>
                <c:ptCount val="7"/>
                <c:pt idx="0">
                  <c:v>99.03</c:v>
                </c:pt>
                <c:pt idx="1">
                  <c:v>84.22</c:v>
                </c:pt>
                <c:pt idx="2">
                  <c:v>74.39</c:v>
                </c:pt>
                <c:pt idx="3">
                  <c:v>66.489999999999995</c:v>
                </c:pt>
                <c:pt idx="4">
                  <c:v>54.17</c:v>
                </c:pt>
                <c:pt idx="5">
                  <c:v>25.959999999999987</c:v>
                </c:pt>
                <c:pt idx="6">
                  <c:v>11.6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43B-46C8-B3EC-948EA1C1C9D6}"/>
            </c:ext>
          </c:extLst>
        </c:ser>
        <c:ser>
          <c:idx val="1"/>
          <c:order val="1"/>
          <c:tx>
            <c:strRef>
              <c:f>'4 stgn means'!$E$25</c:f>
              <c:strCache>
                <c:ptCount val="1"/>
                <c:pt idx="0">
                  <c:v>J2614-11_R14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rgbClr val="00B0F0"/>
                </a:solidFill>
              </a:ln>
            </c:spPr>
          </c:marker>
          <c:cat>
            <c:numRef>
              <c:f>'4 stgn means'!$C$26:$C$32</c:f>
              <c:numCache>
                <c:formatCode>General</c:formatCode>
                <c:ptCount val="7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  <c:pt idx="4">
                  <c:v>35</c:v>
                </c:pt>
                <c:pt idx="5">
                  <c:v>42</c:v>
                </c:pt>
                <c:pt idx="6">
                  <c:v>49</c:v>
                </c:pt>
              </c:numCache>
            </c:numRef>
          </c:cat>
          <c:val>
            <c:numRef>
              <c:f>'4 stgn means'!$E$26:$E$32</c:f>
              <c:numCache>
                <c:formatCode>General</c:formatCode>
                <c:ptCount val="7"/>
                <c:pt idx="0">
                  <c:v>95.240000000000023</c:v>
                </c:pt>
                <c:pt idx="1">
                  <c:v>85.26</c:v>
                </c:pt>
                <c:pt idx="2">
                  <c:v>75.05</c:v>
                </c:pt>
                <c:pt idx="3">
                  <c:v>64.040000000000006</c:v>
                </c:pt>
                <c:pt idx="4">
                  <c:v>50.54</c:v>
                </c:pt>
                <c:pt idx="5">
                  <c:v>40.1</c:v>
                </c:pt>
                <c:pt idx="6">
                  <c:v>28.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43B-46C8-B3EC-948EA1C1C9D6}"/>
            </c:ext>
          </c:extLst>
        </c:ser>
        <c:ser>
          <c:idx val="2"/>
          <c:order val="2"/>
          <c:tx>
            <c:strRef>
              <c:f>'4 stgn means'!$F$25</c:f>
              <c:strCache>
                <c:ptCount val="1"/>
                <c:pt idx="0">
                  <c:v>F4 Progeny_R14</c:v>
                </c:pt>
              </c:strCache>
            </c:strRef>
          </c:tx>
          <c:spPr>
            <a:ln>
              <a:solidFill>
                <a:schemeClr val="tx1"/>
              </a:solidFill>
              <a:prstDash val="sysDot"/>
            </a:ln>
          </c:spPr>
          <c:marker>
            <c:symbol val="triangle"/>
            <c:size val="4"/>
            <c:spPr>
              <a:solidFill>
                <a:srgbClr val="00FF00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val>
            <c:numRef>
              <c:f>'4 stgn means'!$F$26:$F$32</c:f>
              <c:numCache>
                <c:formatCode>General</c:formatCode>
                <c:ptCount val="7"/>
                <c:pt idx="0">
                  <c:v>89.2</c:v>
                </c:pt>
                <c:pt idx="1">
                  <c:v>82.765000000000001</c:v>
                </c:pt>
                <c:pt idx="2">
                  <c:v>74.124999999999986</c:v>
                </c:pt>
                <c:pt idx="3">
                  <c:v>64.424999999999997</c:v>
                </c:pt>
                <c:pt idx="4">
                  <c:v>42.97</c:v>
                </c:pt>
                <c:pt idx="5">
                  <c:v>29.990000000000002</c:v>
                </c:pt>
                <c:pt idx="6">
                  <c:v>24.6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43B-46C8-B3EC-948EA1C1C9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6008888"/>
        <c:axId val="456007320"/>
      </c:lineChart>
      <c:catAx>
        <c:axId val="4560088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weeks</a:t>
                </a:r>
              </a:p>
            </c:rich>
          </c:tx>
          <c:layout>
            <c:manualLayout>
              <c:xMode val="edge"/>
              <c:yMode val="edge"/>
              <c:x val="0.69325955877136958"/>
              <c:y val="0.89758905136857958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456007320"/>
        <c:crosses val="autoZero"/>
        <c:auto val="1"/>
        <c:lblAlgn val="ctr"/>
        <c:lblOffset val="100"/>
        <c:noMultiLvlLbl val="0"/>
      </c:catAx>
      <c:valAx>
        <c:axId val="456007320"/>
        <c:scaling>
          <c:orientation val="minMax"/>
        </c:scaling>
        <c:delete val="0"/>
        <c:axPos val="l"/>
        <c:majorGridlines>
          <c:spPr>
            <a:ln w="0"/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560088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9159111867773282"/>
          <c:y val="0.14320725534308221"/>
          <c:w val="0.29962521576694839"/>
          <c:h val="0.14136342332208474"/>
        </c:manualLayout>
      </c:layout>
      <c:overlay val="0"/>
      <c:txPr>
        <a:bodyPr/>
        <a:lstStyle/>
        <a:p>
          <a:pPr>
            <a:defRPr sz="6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25400" cap="flat" cmpd="sng" algn="ctr">
      <a:solidFill>
        <a:schemeClr val="dk1"/>
      </a:solidFill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b="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env1'!$C$1</c:f>
              <c:strCache>
                <c:ptCount val="1"/>
                <c:pt idx="0">
                  <c:v>Rain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none"/>
          </c:marker>
          <c:cat>
            <c:multiLvlStrRef>
              <c:f>'env1'!$A$2:$B$138</c:f>
              <c:multiLvlStrCache>
                <c:ptCount val="137"/>
                <c:lvl>
                  <c:pt idx="0">
                    <c:v>12/15/2012</c:v>
                  </c:pt>
                  <c:pt idx="1">
                    <c:v>12/16/2012</c:v>
                  </c:pt>
                  <c:pt idx="2">
                    <c:v>12/17/2012</c:v>
                  </c:pt>
                  <c:pt idx="3">
                    <c:v>12/18/2012</c:v>
                  </c:pt>
                  <c:pt idx="4">
                    <c:v>12/19/2012</c:v>
                  </c:pt>
                  <c:pt idx="5">
                    <c:v>12/20/2012</c:v>
                  </c:pt>
                  <c:pt idx="6">
                    <c:v>12/21/2012</c:v>
                  </c:pt>
                  <c:pt idx="7">
                    <c:v>12/22/2012</c:v>
                  </c:pt>
                  <c:pt idx="8">
                    <c:v>12/23/2012</c:v>
                  </c:pt>
                  <c:pt idx="9">
                    <c:v>12/24/2012</c:v>
                  </c:pt>
                  <c:pt idx="10">
                    <c:v>12/25/2012</c:v>
                  </c:pt>
                  <c:pt idx="11">
                    <c:v>12/26/2012</c:v>
                  </c:pt>
                  <c:pt idx="12">
                    <c:v>12/27/2012</c:v>
                  </c:pt>
                  <c:pt idx="13">
                    <c:v>12/28/2012</c:v>
                  </c:pt>
                  <c:pt idx="14">
                    <c:v>12/29/2012</c:v>
                  </c:pt>
                  <c:pt idx="15">
                    <c:v>12/30/2012</c:v>
                  </c:pt>
                  <c:pt idx="16">
                    <c:v>12/31/2012</c:v>
                  </c:pt>
                  <c:pt idx="17">
                    <c:v>1/1/2013</c:v>
                  </c:pt>
                  <c:pt idx="18">
                    <c:v>1/2/2013</c:v>
                  </c:pt>
                  <c:pt idx="19">
                    <c:v>1/3/2013</c:v>
                  </c:pt>
                  <c:pt idx="20">
                    <c:v>1/4/2013</c:v>
                  </c:pt>
                  <c:pt idx="21">
                    <c:v>1/5/2013</c:v>
                  </c:pt>
                  <c:pt idx="22">
                    <c:v>1/6/2013</c:v>
                  </c:pt>
                  <c:pt idx="23">
                    <c:v>1/7/2013</c:v>
                  </c:pt>
                  <c:pt idx="24">
                    <c:v>1/8/2013</c:v>
                  </c:pt>
                  <c:pt idx="25">
                    <c:v>1/9/2013</c:v>
                  </c:pt>
                  <c:pt idx="26">
                    <c:v>1/10/2013</c:v>
                  </c:pt>
                  <c:pt idx="27">
                    <c:v>1/11/2013</c:v>
                  </c:pt>
                  <c:pt idx="28">
                    <c:v>1/12/2013</c:v>
                  </c:pt>
                  <c:pt idx="29">
                    <c:v>1/13/2013</c:v>
                  </c:pt>
                  <c:pt idx="30">
                    <c:v>1/14/2013</c:v>
                  </c:pt>
                  <c:pt idx="31">
                    <c:v>1/15/2013</c:v>
                  </c:pt>
                  <c:pt idx="32">
                    <c:v>1/16/2013</c:v>
                  </c:pt>
                  <c:pt idx="33">
                    <c:v>1/17/2013</c:v>
                  </c:pt>
                  <c:pt idx="34">
                    <c:v>1/18/2013</c:v>
                  </c:pt>
                  <c:pt idx="35">
                    <c:v>1/19/2013</c:v>
                  </c:pt>
                  <c:pt idx="36">
                    <c:v>1/20/2013</c:v>
                  </c:pt>
                  <c:pt idx="37">
                    <c:v>1/21/2013</c:v>
                  </c:pt>
                  <c:pt idx="38">
                    <c:v>1/22/2013</c:v>
                  </c:pt>
                  <c:pt idx="39">
                    <c:v>1/23/2013</c:v>
                  </c:pt>
                  <c:pt idx="40">
                    <c:v>1/24/2013</c:v>
                  </c:pt>
                  <c:pt idx="41">
                    <c:v>1/25/2013</c:v>
                  </c:pt>
                  <c:pt idx="42">
                    <c:v>1/26/2013</c:v>
                  </c:pt>
                  <c:pt idx="43">
                    <c:v>1/27/2013</c:v>
                  </c:pt>
                  <c:pt idx="44">
                    <c:v>1/28/2013</c:v>
                  </c:pt>
                  <c:pt idx="45">
                    <c:v>1/29/2013</c:v>
                  </c:pt>
                  <c:pt idx="46">
                    <c:v>1/30/2013</c:v>
                  </c:pt>
                  <c:pt idx="47">
                    <c:v>1/31/2013</c:v>
                  </c:pt>
                  <c:pt idx="48">
                    <c:v>2/1/2013</c:v>
                  </c:pt>
                  <c:pt idx="49">
                    <c:v>2/2/2013</c:v>
                  </c:pt>
                  <c:pt idx="50">
                    <c:v>2/3/2013</c:v>
                  </c:pt>
                  <c:pt idx="51">
                    <c:v>2/4/2013</c:v>
                  </c:pt>
                  <c:pt idx="52">
                    <c:v>2/5/2013</c:v>
                  </c:pt>
                  <c:pt idx="53">
                    <c:v>2/6/2013</c:v>
                  </c:pt>
                  <c:pt idx="54">
                    <c:v>2/7/2013</c:v>
                  </c:pt>
                  <c:pt idx="55">
                    <c:v>2/8/2013</c:v>
                  </c:pt>
                  <c:pt idx="56">
                    <c:v>2/9/2013</c:v>
                  </c:pt>
                  <c:pt idx="57">
                    <c:v>2/10/2013</c:v>
                  </c:pt>
                  <c:pt idx="58">
                    <c:v>2/11/2013</c:v>
                  </c:pt>
                  <c:pt idx="59">
                    <c:v>2/12/2013</c:v>
                  </c:pt>
                  <c:pt idx="60">
                    <c:v>2/13/2013</c:v>
                  </c:pt>
                  <c:pt idx="61">
                    <c:v>2/14/2013</c:v>
                  </c:pt>
                  <c:pt idx="62">
                    <c:v>2/15/2013</c:v>
                  </c:pt>
                  <c:pt idx="63">
                    <c:v>2/16/2013</c:v>
                  </c:pt>
                  <c:pt idx="64">
                    <c:v>2/17/2013</c:v>
                  </c:pt>
                  <c:pt idx="65">
                    <c:v>2/18/2013</c:v>
                  </c:pt>
                  <c:pt idx="66">
                    <c:v>2/19/2013</c:v>
                  </c:pt>
                  <c:pt idx="67">
                    <c:v>2/20/2013</c:v>
                  </c:pt>
                  <c:pt idx="68">
                    <c:v>2/21/2013</c:v>
                  </c:pt>
                  <c:pt idx="69">
                    <c:v>2/22/2013</c:v>
                  </c:pt>
                  <c:pt idx="70">
                    <c:v>2/23/2013</c:v>
                  </c:pt>
                  <c:pt idx="71">
                    <c:v>2/24/2013</c:v>
                  </c:pt>
                  <c:pt idx="72">
                    <c:v>2/25/2013</c:v>
                  </c:pt>
                  <c:pt idx="73">
                    <c:v>2/26/2013</c:v>
                  </c:pt>
                  <c:pt idx="74">
                    <c:v>2/27/2013</c:v>
                  </c:pt>
                  <c:pt idx="75">
                    <c:v>2/28/2013</c:v>
                  </c:pt>
                  <c:pt idx="76">
                    <c:v>3/1/2013</c:v>
                  </c:pt>
                  <c:pt idx="77">
                    <c:v>3/2/2013</c:v>
                  </c:pt>
                  <c:pt idx="78">
                    <c:v>3/3/2013</c:v>
                  </c:pt>
                  <c:pt idx="79">
                    <c:v>3/4/2013</c:v>
                  </c:pt>
                  <c:pt idx="80">
                    <c:v>3/5/2013</c:v>
                  </c:pt>
                  <c:pt idx="81">
                    <c:v>3/6/2013</c:v>
                  </c:pt>
                  <c:pt idx="82">
                    <c:v>3/7/2013</c:v>
                  </c:pt>
                  <c:pt idx="83">
                    <c:v>3/8/2013</c:v>
                  </c:pt>
                  <c:pt idx="84">
                    <c:v>3/9/2013</c:v>
                  </c:pt>
                  <c:pt idx="85">
                    <c:v>3/10/2013</c:v>
                  </c:pt>
                  <c:pt idx="86">
                    <c:v>3/11/2013</c:v>
                  </c:pt>
                  <c:pt idx="87">
                    <c:v>3/12/2013</c:v>
                  </c:pt>
                  <c:pt idx="88">
                    <c:v>3/13/2013</c:v>
                  </c:pt>
                  <c:pt idx="89">
                    <c:v>3/14/2013</c:v>
                  </c:pt>
                  <c:pt idx="90">
                    <c:v>3/15/2013</c:v>
                  </c:pt>
                  <c:pt idx="91">
                    <c:v>3/16/2013</c:v>
                  </c:pt>
                  <c:pt idx="92">
                    <c:v>3/17/2013</c:v>
                  </c:pt>
                  <c:pt idx="93">
                    <c:v>3/18/2013</c:v>
                  </c:pt>
                  <c:pt idx="94">
                    <c:v>3/19/2013</c:v>
                  </c:pt>
                  <c:pt idx="95">
                    <c:v>3/20/2013</c:v>
                  </c:pt>
                  <c:pt idx="96">
                    <c:v>3/21/2013</c:v>
                  </c:pt>
                  <c:pt idx="97">
                    <c:v>3/22/2013</c:v>
                  </c:pt>
                  <c:pt idx="98">
                    <c:v>3/23/2013</c:v>
                  </c:pt>
                  <c:pt idx="99">
                    <c:v>3/24/2013</c:v>
                  </c:pt>
                  <c:pt idx="100">
                    <c:v>3/25/2013</c:v>
                  </c:pt>
                  <c:pt idx="101">
                    <c:v>3/26/2013</c:v>
                  </c:pt>
                  <c:pt idx="102">
                    <c:v>3/27/2013</c:v>
                  </c:pt>
                  <c:pt idx="103">
                    <c:v>3/28/2013</c:v>
                  </c:pt>
                  <c:pt idx="104">
                    <c:v>3/29/2013</c:v>
                  </c:pt>
                  <c:pt idx="105">
                    <c:v>3/30/2013</c:v>
                  </c:pt>
                  <c:pt idx="106">
                    <c:v>3/31/2013</c:v>
                  </c:pt>
                  <c:pt idx="107">
                    <c:v>4/1/2013</c:v>
                  </c:pt>
                  <c:pt idx="108">
                    <c:v>4/2/2013</c:v>
                  </c:pt>
                  <c:pt idx="109">
                    <c:v>4/3/2013</c:v>
                  </c:pt>
                  <c:pt idx="110">
                    <c:v>4/4/2013</c:v>
                  </c:pt>
                  <c:pt idx="111">
                    <c:v>4/5/2013</c:v>
                  </c:pt>
                  <c:pt idx="112">
                    <c:v>4/6/2013</c:v>
                  </c:pt>
                  <c:pt idx="113">
                    <c:v>4/7/2013</c:v>
                  </c:pt>
                  <c:pt idx="114">
                    <c:v>4/8/2013</c:v>
                  </c:pt>
                  <c:pt idx="115">
                    <c:v>4/9/2013</c:v>
                  </c:pt>
                  <c:pt idx="116">
                    <c:v>4/10/2013</c:v>
                  </c:pt>
                  <c:pt idx="117">
                    <c:v>4/11/2013</c:v>
                  </c:pt>
                  <c:pt idx="118">
                    <c:v>4/12/2013</c:v>
                  </c:pt>
                  <c:pt idx="119">
                    <c:v>4/13/2013</c:v>
                  </c:pt>
                  <c:pt idx="120">
                    <c:v>4/14/2013</c:v>
                  </c:pt>
                  <c:pt idx="121">
                    <c:v>4/15/2013</c:v>
                  </c:pt>
                  <c:pt idx="122">
                    <c:v>4/16/2013</c:v>
                  </c:pt>
                  <c:pt idx="123">
                    <c:v>4/17/2013</c:v>
                  </c:pt>
                  <c:pt idx="124">
                    <c:v>4/18/2013</c:v>
                  </c:pt>
                  <c:pt idx="125">
                    <c:v>4/19/2013</c:v>
                  </c:pt>
                  <c:pt idx="126">
                    <c:v>4/20/2013</c:v>
                  </c:pt>
                  <c:pt idx="127">
                    <c:v>4/21/2013</c:v>
                  </c:pt>
                  <c:pt idx="128">
                    <c:v>4/22/2013</c:v>
                  </c:pt>
                  <c:pt idx="129">
                    <c:v>4/23/2013</c:v>
                  </c:pt>
                  <c:pt idx="130">
                    <c:v>4/24/2013</c:v>
                  </c:pt>
                  <c:pt idx="131">
                    <c:v>4/25/2013</c:v>
                  </c:pt>
                  <c:pt idx="132">
                    <c:v>4/26/2013</c:v>
                  </c:pt>
                  <c:pt idx="133">
                    <c:v>4/27/2013</c:v>
                  </c:pt>
                  <c:pt idx="134">
                    <c:v>4/28/2013</c:v>
                  </c:pt>
                  <c:pt idx="135">
                    <c:v>4/29/2013</c:v>
                  </c:pt>
                  <c:pt idx="136">
                    <c:v>4/30/2013</c:v>
                  </c:pt>
                </c:lvl>
                <c:lvl>
                  <c:pt idx="16">
                    <c:v>DOS</c:v>
                  </c:pt>
                  <c:pt idx="88">
                    <c:v>%GL7</c:v>
                  </c:pt>
                  <c:pt idx="95">
                    <c:v>%GL14</c:v>
                  </c:pt>
                  <c:pt idx="101">
                    <c:v>%GL21</c:v>
                  </c:pt>
                  <c:pt idx="108">
                    <c:v>%GL28</c:v>
                  </c:pt>
                  <c:pt idx="115">
                    <c:v>%GL35</c:v>
                  </c:pt>
                  <c:pt idx="122">
                    <c:v>%GL42</c:v>
                  </c:pt>
                  <c:pt idx="129">
                    <c:v>%GL49</c:v>
                  </c:pt>
                </c:lvl>
              </c:multiLvlStrCache>
            </c:multiLvlStrRef>
          </c:cat>
          <c:val>
            <c:numRef>
              <c:f>'env1'!$C$2:$C$138</c:f>
              <c:numCache>
                <c:formatCode>General</c:formatCode>
                <c:ptCount val="13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1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3.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1</c:v>
                </c:pt>
                <c:pt idx="64">
                  <c:v>5.8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59.4</c:v>
                </c:pt>
                <c:pt idx="110">
                  <c:v>0.6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.4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67D-4FC6-97EF-1746521E7E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6010848"/>
        <c:axId val="456012024"/>
      </c:lineChart>
      <c:lineChart>
        <c:grouping val="standard"/>
        <c:varyColors val="0"/>
        <c:ser>
          <c:idx val="1"/>
          <c:order val="1"/>
          <c:tx>
            <c:strRef>
              <c:f>'env1'!$D$1</c:f>
              <c:strCache>
                <c:ptCount val="1"/>
                <c:pt idx="0">
                  <c:v>Evap</c:v>
                </c:pt>
              </c:strCache>
            </c:strRef>
          </c:tx>
          <c:spPr>
            <a:ln w="38100"/>
          </c:spPr>
          <c:marker>
            <c:symbol val="none"/>
          </c:marker>
          <c:cat>
            <c:multiLvlStrRef>
              <c:f>'env1'!$A$2:$B$138</c:f>
              <c:multiLvlStrCache>
                <c:ptCount val="137"/>
                <c:lvl>
                  <c:pt idx="0">
                    <c:v>12/15/2012</c:v>
                  </c:pt>
                  <c:pt idx="1">
                    <c:v>12/16/2012</c:v>
                  </c:pt>
                  <c:pt idx="2">
                    <c:v>12/17/2012</c:v>
                  </c:pt>
                  <c:pt idx="3">
                    <c:v>12/18/2012</c:v>
                  </c:pt>
                  <c:pt idx="4">
                    <c:v>12/19/2012</c:v>
                  </c:pt>
                  <c:pt idx="5">
                    <c:v>12/20/2012</c:v>
                  </c:pt>
                  <c:pt idx="6">
                    <c:v>12/21/2012</c:v>
                  </c:pt>
                  <c:pt idx="7">
                    <c:v>12/22/2012</c:v>
                  </c:pt>
                  <c:pt idx="8">
                    <c:v>12/23/2012</c:v>
                  </c:pt>
                  <c:pt idx="9">
                    <c:v>12/24/2012</c:v>
                  </c:pt>
                  <c:pt idx="10">
                    <c:v>12/25/2012</c:v>
                  </c:pt>
                  <c:pt idx="11">
                    <c:v>12/26/2012</c:v>
                  </c:pt>
                  <c:pt idx="12">
                    <c:v>12/27/2012</c:v>
                  </c:pt>
                  <c:pt idx="13">
                    <c:v>12/28/2012</c:v>
                  </c:pt>
                  <c:pt idx="14">
                    <c:v>12/29/2012</c:v>
                  </c:pt>
                  <c:pt idx="15">
                    <c:v>12/30/2012</c:v>
                  </c:pt>
                  <c:pt idx="16">
                    <c:v>12/31/2012</c:v>
                  </c:pt>
                  <c:pt idx="17">
                    <c:v>1/1/2013</c:v>
                  </c:pt>
                  <c:pt idx="18">
                    <c:v>1/2/2013</c:v>
                  </c:pt>
                  <c:pt idx="19">
                    <c:v>1/3/2013</c:v>
                  </c:pt>
                  <c:pt idx="20">
                    <c:v>1/4/2013</c:v>
                  </c:pt>
                  <c:pt idx="21">
                    <c:v>1/5/2013</c:v>
                  </c:pt>
                  <c:pt idx="22">
                    <c:v>1/6/2013</c:v>
                  </c:pt>
                  <c:pt idx="23">
                    <c:v>1/7/2013</c:v>
                  </c:pt>
                  <c:pt idx="24">
                    <c:v>1/8/2013</c:v>
                  </c:pt>
                  <c:pt idx="25">
                    <c:v>1/9/2013</c:v>
                  </c:pt>
                  <c:pt idx="26">
                    <c:v>1/10/2013</c:v>
                  </c:pt>
                  <c:pt idx="27">
                    <c:v>1/11/2013</c:v>
                  </c:pt>
                  <c:pt idx="28">
                    <c:v>1/12/2013</c:v>
                  </c:pt>
                  <c:pt idx="29">
                    <c:v>1/13/2013</c:v>
                  </c:pt>
                  <c:pt idx="30">
                    <c:v>1/14/2013</c:v>
                  </c:pt>
                  <c:pt idx="31">
                    <c:v>1/15/2013</c:v>
                  </c:pt>
                  <c:pt idx="32">
                    <c:v>1/16/2013</c:v>
                  </c:pt>
                  <c:pt idx="33">
                    <c:v>1/17/2013</c:v>
                  </c:pt>
                  <c:pt idx="34">
                    <c:v>1/18/2013</c:v>
                  </c:pt>
                  <c:pt idx="35">
                    <c:v>1/19/2013</c:v>
                  </c:pt>
                  <c:pt idx="36">
                    <c:v>1/20/2013</c:v>
                  </c:pt>
                  <c:pt idx="37">
                    <c:v>1/21/2013</c:v>
                  </c:pt>
                  <c:pt idx="38">
                    <c:v>1/22/2013</c:v>
                  </c:pt>
                  <c:pt idx="39">
                    <c:v>1/23/2013</c:v>
                  </c:pt>
                  <c:pt idx="40">
                    <c:v>1/24/2013</c:v>
                  </c:pt>
                  <c:pt idx="41">
                    <c:v>1/25/2013</c:v>
                  </c:pt>
                  <c:pt idx="42">
                    <c:v>1/26/2013</c:v>
                  </c:pt>
                  <c:pt idx="43">
                    <c:v>1/27/2013</c:v>
                  </c:pt>
                  <c:pt idx="44">
                    <c:v>1/28/2013</c:v>
                  </c:pt>
                  <c:pt idx="45">
                    <c:v>1/29/2013</c:v>
                  </c:pt>
                  <c:pt idx="46">
                    <c:v>1/30/2013</c:v>
                  </c:pt>
                  <c:pt idx="47">
                    <c:v>1/31/2013</c:v>
                  </c:pt>
                  <c:pt idx="48">
                    <c:v>2/1/2013</c:v>
                  </c:pt>
                  <c:pt idx="49">
                    <c:v>2/2/2013</c:v>
                  </c:pt>
                  <c:pt idx="50">
                    <c:v>2/3/2013</c:v>
                  </c:pt>
                  <c:pt idx="51">
                    <c:v>2/4/2013</c:v>
                  </c:pt>
                  <c:pt idx="52">
                    <c:v>2/5/2013</c:v>
                  </c:pt>
                  <c:pt idx="53">
                    <c:v>2/6/2013</c:v>
                  </c:pt>
                  <c:pt idx="54">
                    <c:v>2/7/2013</c:v>
                  </c:pt>
                  <c:pt idx="55">
                    <c:v>2/8/2013</c:v>
                  </c:pt>
                  <c:pt idx="56">
                    <c:v>2/9/2013</c:v>
                  </c:pt>
                  <c:pt idx="57">
                    <c:v>2/10/2013</c:v>
                  </c:pt>
                  <c:pt idx="58">
                    <c:v>2/11/2013</c:v>
                  </c:pt>
                  <c:pt idx="59">
                    <c:v>2/12/2013</c:v>
                  </c:pt>
                  <c:pt idx="60">
                    <c:v>2/13/2013</c:v>
                  </c:pt>
                  <c:pt idx="61">
                    <c:v>2/14/2013</c:v>
                  </c:pt>
                  <c:pt idx="62">
                    <c:v>2/15/2013</c:v>
                  </c:pt>
                  <c:pt idx="63">
                    <c:v>2/16/2013</c:v>
                  </c:pt>
                  <c:pt idx="64">
                    <c:v>2/17/2013</c:v>
                  </c:pt>
                  <c:pt idx="65">
                    <c:v>2/18/2013</c:v>
                  </c:pt>
                  <c:pt idx="66">
                    <c:v>2/19/2013</c:v>
                  </c:pt>
                  <c:pt idx="67">
                    <c:v>2/20/2013</c:v>
                  </c:pt>
                  <c:pt idx="68">
                    <c:v>2/21/2013</c:v>
                  </c:pt>
                  <c:pt idx="69">
                    <c:v>2/22/2013</c:v>
                  </c:pt>
                  <c:pt idx="70">
                    <c:v>2/23/2013</c:v>
                  </c:pt>
                  <c:pt idx="71">
                    <c:v>2/24/2013</c:v>
                  </c:pt>
                  <c:pt idx="72">
                    <c:v>2/25/2013</c:v>
                  </c:pt>
                  <c:pt idx="73">
                    <c:v>2/26/2013</c:v>
                  </c:pt>
                  <c:pt idx="74">
                    <c:v>2/27/2013</c:v>
                  </c:pt>
                  <c:pt idx="75">
                    <c:v>2/28/2013</c:v>
                  </c:pt>
                  <c:pt idx="76">
                    <c:v>3/1/2013</c:v>
                  </c:pt>
                  <c:pt idx="77">
                    <c:v>3/2/2013</c:v>
                  </c:pt>
                  <c:pt idx="78">
                    <c:v>3/3/2013</c:v>
                  </c:pt>
                  <c:pt idx="79">
                    <c:v>3/4/2013</c:v>
                  </c:pt>
                  <c:pt idx="80">
                    <c:v>3/5/2013</c:v>
                  </c:pt>
                  <c:pt idx="81">
                    <c:v>3/6/2013</c:v>
                  </c:pt>
                  <c:pt idx="82">
                    <c:v>3/7/2013</c:v>
                  </c:pt>
                  <c:pt idx="83">
                    <c:v>3/8/2013</c:v>
                  </c:pt>
                  <c:pt idx="84">
                    <c:v>3/9/2013</c:v>
                  </c:pt>
                  <c:pt idx="85">
                    <c:v>3/10/2013</c:v>
                  </c:pt>
                  <c:pt idx="86">
                    <c:v>3/11/2013</c:v>
                  </c:pt>
                  <c:pt idx="87">
                    <c:v>3/12/2013</c:v>
                  </c:pt>
                  <c:pt idx="88">
                    <c:v>3/13/2013</c:v>
                  </c:pt>
                  <c:pt idx="89">
                    <c:v>3/14/2013</c:v>
                  </c:pt>
                  <c:pt idx="90">
                    <c:v>3/15/2013</c:v>
                  </c:pt>
                  <c:pt idx="91">
                    <c:v>3/16/2013</c:v>
                  </c:pt>
                  <c:pt idx="92">
                    <c:v>3/17/2013</c:v>
                  </c:pt>
                  <c:pt idx="93">
                    <c:v>3/18/2013</c:v>
                  </c:pt>
                  <c:pt idx="94">
                    <c:v>3/19/2013</c:v>
                  </c:pt>
                  <c:pt idx="95">
                    <c:v>3/20/2013</c:v>
                  </c:pt>
                  <c:pt idx="96">
                    <c:v>3/21/2013</c:v>
                  </c:pt>
                  <c:pt idx="97">
                    <c:v>3/22/2013</c:v>
                  </c:pt>
                  <c:pt idx="98">
                    <c:v>3/23/2013</c:v>
                  </c:pt>
                  <c:pt idx="99">
                    <c:v>3/24/2013</c:v>
                  </c:pt>
                  <c:pt idx="100">
                    <c:v>3/25/2013</c:v>
                  </c:pt>
                  <c:pt idx="101">
                    <c:v>3/26/2013</c:v>
                  </c:pt>
                  <c:pt idx="102">
                    <c:v>3/27/2013</c:v>
                  </c:pt>
                  <c:pt idx="103">
                    <c:v>3/28/2013</c:v>
                  </c:pt>
                  <c:pt idx="104">
                    <c:v>3/29/2013</c:v>
                  </c:pt>
                  <c:pt idx="105">
                    <c:v>3/30/2013</c:v>
                  </c:pt>
                  <c:pt idx="106">
                    <c:v>3/31/2013</c:v>
                  </c:pt>
                  <c:pt idx="107">
                    <c:v>4/1/2013</c:v>
                  </c:pt>
                  <c:pt idx="108">
                    <c:v>4/2/2013</c:v>
                  </c:pt>
                  <c:pt idx="109">
                    <c:v>4/3/2013</c:v>
                  </c:pt>
                  <c:pt idx="110">
                    <c:v>4/4/2013</c:v>
                  </c:pt>
                  <c:pt idx="111">
                    <c:v>4/5/2013</c:v>
                  </c:pt>
                  <c:pt idx="112">
                    <c:v>4/6/2013</c:v>
                  </c:pt>
                  <c:pt idx="113">
                    <c:v>4/7/2013</c:v>
                  </c:pt>
                  <c:pt idx="114">
                    <c:v>4/8/2013</c:v>
                  </c:pt>
                  <c:pt idx="115">
                    <c:v>4/9/2013</c:v>
                  </c:pt>
                  <c:pt idx="116">
                    <c:v>4/10/2013</c:v>
                  </c:pt>
                  <c:pt idx="117">
                    <c:v>4/11/2013</c:v>
                  </c:pt>
                  <c:pt idx="118">
                    <c:v>4/12/2013</c:v>
                  </c:pt>
                  <c:pt idx="119">
                    <c:v>4/13/2013</c:v>
                  </c:pt>
                  <c:pt idx="120">
                    <c:v>4/14/2013</c:v>
                  </c:pt>
                  <c:pt idx="121">
                    <c:v>4/15/2013</c:v>
                  </c:pt>
                  <c:pt idx="122">
                    <c:v>4/16/2013</c:v>
                  </c:pt>
                  <c:pt idx="123">
                    <c:v>4/17/2013</c:v>
                  </c:pt>
                  <c:pt idx="124">
                    <c:v>4/18/2013</c:v>
                  </c:pt>
                  <c:pt idx="125">
                    <c:v>4/19/2013</c:v>
                  </c:pt>
                  <c:pt idx="126">
                    <c:v>4/20/2013</c:v>
                  </c:pt>
                  <c:pt idx="127">
                    <c:v>4/21/2013</c:v>
                  </c:pt>
                  <c:pt idx="128">
                    <c:v>4/22/2013</c:v>
                  </c:pt>
                  <c:pt idx="129">
                    <c:v>4/23/2013</c:v>
                  </c:pt>
                  <c:pt idx="130">
                    <c:v>4/24/2013</c:v>
                  </c:pt>
                  <c:pt idx="131">
                    <c:v>4/25/2013</c:v>
                  </c:pt>
                  <c:pt idx="132">
                    <c:v>4/26/2013</c:v>
                  </c:pt>
                  <c:pt idx="133">
                    <c:v>4/27/2013</c:v>
                  </c:pt>
                  <c:pt idx="134">
                    <c:v>4/28/2013</c:v>
                  </c:pt>
                  <c:pt idx="135">
                    <c:v>4/29/2013</c:v>
                  </c:pt>
                  <c:pt idx="136">
                    <c:v>4/30/2013</c:v>
                  </c:pt>
                </c:lvl>
                <c:lvl>
                  <c:pt idx="16">
                    <c:v>DOS</c:v>
                  </c:pt>
                  <c:pt idx="88">
                    <c:v>%GL7</c:v>
                  </c:pt>
                  <c:pt idx="95">
                    <c:v>%GL14</c:v>
                  </c:pt>
                  <c:pt idx="101">
                    <c:v>%GL21</c:v>
                  </c:pt>
                  <c:pt idx="108">
                    <c:v>%GL28</c:v>
                  </c:pt>
                  <c:pt idx="115">
                    <c:v>%GL35</c:v>
                  </c:pt>
                  <c:pt idx="122">
                    <c:v>%GL42</c:v>
                  </c:pt>
                  <c:pt idx="129">
                    <c:v>%GL49</c:v>
                  </c:pt>
                </c:lvl>
              </c:multiLvlStrCache>
            </c:multiLvlStrRef>
          </c:cat>
          <c:val>
            <c:numRef>
              <c:f>'env1'!$D$2:$D$138</c:f>
              <c:numCache>
                <c:formatCode>General</c:formatCode>
                <c:ptCount val="137"/>
                <c:pt idx="0">
                  <c:v>4.5</c:v>
                </c:pt>
                <c:pt idx="1">
                  <c:v>5.2</c:v>
                </c:pt>
                <c:pt idx="2">
                  <c:v>4.8</c:v>
                </c:pt>
                <c:pt idx="3">
                  <c:v>4.9000000000000004</c:v>
                </c:pt>
                <c:pt idx="4">
                  <c:v>4.8</c:v>
                </c:pt>
                <c:pt idx="5">
                  <c:v>4.3</c:v>
                </c:pt>
                <c:pt idx="6">
                  <c:v>3.6</c:v>
                </c:pt>
                <c:pt idx="7">
                  <c:v>3.4</c:v>
                </c:pt>
                <c:pt idx="8">
                  <c:v>4</c:v>
                </c:pt>
                <c:pt idx="9">
                  <c:v>3.6</c:v>
                </c:pt>
                <c:pt idx="10">
                  <c:v>3.6</c:v>
                </c:pt>
                <c:pt idx="11">
                  <c:v>3.3</c:v>
                </c:pt>
                <c:pt idx="12">
                  <c:v>4</c:v>
                </c:pt>
                <c:pt idx="13">
                  <c:v>3.8</c:v>
                </c:pt>
                <c:pt idx="14">
                  <c:v>2.8</c:v>
                </c:pt>
                <c:pt idx="15">
                  <c:v>3.2</c:v>
                </c:pt>
                <c:pt idx="16">
                  <c:v>3.6</c:v>
                </c:pt>
                <c:pt idx="17">
                  <c:v>3.5</c:v>
                </c:pt>
                <c:pt idx="18">
                  <c:v>3</c:v>
                </c:pt>
                <c:pt idx="19">
                  <c:v>4.3</c:v>
                </c:pt>
                <c:pt idx="20">
                  <c:v>4.3</c:v>
                </c:pt>
                <c:pt idx="21">
                  <c:v>4</c:v>
                </c:pt>
                <c:pt idx="22">
                  <c:v>4.4000000000000004</c:v>
                </c:pt>
                <c:pt idx="23">
                  <c:v>3.5</c:v>
                </c:pt>
                <c:pt idx="24">
                  <c:v>3.7</c:v>
                </c:pt>
                <c:pt idx="25">
                  <c:v>4.5</c:v>
                </c:pt>
                <c:pt idx="26">
                  <c:v>3.6</c:v>
                </c:pt>
                <c:pt idx="27">
                  <c:v>4.4000000000000004</c:v>
                </c:pt>
                <c:pt idx="28">
                  <c:v>4.7</c:v>
                </c:pt>
                <c:pt idx="29">
                  <c:v>4.9000000000000004</c:v>
                </c:pt>
                <c:pt idx="30">
                  <c:v>3.7</c:v>
                </c:pt>
                <c:pt idx="31">
                  <c:v>3.9</c:v>
                </c:pt>
                <c:pt idx="32">
                  <c:v>5.6</c:v>
                </c:pt>
                <c:pt idx="33">
                  <c:v>5.2</c:v>
                </c:pt>
                <c:pt idx="34">
                  <c:v>5.5</c:v>
                </c:pt>
                <c:pt idx="35">
                  <c:v>5.4</c:v>
                </c:pt>
                <c:pt idx="36">
                  <c:v>3.9</c:v>
                </c:pt>
                <c:pt idx="37">
                  <c:v>3.7</c:v>
                </c:pt>
                <c:pt idx="38">
                  <c:v>3.8</c:v>
                </c:pt>
                <c:pt idx="39">
                  <c:v>5.2</c:v>
                </c:pt>
                <c:pt idx="40">
                  <c:v>5</c:v>
                </c:pt>
                <c:pt idx="41">
                  <c:v>5.3</c:v>
                </c:pt>
                <c:pt idx="42">
                  <c:v>4.7</c:v>
                </c:pt>
                <c:pt idx="43">
                  <c:v>4.8</c:v>
                </c:pt>
                <c:pt idx="44">
                  <c:v>4.7</c:v>
                </c:pt>
                <c:pt idx="45">
                  <c:v>5.0999999999999996</c:v>
                </c:pt>
                <c:pt idx="46">
                  <c:v>4</c:v>
                </c:pt>
                <c:pt idx="47">
                  <c:v>3.6</c:v>
                </c:pt>
                <c:pt idx="48">
                  <c:v>5.0999999999999996</c:v>
                </c:pt>
                <c:pt idx="49">
                  <c:v>4.9000000000000004</c:v>
                </c:pt>
                <c:pt idx="50">
                  <c:v>5.0999999999999996</c:v>
                </c:pt>
                <c:pt idx="51">
                  <c:v>5.5</c:v>
                </c:pt>
                <c:pt idx="52">
                  <c:v>7</c:v>
                </c:pt>
                <c:pt idx="53">
                  <c:v>6.8</c:v>
                </c:pt>
                <c:pt idx="54">
                  <c:v>5.4</c:v>
                </c:pt>
                <c:pt idx="55">
                  <c:v>4.4000000000000004</c:v>
                </c:pt>
                <c:pt idx="56">
                  <c:v>6.6</c:v>
                </c:pt>
                <c:pt idx="57">
                  <c:v>5.9</c:v>
                </c:pt>
                <c:pt idx="58">
                  <c:v>5.8</c:v>
                </c:pt>
                <c:pt idx="59">
                  <c:v>6</c:v>
                </c:pt>
                <c:pt idx="60">
                  <c:v>6.1</c:v>
                </c:pt>
                <c:pt idx="61">
                  <c:v>6.6</c:v>
                </c:pt>
                <c:pt idx="62">
                  <c:v>8.6999999999999993</c:v>
                </c:pt>
                <c:pt idx="63">
                  <c:v>6.7</c:v>
                </c:pt>
                <c:pt idx="64">
                  <c:v>4.5999999999999996</c:v>
                </c:pt>
                <c:pt idx="65">
                  <c:v>6.5</c:v>
                </c:pt>
                <c:pt idx="66">
                  <c:v>5.6</c:v>
                </c:pt>
                <c:pt idx="67">
                  <c:v>5.5</c:v>
                </c:pt>
                <c:pt idx="68">
                  <c:v>5.0999999999999996</c:v>
                </c:pt>
                <c:pt idx="69">
                  <c:v>5.5</c:v>
                </c:pt>
                <c:pt idx="70">
                  <c:v>6.1</c:v>
                </c:pt>
                <c:pt idx="71">
                  <c:v>6.4</c:v>
                </c:pt>
                <c:pt idx="72">
                  <c:v>6</c:v>
                </c:pt>
                <c:pt idx="73">
                  <c:v>6.5</c:v>
                </c:pt>
                <c:pt idx="74">
                  <c:v>6.9</c:v>
                </c:pt>
                <c:pt idx="75">
                  <c:v>7.4</c:v>
                </c:pt>
                <c:pt idx="76">
                  <c:v>8.6</c:v>
                </c:pt>
                <c:pt idx="77">
                  <c:v>7.7</c:v>
                </c:pt>
                <c:pt idx="78">
                  <c:v>8.8000000000000007</c:v>
                </c:pt>
                <c:pt idx="79">
                  <c:v>8.8000000000000007</c:v>
                </c:pt>
                <c:pt idx="80">
                  <c:v>8.3000000000000007</c:v>
                </c:pt>
                <c:pt idx="81">
                  <c:v>8.1</c:v>
                </c:pt>
                <c:pt idx="82">
                  <c:v>8</c:v>
                </c:pt>
                <c:pt idx="83">
                  <c:v>7.2</c:v>
                </c:pt>
                <c:pt idx="84">
                  <c:v>6.9</c:v>
                </c:pt>
                <c:pt idx="85">
                  <c:v>7.6</c:v>
                </c:pt>
                <c:pt idx="86">
                  <c:v>8.6</c:v>
                </c:pt>
                <c:pt idx="87">
                  <c:v>8.8000000000000007</c:v>
                </c:pt>
                <c:pt idx="88">
                  <c:v>8.5</c:v>
                </c:pt>
                <c:pt idx="89">
                  <c:v>10.7</c:v>
                </c:pt>
                <c:pt idx="90">
                  <c:v>10.199999999999999</c:v>
                </c:pt>
                <c:pt idx="91">
                  <c:v>9.6</c:v>
                </c:pt>
                <c:pt idx="92">
                  <c:v>10.7</c:v>
                </c:pt>
                <c:pt idx="93">
                  <c:v>8.6</c:v>
                </c:pt>
                <c:pt idx="94">
                  <c:v>7.9</c:v>
                </c:pt>
                <c:pt idx="95">
                  <c:v>8.4</c:v>
                </c:pt>
                <c:pt idx="96">
                  <c:v>7.9</c:v>
                </c:pt>
                <c:pt idx="97">
                  <c:v>8.1999999999999993</c:v>
                </c:pt>
                <c:pt idx="98">
                  <c:v>9.3000000000000007</c:v>
                </c:pt>
                <c:pt idx="99">
                  <c:v>11.6</c:v>
                </c:pt>
                <c:pt idx="100">
                  <c:v>9.1</c:v>
                </c:pt>
                <c:pt idx="101">
                  <c:v>9</c:v>
                </c:pt>
                <c:pt idx="102">
                  <c:v>8.8000000000000007</c:v>
                </c:pt>
                <c:pt idx="103">
                  <c:v>11</c:v>
                </c:pt>
                <c:pt idx="104">
                  <c:v>11.6</c:v>
                </c:pt>
                <c:pt idx="105">
                  <c:v>10.3</c:v>
                </c:pt>
                <c:pt idx="106">
                  <c:v>8.1999999999999993</c:v>
                </c:pt>
                <c:pt idx="107">
                  <c:v>7.8</c:v>
                </c:pt>
                <c:pt idx="108">
                  <c:v>10.5</c:v>
                </c:pt>
                <c:pt idx="109">
                  <c:v>11.2</c:v>
                </c:pt>
                <c:pt idx="110">
                  <c:v>7</c:v>
                </c:pt>
                <c:pt idx="111">
                  <c:v>9.5</c:v>
                </c:pt>
                <c:pt idx="112">
                  <c:v>9.3000000000000007</c:v>
                </c:pt>
                <c:pt idx="113">
                  <c:v>8.6</c:v>
                </c:pt>
                <c:pt idx="114">
                  <c:v>8.6</c:v>
                </c:pt>
                <c:pt idx="115">
                  <c:v>9</c:v>
                </c:pt>
                <c:pt idx="116">
                  <c:v>8.9</c:v>
                </c:pt>
                <c:pt idx="117">
                  <c:v>10</c:v>
                </c:pt>
                <c:pt idx="118">
                  <c:v>10.6</c:v>
                </c:pt>
                <c:pt idx="119">
                  <c:v>9.9</c:v>
                </c:pt>
                <c:pt idx="120">
                  <c:v>10.6</c:v>
                </c:pt>
                <c:pt idx="121">
                  <c:v>10.1</c:v>
                </c:pt>
                <c:pt idx="122">
                  <c:v>9.1</c:v>
                </c:pt>
                <c:pt idx="123">
                  <c:v>12.1</c:v>
                </c:pt>
                <c:pt idx="124">
                  <c:v>12.3</c:v>
                </c:pt>
                <c:pt idx="125">
                  <c:v>11.6</c:v>
                </c:pt>
                <c:pt idx="126">
                  <c:v>12</c:v>
                </c:pt>
                <c:pt idx="127">
                  <c:v>10.199999999999999</c:v>
                </c:pt>
                <c:pt idx="128">
                  <c:v>6.1</c:v>
                </c:pt>
                <c:pt idx="129">
                  <c:v>7.7</c:v>
                </c:pt>
                <c:pt idx="130">
                  <c:v>6.5</c:v>
                </c:pt>
                <c:pt idx="131">
                  <c:v>7.1</c:v>
                </c:pt>
                <c:pt idx="132">
                  <c:v>6.2</c:v>
                </c:pt>
                <c:pt idx="133">
                  <c:v>7.4</c:v>
                </c:pt>
                <c:pt idx="134">
                  <c:v>8.1999999999999993</c:v>
                </c:pt>
                <c:pt idx="135">
                  <c:v>8.9</c:v>
                </c:pt>
                <c:pt idx="136">
                  <c:v>9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67D-4FC6-97EF-1746521E7E41}"/>
            </c:ext>
          </c:extLst>
        </c:ser>
        <c:ser>
          <c:idx val="2"/>
          <c:order val="2"/>
          <c:tx>
            <c:strRef>
              <c:f>'env1'!$E$1</c:f>
              <c:strCache>
                <c:ptCount val="1"/>
                <c:pt idx="0">
                  <c:v>Max Temp</c:v>
                </c:pt>
              </c:strCache>
            </c:strRef>
          </c:tx>
          <c:spPr>
            <a:ln w="38100">
              <a:solidFill>
                <a:srgbClr val="56EE20"/>
              </a:solidFill>
            </a:ln>
          </c:spPr>
          <c:marker>
            <c:symbol val="none"/>
          </c:marker>
          <c:cat>
            <c:multiLvlStrRef>
              <c:f>'env1'!$A$2:$B$138</c:f>
              <c:multiLvlStrCache>
                <c:ptCount val="137"/>
                <c:lvl>
                  <c:pt idx="0">
                    <c:v>12/15/2012</c:v>
                  </c:pt>
                  <c:pt idx="1">
                    <c:v>12/16/2012</c:v>
                  </c:pt>
                  <c:pt idx="2">
                    <c:v>12/17/2012</c:v>
                  </c:pt>
                  <c:pt idx="3">
                    <c:v>12/18/2012</c:v>
                  </c:pt>
                  <c:pt idx="4">
                    <c:v>12/19/2012</c:v>
                  </c:pt>
                  <c:pt idx="5">
                    <c:v>12/20/2012</c:v>
                  </c:pt>
                  <c:pt idx="6">
                    <c:v>12/21/2012</c:v>
                  </c:pt>
                  <c:pt idx="7">
                    <c:v>12/22/2012</c:v>
                  </c:pt>
                  <c:pt idx="8">
                    <c:v>12/23/2012</c:v>
                  </c:pt>
                  <c:pt idx="9">
                    <c:v>12/24/2012</c:v>
                  </c:pt>
                  <c:pt idx="10">
                    <c:v>12/25/2012</c:v>
                  </c:pt>
                  <c:pt idx="11">
                    <c:v>12/26/2012</c:v>
                  </c:pt>
                  <c:pt idx="12">
                    <c:v>12/27/2012</c:v>
                  </c:pt>
                  <c:pt idx="13">
                    <c:v>12/28/2012</c:v>
                  </c:pt>
                  <c:pt idx="14">
                    <c:v>12/29/2012</c:v>
                  </c:pt>
                  <c:pt idx="15">
                    <c:v>12/30/2012</c:v>
                  </c:pt>
                  <c:pt idx="16">
                    <c:v>12/31/2012</c:v>
                  </c:pt>
                  <c:pt idx="17">
                    <c:v>1/1/2013</c:v>
                  </c:pt>
                  <c:pt idx="18">
                    <c:v>1/2/2013</c:v>
                  </c:pt>
                  <c:pt idx="19">
                    <c:v>1/3/2013</c:v>
                  </c:pt>
                  <c:pt idx="20">
                    <c:v>1/4/2013</c:v>
                  </c:pt>
                  <c:pt idx="21">
                    <c:v>1/5/2013</c:v>
                  </c:pt>
                  <c:pt idx="22">
                    <c:v>1/6/2013</c:v>
                  </c:pt>
                  <c:pt idx="23">
                    <c:v>1/7/2013</c:v>
                  </c:pt>
                  <c:pt idx="24">
                    <c:v>1/8/2013</c:v>
                  </c:pt>
                  <c:pt idx="25">
                    <c:v>1/9/2013</c:v>
                  </c:pt>
                  <c:pt idx="26">
                    <c:v>1/10/2013</c:v>
                  </c:pt>
                  <c:pt idx="27">
                    <c:v>1/11/2013</c:v>
                  </c:pt>
                  <c:pt idx="28">
                    <c:v>1/12/2013</c:v>
                  </c:pt>
                  <c:pt idx="29">
                    <c:v>1/13/2013</c:v>
                  </c:pt>
                  <c:pt idx="30">
                    <c:v>1/14/2013</c:v>
                  </c:pt>
                  <c:pt idx="31">
                    <c:v>1/15/2013</c:v>
                  </c:pt>
                  <c:pt idx="32">
                    <c:v>1/16/2013</c:v>
                  </c:pt>
                  <c:pt idx="33">
                    <c:v>1/17/2013</c:v>
                  </c:pt>
                  <c:pt idx="34">
                    <c:v>1/18/2013</c:v>
                  </c:pt>
                  <c:pt idx="35">
                    <c:v>1/19/2013</c:v>
                  </c:pt>
                  <c:pt idx="36">
                    <c:v>1/20/2013</c:v>
                  </c:pt>
                  <c:pt idx="37">
                    <c:v>1/21/2013</c:v>
                  </c:pt>
                  <c:pt idx="38">
                    <c:v>1/22/2013</c:v>
                  </c:pt>
                  <c:pt idx="39">
                    <c:v>1/23/2013</c:v>
                  </c:pt>
                  <c:pt idx="40">
                    <c:v>1/24/2013</c:v>
                  </c:pt>
                  <c:pt idx="41">
                    <c:v>1/25/2013</c:v>
                  </c:pt>
                  <c:pt idx="42">
                    <c:v>1/26/2013</c:v>
                  </c:pt>
                  <c:pt idx="43">
                    <c:v>1/27/2013</c:v>
                  </c:pt>
                  <c:pt idx="44">
                    <c:v>1/28/2013</c:v>
                  </c:pt>
                  <c:pt idx="45">
                    <c:v>1/29/2013</c:v>
                  </c:pt>
                  <c:pt idx="46">
                    <c:v>1/30/2013</c:v>
                  </c:pt>
                  <c:pt idx="47">
                    <c:v>1/31/2013</c:v>
                  </c:pt>
                  <c:pt idx="48">
                    <c:v>2/1/2013</c:v>
                  </c:pt>
                  <c:pt idx="49">
                    <c:v>2/2/2013</c:v>
                  </c:pt>
                  <c:pt idx="50">
                    <c:v>2/3/2013</c:v>
                  </c:pt>
                  <c:pt idx="51">
                    <c:v>2/4/2013</c:v>
                  </c:pt>
                  <c:pt idx="52">
                    <c:v>2/5/2013</c:v>
                  </c:pt>
                  <c:pt idx="53">
                    <c:v>2/6/2013</c:v>
                  </c:pt>
                  <c:pt idx="54">
                    <c:v>2/7/2013</c:v>
                  </c:pt>
                  <c:pt idx="55">
                    <c:v>2/8/2013</c:v>
                  </c:pt>
                  <c:pt idx="56">
                    <c:v>2/9/2013</c:v>
                  </c:pt>
                  <c:pt idx="57">
                    <c:v>2/10/2013</c:v>
                  </c:pt>
                  <c:pt idx="58">
                    <c:v>2/11/2013</c:v>
                  </c:pt>
                  <c:pt idx="59">
                    <c:v>2/12/2013</c:v>
                  </c:pt>
                  <c:pt idx="60">
                    <c:v>2/13/2013</c:v>
                  </c:pt>
                  <c:pt idx="61">
                    <c:v>2/14/2013</c:v>
                  </c:pt>
                  <c:pt idx="62">
                    <c:v>2/15/2013</c:v>
                  </c:pt>
                  <c:pt idx="63">
                    <c:v>2/16/2013</c:v>
                  </c:pt>
                  <c:pt idx="64">
                    <c:v>2/17/2013</c:v>
                  </c:pt>
                  <c:pt idx="65">
                    <c:v>2/18/2013</c:v>
                  </c:pt>
                  <c:pt idx="66">
                    <c:v>2/19/2013</c:v>
                  </c:pt>
                  <c:pt idx="67">
                    <c:v>2/20/2013</c:v>
                  </c:pt>
                  <c:pt idx="68">
                    <c:v>2/21/2013</c:v>
                  </c:pt>
                  <c:pt idx="69">
                    <c:v>2/22/2013</c:v>
                  </c:pt>
                  <c:pt idx="70">
                    <c:v>2/23/2013</c:v>
                  </c:pt>
                  <c:pt idx="71">
                    <c:v>2/24/2013</c:v>
                  </c:pt>
                  <c:pt idx="72">
                    <c:v>2/25/2013</c:v>
                  </c:pt>
                  <c:pt idx="73">
                    <c:v>2/26/2013</c:v>
                  </c:pt>
                  <c:pt idx="74">
                    <c:v>2/27/2013</c:v>
                  </c:pt>
                  <c:pt idx="75">
                    <c:v>2/28/2013</c:v>
                  </c:pt>
                  <c:pt idx="76">
                    <c:v>3/1/2013</c:v>
                  </c:pt>
                  <c:pt idx="77">
                    <c:v>3/2/2013</c:v>
                  </c:pt>
                  <c:pt idx="78">
                    <c:v>3/3/2013</c:v>
                  </c:pt>
                  <c:pt idx="79">
                    <c:v>3/4/2013</c:v>
                  </c:pt>
                  <c:pt idx="80">
                    <c:v>3/5/2013</c:v>
                  </c:pt>
                  <c:pt idx="81">
                    <c:v>3/6/2013</c:v>
                  </c:pt>
                  <c:pt idx="82">
                    <c:v>3/7/2013</c:v>
                  </c:pt>
                  <c:pt idx="83">
                    <c:v>3/8/2013</c:v>
                  </c:pt>
                  <c:pt idx="84">
                    <c:v>3/9/2013</c:v>
                  </c:pt>
                  <c:pt idx="85">
                    <c:v>3/10/2013</c:v>
                  </c:pt>
                  <c:pt idx="86">
                    <c:v>3/11/2013</c:v>
                  </c:pt>
                  <c:pt idx="87">
                    <c:v>3/12/2013</c:v>
                  </c:pt>
                  <c:pt idx="88">
                    <c:v>3/13/2013</c:v>
                  </c:pt>
                  <c:pt idx="89">
                    <c:v>3/14/2013</c:v>
                  </c:pt>
                  <c:pt idx="90">
                    <c:v>3/15/2013</c:v>
                  </c:pt>
                  <c:pt idx="91">
                    <c:v>3/16/2013</c:v>
                  </c:pt>
                  <c:pt idx="92">
                    <c:v>3/17/2013</c:v>
                  </c:pt>
                  <c:pt idx="93">
                    <c:v>3/18/2013</c:v>
                  </c:pt>
                  <c:pt idx="94">
                    <c:v>3/19/2013</c:v>
                  </c:pt>
                  <c:pt idx="95">
                    <c:v>3/20/2013</c:v>
                  </c:pt>
                  <c:pt idx="96">
                    <c:v>3/21/2013</c:v>
                  </c:pt>
                  <c:pt idx="97">
                    <c:v>3/22/2013</c:v>
                  </c:pt>
                  <c:pt idx="98">
                    <c:v>3/23/2013</c:v>
                  </c:pt>
                  <c:pt idx="99">
                    <c:v>3/24/2013</c:v>
                  </c:pt>
                  <c:pt idx="100">
                    <c:v>3/25/2013</c:v>
                  </c:pt>
                  <c:pt idx="101">
                    <c:v>3/26/2013</c:v>
                  </c:pt>
                  <c:pt idx="102">
                    <c:v>3/27/2013</c:v>
                  </c:pt>
                  <c:pt idx="103">
                    <c:v>3/28/2013</c:v>
                  </c:pt>
                  <c:pt idx="104">
                    <c:v>3/29/2013</c:v>
                  </c:pt>
                  <c:pt idx="105">
                    <c:v>3/30/2013</c:v>
                  </c:pt>
                  <c:pt idx="106">
                    <c:v>3/31/2013</c:v>
                  </c:pt>
                  <c:pt idx="107">
                    <c:v>4/1/2013</c:v>
                  </c:pt>
                  <c:pt idx="108">
                    <c:v>4/2/2013</c:v>
                  </c:pt>
                  <c:pt idx="109">
                    <c:v>4/3/2013</c:v>
                  </c:pt>
                  <c:pt idx="110">
                    <c:v>4/4/2013</c:v>
                  </c:pt>
                  <c:pt idx="111">
                    <c:v>4/5/2013</c:v>
                  </c:pt>
                  <c:pt idx="112">
                    <c:v>4/6/2013</c:v>
                  </c:pt>
                  <c:pt idx="113">
                    <c:v>4/7/2013</c:v>
                  </c:pt>
                  <c:pt idx="114">
                    <c:v>4/8/2013</c:v>
                  </c:pt>
                  <c:pt idx="115">
                    <c:v>4/9/2013</c:v>
                  </c:pt>
                  <c:pt idx="116">
                    <c:v>4/10/2013</c:v>
                  </c:pt>
                  <c:pt idx="117">
                    <c:v>4/11/2013</c:v>
                  </c:pt>
                  <c:pt idx="118">
                    <c:v>4/12/2013</c:v>
                  </c:pt>
                  <c:pt idx="119">
                    <c:v>4/13/2013</c:v>
                  </c:pt>
                  <c:pt idx="120">
                    <c:v>4/14/2013</c:v>
                  </c:pt>
                  <c:pt idx="121">
                    <c:v>4/15/2013</c:v>
                  </c:pt>
                  <c:pt idx="122">
                    <c:v>4/16/2013</c:v>
                  </c:pt>
                  <c:pt idx="123">
                    <c:v>4/17/2013</c:v>
                  </c:pt>
                  <c:pt idx="124">
                    <c:v>4/18/2013</c:v>
                  </c:pt>
                  <c:pt idx="125">
                    <c:v>4/19/2013</c:v>
                  </c:pt>
                  <c:pt idx="126">
                    <c:v>4/20/2013</c:v>
                  </c:pt>
                  <c:pt idx="127">
                    <c:v>4/21/2013</c:v>
                  </c:pt>
                  <c:pt idx="128">
                    <c:v>4/22/2013</c:v>
                  </c:pt>
                  <c:pt idx="129">
                    <c:v>4/23/2013</c:v>
                  </c:pt>
                  <c:pt idx="130">
                    <c:v>4/24/2013</c:v>
                  </c:pt>
                  <c:pt idx="131">
                    <c:v>4/25/2013</c:v>
                  </c:pt>
                  <c:pt idx="132">
                    <c:v>4/26/2013</c:v>
                  </c:pt>
                  <c:pt idx="133">
                    <c:v>4/27/2013</c:v>
                  </c:pt>
                  <c:pt idx="134">
                    <c:v>4/28/2013</c:v>
                  </c:pt>
                  <c:pt idx="135">
                    <c:v>4/29/2013</c:v>
                  </c:pt>
                  <c:pt idx="136">
                    <c:v>4/30/2013</c:v>
                  </c:pt>
                </c:lvl>
                <c:lvl>
                  <c:pt idx="16">
                    <c:v>DOS</c:v>
                  </c:pt>
                  <c:pt idx="88">
                    <c:v>%GL7</c:v>
                  </c:pt>
                  <c:pt idx="95">
                    <c:v>%GL14</c:v>
                  </c:pt>
                  <c:pt idx="101">
                    <c:v>%GL21</c:v>
                  </c:pt>
                  <c:pt idx="108">
                    <c:v>%GL28</c:v>
                  </c:pt>
                  <c:pt idx="115">
                    <c:v>%GL35</c:v>
                  </c:pt>
                  <c:pt idx="122">
                    <c:v>%GL42</c:v>
                  </c:pt>
                  <c:pt idx="129">
                    <c:v>%GL49</c:v>
                  </c:pt>
                </c:lvl>
              </c:multiLvlStrCache>
            </c:multiLvlStrRef>
          </c:cat>
          <c:val>
            <c:numRef>
              <c:f>'env1'!$E$2:$E$138</c:f>
              <c:numCache>
                <c:formatCode>General</c:formatCode>
                <c:ptCount val="137"/>
                <c:pt idx="0">
                  <c:v>30.8</c:v>
                </c:pt>
                <c:pt idx="1">
                  <c:v>29.2</c:v>
                </c:pt>
                <c:pt idx="2">
                  <c:v>29.2</c:v>
                </c:pt>
                <c:pt idx="3">
                  <c:v>29</c:v>
                </c:pt>
                <c:pt idx="4">
                  <c:v>28.9</c:v>
                </c:pt>
                <c:pt idx="5">
                  <c:v>28.8</c:v>
                </c:pt>
                <c:pt idx="6">
                  <c:v>28.9</c:v>
                </c:pt>
                <c:pt idx="7">
                  <c:v>28.6</c:v>
                </c:pt>
                <c:pt idx="8">
                  <c:v>29.2</c:v>
                </c:pt>
                <c:pt idx="9">
                  <c:v>28.7</c:v>
                </c:pt>
                <c:pt idx="10">
                  <c:v>27.8</c:v>
                </c:pt>
                <c:pt idx="11">
                  <c:v>28.4</c:v>
                </c:pt>
                <c:pt idx="12">
                  <c:v>28.7</c:v>
                </c:pt>
                <c:pt idx="13">
                  <c:v>28</c:v>
                </c:pt>
                <c:pt idx="14">
                  <c:v>29.4</c:v>
                </c:pt>
                <c:pt idx="15">
                  <c:v>29</c:v>
                </c:pt>
                <c:pt idx="16">
                  <c:v>28.8</c:v>
                </c:pt>
                <c:pt idx="17">
                  <c:v>30.4</c:v>
                </c:pt>
                <c:pt idx="18">
                  <c:v>32</c:v>
                </c:pt>
                <c:pt idx="19">
                  <c:v>32.700000000000003</c:v>
                </c:pt>
                <c:pt idx="20">
                  <c:v>33.200000000000003</c:v>
                </c:pt>
                <c:pt idx="21">
                  <c:v>32.700000000000003</c:v>
                </c:pt>
                <c:pt idx="22">
                  <c:v>33.5</c:v>
                </c:pt>
                <c:pt idx="23">
                  <c:v>31.5</c:v>
                </c:pt>
                <c:pt idx="24">
                  <c:v>31.2</c:v>
                </c:pt>
                <c:pt idx="25">
                  <c:v>30.3</c:v>
                </c:pt>
                <c:pt idx="26">
                  <c:v>28.8</c:v>
                </c:pt>
                <c:pt idx="27">
                  <c:v>29.6</c:v>
                </c:pt>
                <c:pt idx="28">
                  <c:v>28.9</c:v>
                </c:pt>
                <c:pt idx="29">
                  <c:v>29.4</c:v>
                </c:pt>
                <c:pt idx="30">
                  <c:v>31.5</c:v>
                </c:pt>
                <c:pt idx="31">
                  <c:v>32.6</c:v>
                </c:pt>
                <c:pt idx="32">
                  <c:v>32</c:v>
                </c:pt>
                <c:pt idx="33">
                  <c:v>31.8</c:v>
                </c:pt>
                <c:pt idx="34">
                  <c:v>30.1</c:v>
                </c:pt>
                <c:pt idx="35">
                  <c:v>29.9</c:v>
                </c:pt>
                <c:pt idx="36">
                  <c:v>29.5</c:v>
                </c:pt>
                <c:pt idx="37">
                  <c:v>29.2</c:v>
                </c:pt>
                <c:pt idx="38">
                  <c:v>29.7</c:v>
                </c:pt>
                <c:pt idx="39">
                  <c:v>29.8</c:v>
                </c:pt>
                <c:pt idx="40">
                  <c:v>29.3</c:v>
                </c:pt>
                <c:pt idx="41">
                  <c:v>30.2</c:v>
                </c:pt>
                <c:pt idx="42">
                  <c:v>29.8</c:v>
                </c:pt>
                <c:pt idx="43">
                  <c:v>30</c:v>
                </c:pt>
                <c:pt idx="44">
                  <c:v>30.6</c:v>
                </c:pt>
                <c:pt idx="45">
                  <c:v>29.9</c:v>
                </c:pt>
                <c:pt idx="46">
                  <c:v>30.4</c:v>
                </c:pt>
                <c:pt idx="47">
                  <c:v>28.2</c:v>
                </c:pt>
                <c:pt idx="48">
                  <c:v>28.5</c:v>
                </c:pt>
                <c:pt idx="49">
                  <c:v>28.7</c:v>
                </c:pt>
                <c:pt idx="50">
                  <c:v>28.8</c:v>
                </c:pt>
                <c:pt idx="51">
                  <c:v>30</c:v>
                </c:pt>
                <c:pt idx="52">
                  <c:v>30.3</c:v>
                </c:pt>
                <c:pt idx="53">
                  <c:v>31.8</c:v>
                </c:pt>
                <c:pt idx="54">
                  <c:v>32.5</c:v>
                </c:pt>
                <c:pt idx="55">
                  <c:v>31.7</c:v>
                </c:pt>
                <c:pt idx="56">
                  <c:v>29.5</c:v>
                </c:pt>
                <c:pt idx="57">
                  <c:v>29.3</c:v>
                </c:pt>
                <c:pt idx="58">
                  <c:v>30.6</c:v>
                </c:pt>
                <c:pt idx="59">
                  <c:v>31.3</c:v>
                </c:pt>
                <c:pt idx="60">
                  <c:v>31</c:v>
                </c:pt>
                <c:pt idx="61">
                  <c:v>30.5</c:v>
                </c:pt>
                <c:pt idx="62">
                  <c:v>32</c:v>
                </c:pt>
                <c:pt idx="63">
                  <c:v>32.5</c:v>
                </c:pt>
                <c:pt idx="64">
                  <c:v>30.5</c:v>
                </c:pt>
                <c:pt idx="65">
                  <c:v>28.7</c:v>
                </c:pt>
                <c:pt idx="66">
                  <c:v>29.2</c:v>
                </c:pt>
                <c:pt idx="67">
                  <c:v>31.3</c:v>
                </c:pt>
                <c:pt idx="68">
                  <c:v>31.5</c:v>
                </c:pt>
                <c:pt idx="69">
                  <c:v>31</c:v>
                </c:pt>
                <c:pt idx="70">
                  <c:v>31.7</c:v>
                </c:pt>
                <c:pt idx="71">
                  <c:v>33.700000000000003</c:v>
                </c:pt>
                <c:pt idx="72">
                  <c:v>33.200000000000003</c:v>
                </c:pt>
                <c:pt idx="73">
                  <c:v>32.799999999999997</c:v>
                </c:pt>
                <c:pt idx="74">
                  <c:v>32.799999999999997</c:v>
                </c:pt>
                <c:pt idx="75">
                  <c:v>34.299999999999997</c:v>
                </c:pt>
                <c:pt idx="76">
                  <c:v>34.5</c:v>
                </c:pt>
                <c:pt idx="77">
                  <c:v>33.799999999999997</c:v>
                </c:pt>
                <c:pt idx="78">
                  <c:v>33.5</c:v>
                </c:pt>
                <c:pt idx="79">
                  <c:v>34.200000000000003</c:v>
                </c:pt>
                <c:pt idx="80">
                  <c:v>34.6</c:v>
                </c:pt>
                <c:pt idx="81">
                  <c:v>32.799999999999997</c:v>
                </c:pt>
                <c:pt idx="82">
                  <c:v>33.5</c:v>
                </c:pt>
                <c:pt idx="83">
                  <c:v>33.799999999999997</c:v>
                </c:pt>
                <c:pt idx="84">
                  <c:v>34.700000000000003</c:v>
                </c:pt>
                <c:pt idx="85">
                  <c:v>35.200000000000003</c:v>
                </c:pt>
                <c:pt idx="86">
                  <c:v>35.6</c:v>
                </c:pt>
                <c:pt idx="87">
                  <c:v>36.200000000000003</c:v>
                </c:pt>
                <c:pt idx="88">
                  <c:v>35.6</c:v>
                </c:pt>
                <c:pt idx="89">
                  <c:v>36.5</c:v>
                </c:pt>
                <c:pt idx="90">
                  <c:v>35.200000000000003</c:v>
                </c:pt>
                <c:pt idx="91">
                  <c:v>34.9</c:v>
                </c:pt>
                <c:pt idx="92">
                  <c:v>33.6</c:v>
                </c:pt>
                <c:pt idx="93">
                  <c:v>34.799999999999997</c:v>
                </c:pt>
                <c:pt idx="94">
                  <c:v>34.9</c:v>
                </c:pt>
                <c:pt idx="95">
                  <c:v>34.9</c:v>
                </c:pt>
                <c:pt idx="96">
                  <c:v>36.200000000000003</c:v>
                </c:pt>
                <c:pt idx="97">
                  <c:v>37.4</c:v>
                </c:pt>
                <c:pt idx="98">
                  <c:v>37.5</c:v>
                </c:pt>
                <c:pt idx="99">
                  <c:v>37.200000000000003</c:v>
                </c:pt>
                <c:pt idx="100">
                  <c:v>36.700000000000003</c:v>
                </c:pt>
                <c:pt idx="101">
                  <c:v>37.799999999999997</c:v>
                </c:pt>
                <c:pt idx="102">
                  <c:v>38.299999999999997</c:v>
                </c:pt>
                <c:pt idx="103">
                  <c:v>38.6</c:v>
                </c:pt>
                <c:pt idx="104">
                  <c:v>38</c:v>
                </c:pt>
                <c:pt idx="105">
                  <c:v>37.6</c:v>
                </c:pt>
                <c:pt idx="106">
                  <c:v>37.4</c:v>
                </c:pt>
                <c:pt idx="107">
                  <c:v>37.799999999999997</c:v>
                </c:pt>
                <c:pt idx="108">
                  <c:v>38.6</c:v>
                </c:pt>
                <c:pt idx="109">
                  <c:v>34.4</c:v>
                </c:pt>
                <c:pt idx="110">
                  <c:v>34.799999999999997</c:v>
                </c:pt>
                <c:pt idx="111">
                  <c:v>35.799999999999997</c:v>
                </c:pt>
                <c:pt idx="112">
                  <c:v>37.299999999999997</c:v>
                </c:pt>
                <c:pt idx="113">
                  <c:v>38</c:v>
                </c:pt>
                <c:pt idx="114">
                  <c:v>39.200000000000003</c:v>
                </c:pt>
                <c:pt idx="115">
                  <c:v>38.200000000000003</c:v>
                </c:pt>
                <c:pt idx="116">
                  <c:v>38</c:v>
                </c:pt>
                <c:pt idx="117">
                  <c:v>38.4</c:v>
                </c:pt>
                <c:pt idx="118">
                  <c:v>38.6</c:v>
                </c:pt>
                <c:pt idx="119">
                  <c:v>38</c:v>
                </c:pt>
                <c:pt idx="120">
                  <c:v>38.6</c:v>
                </c:pt>
                <c:pt idx="121">
                  <c:v>35.799999999999997</c:v>
                </c:pt>
                <c:pt idx="122">
                  <c:v>38.4</c:v>
                </c:pt>
                <c:pt idx="123">
                  <c:v>38.5</c:v>
                </c:pt>
                <c:pt idx="124">
                  <c:v>39.799999999999997</c:v>
                </c:pt>
                <c:pt idx="125">
                  <c:v>39</c:v>
                </c:pt>
                <c:pt idx="126">
                  <c:v>38.4</c:v>
                </c:pt>
                <c:pt idx="127">
                  <c:v>36.200000000000003</c:v>
                </c:pt>
                <c:pt idx="128">
                  <c:v>33.700000000000003</c:v>
                </c:pt>
                <c:pt idx="129">
                  <c:v>36.200000000000003</c:v>
                </c:pt>
                <c:pt idx="130">
                  <c:v>36.700000000000003</c:v>
                </c:pt>
                <c:pt idx="131">
                  <c:v>36.200000000000003</c:v>
                </c:pt>
                <c:pt idx="132">
                  <c:v>35.799999999999997</c:v>
                </c:pt>
                <c:pt idx="133">
                  <c:v>36.299999999999997</c:v>
                </c:pt>
                <c:pt idx="134">
                  <c:v>38.200000000000003</c:v>
                </c:pt>
                <c:pt idx="135">
                  <c:v>39.799999999999997</c:v>
                </c:pt>
                <c:pt idx="136">
                  <c:v>39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67D-4FC6-97EF-1746521E7E41}"/>
            </c:ext>
          </c:extLst>
        </c:ser>
        <c:ser>
          <c:idx val="3"/>
          <c:order val="3"/>
          <c:tx>
            <c:strRef>
              <c:f>'env1'!$F$1</c:f>
              <c:strCache>
                <c:ptCount val="1"/>
                <c:pt idx="0">
                  <c:v>Min Temp</c:v>
                </c:pt>
              </c:strCache>
            </c:strRef>
          </c:tx>
          <c:spPr>
            <a:ln w="38100"/>
          </c:spPr>
          <c:marker>
            <c:symbol val="none"/>
          </c:marker>
          <c:cat>
            <c:multiLvlStrRef>
              <c:f>'env1'!$A$2:$B$138</c:f>
              <c:multiLvlStrCache>
                <c:ptCount val="137"/>
                <c:lvl>
                  <c:pt idx="0">
                    <c:v>12/15/2012</c:v>
                  </c:pt>
                  <c:pt idx="1">
                    <c:v>12/16/2012</c:v>
                  </c:pt>
                  <c:pt idx="2">
                    <c:v>12/17/2012</c:v>
                  </c:pt>
                  <c:pt idx="3">
                    <c:v>12/18/2012</c:v>
                  </c:pt>
                  <c:pt idx="4">
                    <c:v>12/19/2012</c:v>
                  </c:pt>
                  <c:pt idx="5">
                    <c:v>12/20/2012</c:v>
                  </c:pt>
                  <c:pt idx="6">
                    <c:v>12/21/2012</c:v>
                  </c:pt>
                  <c:pt idx="7">
                    <c:v>12/22/2012</c:v>
                  </c:pt>
                  <c:pt idx="8">
                    <c:v>12/23/2012</c:v>
                  </c:pt>
                  <c:pt idx="9">
                    <c:v>12/24/2012</c:v>
                  </c:pt>
                  <c:pt idx="10">
                    <c:v>12/25/2012</c:v>
                  </c:pt>
                  <c:pt idx="11">
                    <c:v>12/26/2012</c:v>
                  </c:pt>
                  <c:pt idx="12">
                    <c:v>12/27/2012</c:v>
                  </c:pt>
                  <c:pt idx="13">
                    <c:v>12/28/2012</c:v>
                  </c:pt>
                  <c:pt idx="14">
                    <c:v>12/29/2012</c:v>
                  </c:pt>
                  <c:pt idx="15">
                    <c:v>12/30/2012</c:v>
                  </c:pt>
                  <c:pt idx="16">
                    <c:v>12/31/2012</c:v>
                  </c:pt>
                  <c:pt idx="17">
                    <c:v>1/1/2013</c:v>
                  </c:pt>
                  <c:pt idx="18">
                    <c:v>1/2/2013</c:v>
                  </c:pt>
                  <c:pt idx="19">
                    <c:v>1/3/2013</c:v>
                  </c:pt>
                  <c:pt idx="20">
                    <c:v>1/4/2013</c:v>
                  </c:pt>
                  <c:pt idx="21">
                    <c:v>1/5/2013</c:v>
                  </c:pt>
                  <c:pt idx="22">
                    <c:v>1/6/2013</c:v>
                  </c:pt>
                  <c:pt idx="23">
                    <c:v>1/7/2013</c:v>
                  </c:pt>
                  <c:pt idx="24">
                    <c:v>1/8/2013</c:v>
                  </c:pt>
                  <c:pt idx="25">
                    <c:v>1/9/2013</c:v>
                  </c:pt>
                  <c:pt idx="26">
                    <c:v>1/10/2013</c:v>
                  </c:pt>
                  <c:pt idx="27">
                    <c:v>1/11/2013</c:v>
                  </c:pt>
                  <c:pt idx="28">
                    <c:v>1/12/2013</c:v>
                  </c:pt>
                  <c:pt idx="29">
                    <c:v>1/13/2013</c:v>
                  </c:pt>
                  <c:pt idx="30">
                    <c:v>1/14/2013</c:v>
                  </c:pt>
                  <c:pt idx="31">
                    <c:v>1/15/2013</c:v>
                  </c:pt>
                  <c:pt idx="32">
                    <c:v>1/16/2013</c:v>
                  </c:pt>
                  <c:pt idx="33">
                    <c:v>1/17/2013</c:v>
                  </c:pt>
                  <c:pt idx="34">
                    <c:v>1/18/2013</c:v>
                  </c:pt>
                  <c:pt idx="35">
                    <c:v>1/19/2013</c:v>
                  </c:pt>
                  <c:pt idx="36">
                    <c:v>1/20/2013</c:v>
                  </c:pt>
                  <c:pt idx="37">
                    <c:v>1/21/2013</c:v>
                  </c:pt>
                  <c:pt idx="38">
                    <c:v>1/22/2013</c:v>
                  </c:pt>
                  <c:pt idx="39">
                    <c:v>1/23/2013</c:v>
                  </c:pt>
                  <c:pt idx="40">
                    <c:v>1/24/2013</c:v>
                  </c:pt>
                  <c:pt idx="41">
                    <c:v>1/25/2013</c:v>
                  </c:pt>
                  <c:pt idx="42">
                    <c:v>1/26/2013</c:v>
                  </c:pt>
                  <c:pt idx="43">
                    <c:v>1/27/2013</c:v>
                  </c:pt>
                  <c:pt idx="44">
                    <c:v>1/28/2013</c:v>
                  </c:pt>
                  <c:pt idx="45">
                    <c:v>1/29/2013</c:v>
                  </c:pt>
                  <c:pt idx="46">
                    <c:v>1/30/2013</c:v>
                  </c:pt>
                  <c:pt idx="47">
                    <c:v>1/31/2013</c:v>
                  </c:pt>
                  <c:pt idx="48">
                    <c:v>2/1/2013</c:v>
                  </c:pt>
                  <c:pt idx="49">
                    <c:v>2/2/2013</c:v>
                  </c:pt>
                  <c:pt idx="50">
                    <c:v>2/3/2013</c:v>
                  </c:pt>
                  <c:pt idx="51">
                    <c:v>2/4/2013</c:v>
                  </c:pt>
                  <c:pt idx="52">
                    <c:v>2/5/2013</c:v>
                  </c:pt>
                  <c:pt idx="53">
                    <c:v>2/6/2013</c:v>
                  </c:pt>
                  <c:pt idx="54">
                    <c:v>2/7/2013</c:v>
                  </c:pt>
                  <c:pt idx="55">
                    <c:v>2/8/2013</c:v>
                  </c:pt>
                  <c:pt idx="56">
                    <c:v>2/9/2013</c:v>
                  </c:pt>
                  <c:pt idx="57">
                    <c:v>2/10/2013</c:v>
                  </c:pt>
                  <c:pt idx="58">
                    <c:v>2/11/2013</c:v>
                  </c:pt>
                  <c:pt idx="59">
                    <c:v>2/12/2013</c:v>
                  </c:pt>
                  <c:pt idx="60">
                    <c:v>2/13/2013</c:v>
                  </c:pt>
                  <c:pt idx="61">
                    <c:v>2/14/2013</c:v>
                  </c:pt>
                  <c:pt idx="62">
                    <c:v>2/15/2013</c:v>
                  </c:pt>
                  <c:pt idx="63">
                    <c:v>2/16/2013</c:v>
                  </c:pt>
                  <c:pt idx="64">
                    <c:v>2/17/2013</c:v>
                  </c:pt>
                  <c:pt idx="65">
                    <c:v>2/18/2013</c:v>
                  </c:pt>
                  <c:pt idx="66">
                    <c:v>2/19/2013</c:v>
                  </c:pt>
                  <c:pt idx="67">
                    <c:v>2/20/2013</c:v>
                  </c:pt>
                  <c:pt idx="68">
                    <c:v>2/21/2013</c:v>
                  </c:pt>
                  <c:pt idx="69">
                    <c:v>2/22/2013</c:v>
                  </c:pt>
                  <c:pt idx="70">
                    <c:v>2/23/2013</c:v>
                  </c:pt>
                  <c:pt idx="71">
                    <c:v>2/24/2013</c:v>
                  </c:pt>
                  <c:pt idx="72">
                    <c:v>2/25/2013</c:v>
                  </c:pt>
                  <c:pt idx="73">
                    <c:v>2/26/2013</c:v>
                  </c:pt>
                  <c:pt idx="74">
                    <c:v>2/27/2013</c:v>
                  </c:pt>
                  <c:pt idx="75">
                    <c:v>2/28/2013</c:v>
                  </c:pt>
                  <c:pt idx="76">
                    <c:v>3/1/2013</c:v>
                  </c:pt>
                  <c:pt idx="77">
                    <c:v>3/2/2013</c:v>
                  </c:pt>
                  <c:pt idx="78">
                    <c:v>3/3/2013</c:v>
                  </c:pt>
                  <c:pt idx="79">
                    <c:v>3/4/2013</c:v>
                  </c:pt>
                  <c:pt idx="80">
                    <c:v>3/5/2013</c:v>
                  </c:pt>
                  <c:pt idx="81">
                    <c:v>3/6/2013</c:v>
                  </c:pt>
                  <c:pt idx="82">
                    <c:v>3/7/2013</c:v>
                  </c:pt>
                  <c:pt idx="83">
                    <c:v>3/8/2013</c:v>
                  </c:pt>
                  <c:pt idx="84">
                    <c:v>3/9/2013</c:v>
                  </c:pt>
                  <c:pt idx="85">
                    <c:v>3/10/2013</c:v>
                  </c:pt>
                  <c:pt idx="86">
                    <c:v>3/11/2013</c:v>
                  </c:pt>
                  <c:pt idx="87">
                    <c:v>3/12/2013</c:v>
                  </c:pt>
                  <c:pt idx="88">
                    <c:v>3/13/2013</c:v>
                  </c:pt>
                  <c:pt idx="89">
                    <c:v>3/14/2013</c:v>
                  </c:pt>
                  <c:pt idx="90">
                    <c:v>3/15/2013</c:v>
                  </c:pt>
                  <c:pt idx="91">
                    <c:v>3/16/2013</c:v>
                  </c:pt>
                  <c:pt idx="92">
                    <c:v>3/17/2013</c:v>
                  </c:pt>
                  <c:pt idx="93">
                    <c:v>3/18/2013</c:v>
                  </c:pt>
                  <c:pt idx="94">
                    <c:v>3/19/2013</c:v>
                  </c:pt>
                  <c:pt idx="95">
                    <c:v>3/20/2013</c:v>
                  </c:pt>
                  <c:pt idx="96">
                    <c:v>3/21/2013</c:v>
                  </c:pt>
                  <c:pt idx="97">
                    <c:v>3/22/2013</c:v>
                  </c:pt>
                  <c:pt idx="98">
                    <c:v>3/23/2013</c:v>
                  </c:pt>
                  <c:pt idx="99">
                    <c:v>3/24/2013</c:v>
                  </c:pt>
                  <c:pt idx="100">
                    <c:v>3/25/2013</c:v>
                  </c:pt>
                  <c:pt idx="101">
                    <c:v>3/26/2013</c:v>
                  </c:pt>
                  <c:pt idx="102">
                    <c:v>3/27/2013</c:v>
                  </c:pt>
                  <c:pt idx="103">
                    <c:v>3/28/2013</c:v>
                  </c:pt>
                  <c:pt idx="104">
                    <c:v>3/29/2013</c:v>
                  </c:pt>
                  <c:pt idx="105">
                    <c:v>3/30/2013</c:v>
                  </c:pt>
                  <c:pt idx="106">
                    <c:v>3/31/2013</c:v>
                  </c:pt>
                  <c:pt idx="107">
                    <c:v>4/1/2013</c:v>
                  </c:pt>
                  <c:pt idx="108">
                    <c:v>4/2/2013</c:v>
                  </c:pt>
                  <c:pt idx="109">
                    <c:v>4/3/2013</c:v>
                  </c:pt>
                  <c:pt idx="110">
                    <c:v>4/4/2013</c:v>
                  </c:pt>
                  <c:pt idx="111">
                    <c:v>4/5/2013</c:v>
                  </c:pt>
                  <c:pt idx="112">
                    <c:v>4/6/2013</c:v>
                  </c:pt>
                  <c:pt idx="113">
                    <c:v>4/7/2013</c:v>
                  </c:pt>
                  <c:pt idx="114">
                    <c:v>4/8/2013</c:v>
                  </c:pt>
                  <c:pt idx="115">
                    <c:v>4/9/2013</c:v>
                  </c:pt>
                  <c:pt idx="116">
                    <c:v>4/10/2013</c:v>
                  </c:pt>
                  <c:pt idx="117">
                    <c:v>4/11/2013</c:v>
                  </c:pt>
                  <c:pt idx="118">
                    <c:v>4/12/2013</c:v>
                  </c:pt>
                  <c:pt idx="119">
                    <c:v>4/13/2013</c:v>
                  </c:pt>
                  <c:pt idx="120">
                    <c:v>4/14/2013</c:v>
                  </c:pt>
                  <c:pt idx="121">
                    <c:v>4/15/2013</c:v>
                  </c:pt>
                  <c:pt idx="122">
                    <c:v>4/16/2013</c:v>
                  </c:pt>
                  <c:pt idx="123">
                    <c:v>4/17/2013</c:v>
                  </c:pt>
                  <c:pt idx="124">
                    <c:v>4/18/2013</c:v>
                  </c:pt>
                  <c:pt idx="125">
                    <c:v>4/19/2013</c:v>
                  </c:pt>
                  <c:pt idx="126">
                    <c:v>4/20/2013</c:v>
                  </c:pt>
                  <c:pt idx="127">
                    <c:v>4/21/2013</c:v>
                  </c:pt>
                  <c:pt idx="128">
                    <c:v>4/22/2013</c:v>
                  </c:pt>
                  <c:pt idx="129">
                    <c:v>4/23/2013</c:v>
                  </c:pt>
                  <c:pt idx="130">
                    <c:v>4/24/2013</c:v>
                  </c:pt>
                  <c:pt idx="131">
                    <c:v>4/25/2013</c:v>
                  </c:pt>
                  <c:pt idx="132">
                    <c:v>4/26/2013</c:v>
                  </c:pt>
                  <c:pt idx="133">
                    <c:v>4/27/2013</c:v>
                  </c:pt>
                  <c:pt idx="134">
                    <c:v>4/28/2013</c:v>
                  </c:pt>
                  <c:pt idx="135">
                    <c:v>4/29/2013</c:v>
                  </c:pt>
                  <c:pt idx="136">
                    <c:v>4/30/2013</c:v>
                  </c:pt>
                </c:lvl>
                <c:lvl>
                  <c:pt idx="16">
                    <c:v>DOS</c:v>
                  </c:pt>
                  <c:pt idx="88">
                    <c:v>%GL7</c:v>
                  </c:pt>
                  <c:pt idx="95">
                    <c:v>%GL14</c:v>
                  </c:pt>
                  <c:pt idx="101">
                    <c:v>%GL21</c:v>
                  </c:pt>
                  <c:pt idx="108">
                    <c:v>%GL28</c:v>
                  </c:pt>
                  <c:pt idx="115">
                    <c:v>%GL35</c:v>
                  </c:pt>
                  <c:pt idx="122">
                    <c:v>%GL42</c:v>
                  </c:pt>
                  <c:pt idx="129">
                    <c:v>%GL49</c:v>
                  </c:pt>
                </c:lvl>
              </c:multiLvlStrCache>
            </c:multiLvlStrRef>
          </c:cat>
          <c:val>
            <c:numRef>
              <c:f>'env1'!$F$2:$F$138</c:f>
              <c:numCache>
                <c:formatCode>General</c:formatCode>
                <c:ptCount val="137"/>
                <c:pt idx="0">
                  <c:v>15</c:v>
                </c:pt>
                <c:pt idx="1">
                  <c:v>12.7</c:v>
                </c:pt>
                <c:pt idx="2">
                  <c:v>13.5</c:v>
                </c:pt>
                <c:pt idx="3">
                  <c:v>11</c:v>
                </c:pt>
                <c:pt idx="4">
                  <c:v>10.5</c:v>
                </c:pt>
                <c:pt idx="5">
                  <c:v>10</c:v>
                </c:pt>
                <c:pt idx="6">
                  <c:v>11.4</c:v>
                </c:pt>
                <c:pt idx="7">
                  <c:v>12.5</c:v>
                </c:pt>
                <c:pt idx="8">
                  <c:v>11.5</c:v>
                </c:pt>
                <c:pt idx="9">
                  <c:v>12.4</c:v>
                </c:pt>
                <c:pt idx="10">
                  <c:v>12.2</c:v>
                </c:pt>
                <c:pt idx="11">
                  <c:v>8.6999999999999993</c:v>
                </c:pt>
                <c:pt idx="12">
                  <c:v>8.5</c:v>
                </c:pt>
                <c:pt idx="13">
                  <c:v>7.6</c:v>
                </c:pt>
                <c:pt idx="14">
                  <c:v>10.9</c:v>
                </c:pt>
                <c:pt idx="15">
                  <c:v>18.899999999999999</c:v>
                </c:pt>
                <c:pt idx="16">
                  <c:v>21</c:v>
                </c:pt>
                <c:pt idx="17">
                  <c:v>19.3</c:v>
                </c:pt>
                <c:pt idx="18">
                  <c:v>19.399999999999999</c:v>
                </c:pt>
                <c:pt idx="19">
                  <c:v>19.399999999999999</c:v>
                </c:pt>
                <c:pt idx="20">
                  <c:v>18.399999999999999</c:v>
                </c:pt>
                <c:pt idx="21">
                  <c:v>16.899999999999999</c:v>
                </c:pt>
                <c:pt idx="22">
                  <c:v>16.5</c:v>
                </c:pt>
                <c:pt idx="23">
                  <c:v>16.100000000000001</c:v>
                </c:pt>
                <c:pt idx="24">
                  <c:v>18.5</c:v>
                </c:pt>
                <c:pt idx="25">
                  <c:v>17.3</c:v>
                </c:pt>
                <c:pt idx="26">
                  <c:v>12.9</c:v>
                </c:pt>
                <c:pt idx="27">
                  <c:v>11.9</c:v>
                </c:pt>
                <c:pt idx="28">
                  <c:v>9.5</c:v>
                </c:pt>
                <c:pt idx="29">
                  <c:v>8.5</c:v>
                </c:pt>
                <c:pt idx="30">
                  <c:v>9.9</c:v>
                </c:pt>
                <c:pt idx="31">
                  <c:v>12.2</c:v>
                </c:pt>
                <c:pt idx="32">
                  <c:v>13.3</c:v>
                </c:pt>
                <c:pt idx="33">
                  <c:v>14</c:v>
                </c:pt>
                <c:pt idx="34">
                  <c:v>12.3</c:v>
                </c:pt>
                <c:pt idx="35">
                  <c:v>14.1</c:v>
                </c:pt>
                <c:pt idx="36">
                  <c:v>13.2</c:v>
                </c:pt>
                <c:pt idx="37">
                  <c:v>12.7</c:v>
                </c:pt>
                <c:pt idx="38">
                  <c:v>17.7</c:v>
                </c:pt>
                <c:pt idx="39">
                  <c:v>15.8</c:v>
                </c:pt>
                <c:pt idx="40">
                  <c:v>17.3</c:v>
                </c:pt>
                <c:pt idx="41">
                  <c:v>18.5</c:v>
                </c:pt>
                <c:pt idx="42">
                  <c:v>17.399999999999999</c:v>
                </c:pt>
                <c:pt idx="43">
                  <c:v>16.899999999999999</c:v>
                </c:pt>
                <c:pt idx="44">
                  <c:v>17.8</c:v>
                </c:pt>
                <c:pt idx="45">
                  <c:v>16.100000000000001</c:v>
                </c:pt>
                <c:pt idx="46">
                  <c:v>17.899999999999999</c:v>
                </c:pt>
                <c:pt idx="47">
                  <c:v>15.1</c:v>
                </c:pt>
                <c:pt idx="48">
                  <c:v>14.5</c:v>
                </c:pt>
                <c:pt idx="49">
                  <c:v>12.9</c:v>
                </c:pt>
                <c:pt idx="50">
                  <c:v>14</c:v>
                </c:pt>
                <c:pt idx="51">
                  <c:v>16.899999999999999</c:v>
                </c:pt>
                <c:pt idx="52">
                  <c:v>16.899999999999999</c:v>
                </c:pt>
                <c:pt idx="53">
                  <c:v>18.7</c:v>
                </c:pt>
                <c:pt idx="54">
                  <c:v>18.3</c:v>
                </c:pt>
                <c:pt idx="55">
                  <c:v>18.399999999999999</c:v>
                </c:pt>
                <c:pt idx="56">
                  <c:v>18.7</c:v>
                </c:pt>
                <c:pt idx="57">
                  <c:v>18.899999999999999</c:v>
                </c:pt>
                <c:pt idx="58">
                  <c:v>16.2</c:v>
                </c:pt>
                <c:pt idx="59">
                  <c:v>16.8</c:v>
                </c:pt>
                <c:pt idx="60">
                  <c:v>17.899999999999999</c:v>
                </c:pt>
                <c:pt idx="61">
                  <c:v>16</c:v>
                </c:pt>
                <c:pt idx="62">
                  <c:v>19.5</c:v>
                </c:pt>
                <c:pt idx="63">
                  <c:v>20.3</c:v>
                </c:pt>
                <c:pt idx="64">
                  <c:v>18</c:v>
                </c:pt>
                <c:pt idx="65">
                  <c:v>11</c:v>
                </c:pt>
                <c:pt idx="66">
                  <c:v>12.2</c:v>
                </c:pt>
                <c:pt idx="67">
                  <c:v>11.7</c:v>
                </c:pt>
                <c:pt idx="68">
                  <c:v>17</c:v>
                </c:pt>
                <c:pt idx="69">
                  <c:v>17</c:v>
                </c:pt>
                <c:pt idx="70">
                  <c:v>16.600000000000001</c:v>
                </c:pt>
                <c:pt idx="71">
                  <c:v>16.7</c:v>
                </c:pt>
                <c:pt idx="72">
                  <c:v>16.3</c:v>
                </c:pt>
                <c:pt idx="73">
                  <c:v>15.5</c:v>
                </c:pt>
                <c:pt idx="74">
                  <c:v>15.4</c:v>
                </c:pt>
                <c:pt idx="75">
                  <c:v>15.4</c:v>
                </c:pt>
                <c:pt idx="76">
                  <c:v>15</c:v>
                </c:pt>
                <c:pt idx="77">
                  <c:v>14.6</c:v>
                </c:pt>
                <c:pt idx="78">
                  <c:v>11.5</c:v>
                </c:pt>
                <c:pt idx="79">
                  <c:v>11.4</c:v>
                </c:pt>
                <c:pt idx="80">
                  <c:v>14</c:v>
                </c:pt>
                <c:pt idx="81">
                  <c:v>15</c:v>
                </c:pt>
                <c:pt idx="82">
                  <c:v>16.399999999999999</c:v>
                </c:pt>
                <c:pt idx="83">
                  <c:v>17.3</c:v>
                </c:pt>
                <c:pt idx="84">
                  <c:v>17.2</c:v>
                </c:pt>
                <c:pt idx="85">
                  <c:v>18.399999999999999</c:v>
                </c:pt>
                <c:pt idx="86">
                  <c:v>20.9</c:v>
                </c:pt>
                <c:pt idx="87">
                  <c:v>21.9</c:v>
                </c:pt>
                <c:pt idx="88">
                  <c:v>20.8</c:v>
                </c:pt>
                <c:pt idx="89">
                  <c:v>20.5</c:v>
                </c:pt>
                <c:pt idx="90">
                  <c:v>22.7</c:v>
                </c:pt>
                <c:pt idx="91">
                  <c:v>16</c:v>
                </c:pt>
                <c:pt idx="92">
                  <c:v>14.4</c:v>
                </c:pt>
                <c:pt idx="93">
                  <c:v>17.2</c:v>
                </c:pt>
                <c:pt idx="94">
                  <c:v>19</c:v>
                </c:pt>
                <c:pt idx="95">
                  <c:v>21.6</c:v>
                </c:pt>
                <c:pt idx="96">
                  <c:v>20</c:v>
                </c:pt>
                <c:pt idx="97">
                  <c:v>20.7</c:v>
                </c:pt>
                <c:pt idx="98">
                  <c:v>22.2</c:v>
                </c:pt>
                <c:pt idx="99">
                  <c:v>21.5</c:v>
                </c:pt>
                <c:pt idx="100">
                  <c:v>20.6</c:v>
                </c:pt>
                <c:pt idx="101">
                  <c:v>22</c:v>
                </c:pt>
                <c:pt idx="102">
                  <c:v>24.9</c:v>
                </c:pt>
                <c:pt idx="103">
                  <c:v>24.1</c:v>
                </c:pt>
                <c:pt idx="104">
                  <c:v>21.5</c:v>
                </c:pt>
                <c:pt idx="105">
                  <c:v>22.6</c:v>
                </c:pt>
                <c:pt idx="106">
                  <c:v>22.5</c:v>
                </c:pt>
                <c:pt idx="107">
                  <c:v>23.9</c:v>
                </c:pt>
                <c:pt idx="108">
                  <c:v>23.7</c:v>
                </c:pt>
                <c:pt idx="109">
                  <c:v>18.3</c:v>
                </c:pt>
                <c:pt idx="110">
                  <c:v>22.3</c:v>
                </c:pt>
                <c:pt idx="111">
                  <c:v>20.9</c:v>
                </c:pt>
                <c:pt idx="112">
                  <c:v>20.5</c:v>
                </c:pt>
                <c:pt idx="113">
                  <c:v>21.3</c:v>
                </c:pt>
                <c:pt idx="114">
                  <c:v>24</c:v>
                </c:pt>
                <c:pt idx="115">
                  <c:v>24</c:v>
                </c:pt>
                <c:pt idx="116">
                  <c:v>24.9</c:v>
                </c:pt>
                <c:pt idx="117">
                  <c:v>21.6</c:v>
                </c:pt>
                <c:pt idx="118">
                  <c:v>20.9</c:v>
                </c:pt>
                <c:pt idx="119">
                  <c:v>22.9</c:v>
                </c:pt>
                <c:pt idx="120">
                  <c:v>24.3</c:v>
                </c:pt>
                <c:pt idx="121">
                  <c:v>23.8</c:v>
                </c:pt>
                <c:pt idx="122">
                  <c:v>20.3</c:v>
                </c:pt>
                <c:pt idx="123">
                  <c:v>20.6</c:v>
                </c:pt>
                <c:pt idx="124">
                  <c:v>21.6</c:v>
                </c:pt>
                <c:pt idx="125">
                  <c:v>22</c:v>
                </c:pt>
                <c:pt idx="126">
                  <c:v>21.6</c:v>
                </c:pt>
                <c:pt idx="127">
                  <c:v>21.3</c:v>
                </c:pt>
                <c:pt idx="128">
                  <c:v>23.1</c:v>
                </c:pt>
                <c:pt idx="129">
                  <c:v>23.2</c:v>
                </c:pt>
                <c:pt idx="130">
                  <c:v>23.6</c:v>
                </c:pt>
                <c:pt idx="131">
                  <c:v>23.2</c:v>
                </c:pt>
                <c:pt idx="132">
                  <c:v>21.2</c:v>
                </c:pt>
                <c:pt idx="133">
                  <c:v>23.4</c:v>
                </c:pt>
                <c:pt idx="134">
                  <c:v>23.4</c:v>
                </c:pt>
                <c:pt idx="135">
                  <c:v>25</c:v>
                </c:pt>
                <c:pt idx="136">
                  <c:v>25.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F67D-4FC6-97EF-1746521E7E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2748432"/>
        <c:axId val="456012416"/>
      </c:lineChart>
      <c:catAx>
        <c:axId val="4560108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456012024"/>
        <c:crosses val="autoZero"/>
        <c:auto val="1"/>
        <c:lblAlgn val="ctr"/>
        <c:lblOffset val="100"/>
        <c:noMultiLvlLbl val="0"/>
      </c:catAx>
      <c:valAx>
        <c:axId val="45601202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in</a:t>
                </a:r>
                <a:r>
                  <a:rPr lang="en-US" sz="1100" b="0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all</a:t>
                </a:r>
                <a:endParaRPr lang="en-US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456010848"/>
        <c:crosses val="autoZero"/>
        <c:crossBetween val="between"/>
      </c:valAx>
      <c:valAx>
        <c:axId val="45601241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crossAx val="352748432"/>
        <c:crosses val="max"/>
        <c:crossBetween val="between"/>
      </c:valAx>
      <c:catAx>
        <c:axId val="3527484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456012416"/>
        <c:crosses val="autoZero"/>
        <c:auto val="1"/>
        <c:lblAlgn val="ctr"/>
        <c:lblOffset val="100"/>
        <c:noMultiLvlLbl val="0"/>
      </c:catAx>
    </c:plotArea>
    <c:legend>
      <c:legendPos val="r"/>
      <c:layout>
        <c:manualLayout>
          <c:xMode val="edge"/>
          <c:yMode val="edge"/>
          <c:x val="0.88030609955806804"/>
          <c:y val="8.4874264027807331E-2"/>
          <c:w val="0.10402438477241625"/>
          <c:h val="0.16290912960204298"/>
        </c:manualLayout>
      </c:layout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4586535657401799"/>
          <c:y val="0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env2'!$C$1</c:f>
              <c:strCache>
                <c:ptCount val="1"/>
                <c:pt idx="0">
                  <c:v>Rain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none"/>
          </c:marker>
          <c:cat>
            <c:multiLvlStrRef>
              <c:f>'env2'!$A$2:$B$178</c:f>
              <c:multiLvlStrCache>
                <c:ptCount val="177"/>
                <c:lvl>
                  <c:pt idx="0">
                    <c:v>11/5/2013</c:v>
                  </c:pt>
                  <c:pt idx="1">
                    <c:v>11/6/2013</c:v>
                  </c:pt>
                  <c:pt idx="2">
                    <c:v>11/7/2013</c:v>
                  </c:pt>
                  <c:pt idx="3">
                    <c:v>11/8/2013</c:v>
                  </c:pt>
                  <c:pt idx="4">
                    <c:v>11/9/2013</c:v>
                  </c:pt>
                  <c:pt idx="5">
                    <c:v>11/10/2013</c:v>
                  </c:pt>
                  <c:pt idx="6">
                    <c:v>11/11/2013</c:v>
                  </c:pt>
                  <c:pt idx="7">
                    <c:v>11/12/2013</c:v>
                  </c:pt>
                  <c:pt idx="8">
                    <c:v>11/13/2013</c:v>
                  </c:pt>
                  <c:pt idx="9">
                    <c:v>11/14/2013</c:v>
                  </c:pt>
                  <c:pt idx="10">
                    <c:v>11/15/2013</c:v>
                  </c:pt>
                  <c:pt idx="11">
                    <c:v>11/16/2013</c:v>
                  </c:pt>
                  <c:pt idx="12">
                    <c:v>11/17/2013</c:v>
                  </c:pt>
                  <c:pt idx="13">
                    <c:v>11/18/2013</c:v>
                  </c:pt>
                  <c:pt idx="14">
                    <c:v>11/19/2013</c:v>
                  </c:pt>
                  <c:pt idx="15">
                    <c:v>11/20/2013</c:v>
                  </c:pt>
                  <c:pt idx="16">
                    <c:v>11/21/2013</c:v>
                  </c:pt>
                  <c:pt idx="17">
                    <c:v>11/22/2013</c:v>
                  </c:pt>
                  <c:pt idx="18">
                    <c:v>11/23/2013</c:v>
                  </c:pt>
                  <c:pt idx="19">
                    <c:v>11/24/2013</c:v>
                  </c:pt>
                  <c:pt idx="20">
                    <c:v>11/25/2013</c:v>
                  </c:pt>
                  <c:pt idx="21">
                    <c:v>11/26/2013</c:v>
                  </c:pt>
                  <c:pt idx="22">
                    <c:v>11/27/2013</c:v>
                  </c:pt>
                  <c:pt idx="23">
                    <c:v>11/28/2013</c:v>
                  </c:pt>
                  <c:pt idx="24">
                    <c:v>11/29/2013</c:v>
                  </c:pt>
                  <c:pt idx="25">
                    <c:v>11/30/2013</c:v>
                  </c:pt>
                  <c:pt idx="26">
                    <c:v>12/1/2013</c:v>
                  </c:pt>
                  <c:pt idx="27">
                    <c:v>12/2/2013</c:v>
                  </c:pt>
                  <c:pt idx="28">
                    <c:v>12/3/2013</c:v>
                  </c:pt>
                  <c:pt idx="29">
                    <c:v>12/4/2013</c:v>
                  </c:pt>
                  <c:pt idx="30">
                    <c:v>12/5/2013</c:v>
                  </c:pt>
                  <c:pt idx="31">
                    <c:v>12/6/2013</c:v>
                  </c:pt>
                  <c:pt idx="32">
                    <c:v>12/7/2013</c:v>
                  </c:pt>
                  <c:pt idx="33">
                    <c:v>12/8/2013</c:v>
                  </c:pt>
                  <c:pt idx="34">
                    <c:v>12/9/2013</c:v>
                  </c:pt>
                  <c:pt idx="35">
                    <c:v>12/10/2013</c:v>
                  </c:pt>
                  <c:pt idx="36">
                    <c:v>12/11/2013</c:v>
                  </c:pt>
                  <c:pt idx="37">
                    <c:v>12/12/2013</c:v>
                  </c:pt>
                  <c:pt idx="38">
                    <c:v>12/13/2013</c:v>
                  </c:pt>
                  <c:pt idx="39">
                    <c:v>12/14/2013</c:v>
                  </c:pt>
                  <c:pt idx="40">
                    <c:v>12/15/2013</c:v>
                  </c:pt>
                  <c:pt idx="41">
                    <c:v>12/16/2013</c:v>
                  </c:pt>
                  <c:pt idx="42">
                    <c:v>12/17/2013</c:v>
                  </c:pt>
                  <c:pt idx="43">
                    <c:v>12/18/2013</c:v>
                  </c:pt>
                  <c:pt idx="44">
                    <c:v>12/19/2013</c:v>
                  </c:pt>
                  <c:pt idx="45">
                    <c:v>12/20/2013</c:v>
                  </c:pt>
                  <c:pt idx="46">
                    <c:v>12/21/2013</c:v>
                  </c:pt>
                  <c:pt idx="47">
                    <c:v>12/22/2013</c:v>
                  </c:pt>
                  <c:pt idx="48">
                    <c:v>12/23/2013</c:v>
                  </c:pt>
                  <c:pt idx="49">
                    <c:v>12/24/2013</c:v>
                  </c:pt>
                  <c:pt idx="50">
                    <c:v>12/25/2013</c:v>
                  </c:pt>
                  <c:pt idx="51">
                    <c:v>12/26/2013</c:v>
                  </c:pt>
                  <c:pt idx="52">
                    <c:v>12/27/2013</c:v>
                  </c:pt>
                  <c:pt idx="53">
                    <c:v>12/28/2013</c:v>
                  </c:pt>
                  <c:pt idx="54">
                    <c:v>12/29/2013</c:v>
                  </c:pt>
                  <c:pt idx="55">
                    <c:v>12/30/2013</c:v>
                  </c:pt>
                  <c:pt idx="56">
                    <c:v>12/31/2013</c:v>
                  </c:pt>
                  <c:pt idx="57">
                    <c:v>1/1/2014</c:v>
                  </c:pt>
                  <c:pt idx="58">
                    <c:v>1/2/2014</c:v>
                  </c:pt>
                  <c:pt idx="59">
                    <c:v>1/3/2014</c:v>
                  </c:pt>
                  <c:pt idx="60">
                    <c:v>1/4/2014</c:v>
                  </c:pt>
                  <c:pt idx="61">
                    <c:v>1/5/2014</c:v>
                  </c:pt>
                  <c:pt idx="62">
                    <c:v>1/6/2014</c:v>
                  </c:pt>
                  <c:pt idx="63">
                    <c:v>1/7/2014</c:v>
                  </c:pt>
                  <c:pt idx="64">
                    <c:v>1/8/2014</c:v>
                  </c:pt>
                  <c:pt idx="65">
                    <c:v>1/9/2014</c:v>
                  </c:pt>
                  <c:pt idx="66">
                    <c:v>1/10/2014</c:v>
                  </c:pt>
                  <c:pt idx="67">
                    <c:v>1/11/2014</c:v>
                  </c:pt>
                  <c:pt idx="68">
                    <c:v>1/12/2014</c:v>
                  </c:pt>
                  <c:pt idx="69">
                    <c:v>1/13/2014</c:v>
                  </c:pt>
                  <c:pt idx="70">
                    <c:v>1/14/2014</c:v>
                  </c:pt>
                  <c:pt idx="71">
                    <c:v>1/15/2014</c:v>
                  </c:pt>
                  <c:pt idx="72">
                    <c:v>1/16/2014</c:v>
                  </c:pt>
                  <c:pt idx="73">
                    <c:v>1/17/2014</c:v>
                  </c:pt>
                  <c:pt idx="74">
                    <c:v>1/18/2014</c:v>
                  </c:pt>
                  <c:pt idx="75">
                    <c:v>1/19/2014</c:v>
                  </c:pt>
                  <c:pt idx="76">
                    <c:v>1/20/2014</c:v>
                  </c:pt>
                  <c:pt idx="77">
                    <c:v>1/21/2014</c:v>
                  </c:pt>
                  <c:pt idx="78">
                    <c:v>1/22/2014</c:v>
                  </c:pt>
                  <c:pt idx="79">
                    <c:v>1/23/2014</c:v>
                  </c:pt>
                  <c:pt idx="80">
                    <c:v>1/24/2014</c:v>
                  </c:pt>
                  <c:pt idx="81">
                    <c:v>1/25/2014</c:v>
                  </c:pt>
                  <c:pt idx="82">
                    <c:v>1/26/2014</c:v>
                  </c:pt>
                  <c:pt idx="83">
                    <c:v>1/27/2014</c:v>
                  </c:pt>
                  <c:pt idx="84">
                    <c:v>1/28/2014</c:v>
                  </c:pt>
                  <c:pt idx="85">
                    <c:v>1/29/2014</c:v>
                  </c:pt>
                  <c:pt idx="86">
                    <c:v>1/30/2014</c:v>
                  </c:pt>
                  <c:pt idx="87">
                    <c:v>1/31/2014</c:v>
                  </c:pt>
                  <c:pt idx="88">
                    <c:v>2/1/2014</c:v>
                  </c:pt>
                  <c:pt idx="89">
                    <c:v>2/2/2014</c:v>
                  </c:pt>
                  <c:pt idx="90">
                    <c:v>2/3/2014</c:v>
                  </c:pt>
                  <c:pt idx="91">
                    <c:v>2/4/2014</c:v>
                  </c:pt>
                  <c:pt idx="92">
                    <c:v>2/5/2014</c:v>
                  </c:pt>
                  <c:pt idx="93">
                    <c:v>2/6/2014</c:v>
                  </c:pt>
                  <c:pt idx="94">
                    <c:v>2/7/2014</c:v>
                  </c:pt>
                  <c:pt idx="95">
                    <c:v>2/8/2014</c:v>
                  </c:pt>
                  <c:pt idx="96">
                    <c:v>2/9/2014</c:v>
                  </c:pt>
                  <c:pt idx="97">
                    <c:v>2/10/2014</c:v>
                  </c:pt>
                  <c:pt idx="98">
                    <c:v>2/11/2014</c:v>
                  </c:pt>
                  <c:pt idx="99">
                    <c:v>2/12/2014</c:v>
                  </c:pt>
                  <c:pt idx="100">
                    <c:v>2/13/2014</c:v>
                  </c:pt>
                  <c:pt idx="101">
                    <c:v>2/14/2014</c:v>
                  </c:pt>
                  <c:pt idx="102">
                    <c:v>2/15/2014</c:v>
                  </c:pt>
                  <c:pt idx="103">
                    <c:v>2/16/2014</c:v>
                  </c:pt>
                  <c:pt idx="104">
                    <c:v>2/17/2014</c:v>
                  </c:pt>
                  <c:pt idx="105">
                    <c:v>2/18/2014</c:v>
                  </c:pt>
                  <c:pt idx="106">
                    <c:v>2/19/2014</c:v>
                  </c:pt>
                  <c:pt idx="107">
                    <c:v>2/20/2014</c:v>
                  </c:pt>
                  <c:pt idx="108">
                    <c:v>2/21/2014</c:v>
                  </c:pt>
                  <c:pt idx="109">
                    <c:v>2/22/2014</c:v>
                  </c:pt>
                  <c:pt idx="110">
                    <c:v>2/23/2014</c:v>
                  </c:pt>
                  <c:pt idx="111">
                    <c:v>2/24/2014</c:v>
                  </c:pt>
                  <c:pt idx="112">
                    <c:v>2/25/2014</c:v>
                  </c:pt>
                  <c:pt idx="113">
                    <c:v>2/26/2014</c:v>
                  </c:pt>
                  <c:pt idx="114">
                    <c:v>2/27/2014</c:v>
                  </c:pt>
                  <c:pt idx="115">
                    <c:v>2/28/2014</c:v>
                  </c:pt>
                  <c:pt idx="116">
                    <c:v>3/1/2014</c:v>
                  </c:pt>
                  <c:pt idx="117">
                    <c:v>3/2/2014</c:v>
                  </c:pt>
                  <c:pt idx="118">
                    <c:v>3/3/2014</c:v>
                  </c:pt>
                  <c:pt idx="119">
                    <c:v>3/4/2014</c:v>
                  </c:pt>
                  <c:pt idx="120">
                    <c:v>3/5/2014</c:v>
                  </c:pt>
                  <c:pt idx="121">
                    <c:v>3/6/2014</c:v>
                  </c:pt>
                  <c:pt idx="122">
                    <c:v>3/7/2014</c:v>
                  </c:pt>
                  <c:pt idx="123">
                    <c:v>3/8/2014</c:v>
                  </c:pt>
                  <c:pt idx="124">
                    <c:v>3/9/2014</c:v>
                  </c:pt>
                  <c:pt idx="125">
                    <c:v>3/10/2014</c:v>
                  </c:pt>
                  <c:pt idx="126">
                    <c:v>3/11/2014</c:v>
                  </c:pt>
                  <c:pt idx="127">
                    <c:v>3/12/2014</c:v>
                  </c:pt>
                  <c:pt idx="128">
                    <c:v>3/13/2014</c:v>
                  </c:pt>
                  <c:pt idx="129">
                    <c:v>3/14/2014</c:v>
                  </c:pt>
                  <c:pt idx="130">
                    <c:v>3/15/2014</c:v>
                  </c:pt>
                  <c:pt idx="131">
                    <c:v>3/16/2014</c:v>
                  </c:pt>
                  <c:pt idx="132">
                    <c:v>3/17/2014</c:v>
                  </c:pt>
                  <c:pt idx="133">
                    <c:v>3/18/2014</c:v>
                  </c:pt>
                  <c:pt idx="134">
                    <c:v>3/19/2014</c:v>
                  </c:pt>
                  <c:pt idx="135">
                    <c:v>3/20/2014</c:v>
                  </c:pt>
                  <c:pt idx="136">
                    <c:v>3/21/2014</c:v>
                  </c:pt>
                  <c:pt idx="137">
                    <c:v>3/22/2014</c:v>
                  </c:pt>
                  <c:pt idx="138">
                    <c:v>3/23/2014</c:v>
                  </c:pt>
                  <c:pt idx="139">
                    <c:v>3/24/2014</c:v>
                  </c:pt>
                  <c:pt idx="140">
                    <c:v>3/25/2014</c:v>
                  </c:pt>
                  <c:pt idx="141">
                    <c:v>3/26/2014</c:v>
                  </c:pt>
                  <c:pt idx="142">
                    <c:v>3/27/2014</c:v>
                  </c:pt>
                  <c:pt idx="143">
                    <c:v>3/28/2014</c:v>
                  </c:pt>
                  <c:pt idx="144">
                    <c:v>3/29/2014</c:v>
                  </c:pt>
                  <c:pt idx="145">
                    <c:v>3/30/2014</c:v>
                  </c:pt>
                  <c:pt idx="146">
                    <c:v>3/31/2014</c:v>
                  </c:pt>
                  <c:pt idx="147">
                    <c:v>4/1/2014</c:v>
                  </c:pt>
                  <c:pt idx="148">
                    <c:v>4/2/2014</c:v>
                  </c:pt>
                  <c:pt idx="149">
                    <c:v>4/3/2014</c:v>
                  </c:pt>
                  <c:pt idx="150">
                    <c:v>4/4/2014</c:v>
                  </c:pt>
                  <c:pt idx="151">
                    <c:v>4/5/2014</c:v>
                  </c:pt>
                  <c:pt idx="152">
                    <c:v>4/6/2014</c:v>
                  </c:pt>
                  <c:pt idx="153">
                    <c:v>4/7/2014</c:v>
                  </c:pt>
                  <c:pt idx="154">
                    <c:v>4/8/2014</c:v>
                  </c:pt>
                  <c:pt idx="155">
                    <c:v>4/9/2014</c:v>
                  </c:pt>
                  <c:pt idx="156">
                    <c:v>4/10/2014</c:v>
                  </c:pt>
                  <c:pt idx="157">
                    <c:v>4/11/2014</c:v>
                  </c:pt>
                  <c:pt idx="158">
                    <c:v>4/12/2014</c:v>
                  </c:pt>
                  <c:pt idx="159">
                    <c:v>4/13/2014</c:v>
                  </c:pt>
                  <c:pt idx="160">
                    <c:v>4/14/2014</c:v>
                  </c:pt>
                  <c:pt idx="161">
                    <c:v>4/15/2014</c:v>
                  </c:pt>
                  <c:pt idx="162">
                    <c:v>4/16/2014</c:v>
                  </c:pt>
                  <c:pt idx="163">
                    <c:v>4/17/2014</c:v>
                  </c:pt>
                  <c:pt idx="164">
                    <c:v>4/18/2014</c:v>
                  </c:pt>
                  <c:pt idx="165">
                    <c:v>4/19/2014</c:v>
                  </c:pt>
                  <c:pt idx="166">
                    <c:v>4/20/2014</c:v>
                  </c:pt>
                  <c:pt idx="167">
                    <c:v>4/21/2014</c:v>
                  </c:pt>
                  <c:pt idx="168">
                    <c:v>4/22/2014</c:v>
                  </c:pt>
                  <c:pt idx="169">
                    <c:v>4/23/2014</c:v>
                  </c:pt>
                  <c:pt idx="170">
                    <c:v>4/24/2014</c:v>
                  </c:pt>
                  <c:pt idx="171">
                    <c:v>4/25/2014</c:v>
                  </c:pt>
                  <c:pt idx="172">
                    <c:v>4/26/2014</c:v>
                  </c:pt>
                  <c:pt idx="173">
                    <c:v>4/27/2014</c:v>
                  </c:pt>
                  <c:pt idx="174">
                    <c:v>4/28/2014</c:v>
                  </c:pt>
                  <c:pt idx="175">
                    <c:v>4/29/2014</c:v>
                  </c:pt>
                  <c:pt idx="176">
                    <c:v>4/30/2014</c:v>
                  </c:pt>
                </c:lvl>
                <c:lvl>
                  <c:pt idx="15">
                    <c:v>DOS</c:v>
                  </c:pt>
                  <c:pt idx="101">
                    <c:v>%GL7</c:v>
                  </c:pt>
                  <c:pt idx="108">
                    <c:v>%GL14</c:v>
                  </c:pt>
                  <c:pt idx="115">
                    <c:v>%GL21</c:v>
                  </c:pt>
                  <c:pt idx="134">
                    <c:v>%GL28</c:v>
                  </c:pt>
                  <c:pt idx="141">
                    <c:v>%GL35</c:v>
                  </c:pt>
                  <c:pt idx="148">
                    <c:v>%GL42</c:v>
                  </c:pt>
                  <c:pt idx="155">
                    <c:v>%GL49</c:v>
                  </c:pt>
                </c:lvl>
              </c:multiLvlStrCache>
            </c:multiLvlStrRef>
          </c:cat>
          <c:val>
            <c:numRef>
              <c:f>'env2'!$C$2:$C$178</c:f>
              <c:numCache>
                <c:formatCode>General</c:formatCode>
                <c:ptCount val="17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18.7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3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6.4</c:v>
                </c:pt>
                <c:pt idx="121">
                  <c:v>0</c:v>
                </c:pt>
                <c:pt idx="122">
                  <c:v>0.4</c:v>
                </c:pt>
                <c:pt idx="123">
                  <c:v>3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42.4</c:v>
                </c:pt>
                <c:pt idx="162">
                  <c:v>0</c:v>
                </c:pt>
                <c:pt idx="163">
                  <c:v>0.2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42.8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747-494E-8B86-A589F440B1D4}"/>
            </c:ext>
          </c:extLst>
        </c:ser>
        <c:ser>
          <c:idx val="1"/>
          <c:order val="1"/>
          <c:tx>
            <c:strRef>
              <c:f>'env2'!$D$1</c:f>
              <c:strCache>
                <c:ptCount val="1"/>
                <c:pt idx="0">
                  <c:v>Evap</c:v>
                </c:pt>
              </c:strCache>
            </c:strRef>
          </c:tx>
          <c:spPr>
            <a:ln w="38100"/>
          </c:spPr>
          <c:marker>
            <c:symbol val="none"/>
          </c:marker>
          <c:cat>
            <c:multiLvlStrRef>
              <c:f>'env2'!$A$2:$B$178</c:f>
              <c:multiLvlStrCache>
                <c:ptCount val="177"/>
                <c:lvl>
                  <c:pt idx="0">
                    <c:v>11/5/2013</c:v>
                  </c:pt>
                  <c:pt idx="1">
                    <c:v>11/6/2013</c:v>
                  </c:pt>
                  <c:pt idx="2">
                    <c:v>11/7/2013</c:v>
                  </c:pt>
                  <c:pt idx="3">
                    <c:v>11/8/2013</c:v>
                  </c:pt>
                  <c:pt idx="4">
                    <c:v>11/9/2013</c:v>
                  </c:pt>
                  <c:pt idx="5">
                    <c:v>11/10/2013</c:v>
                  </c:pt>
                  <c:pt idx="6">
                    <c:v>11/11/2013</c:v>
                  </c:pt>
                  <c:pt idx="7">
                    <c:v>11/12/2013</c:v>
                  </c:pt>
                  <c:pt idx="8">
                    <c:v>11/13/2013</c:v>
                  </c:pt>
                  <c:pt idx="9">
                    <c:v>11/14/2013</c:v>
                  </c:pt>
                  <c:pt idx="10">
                    <c:v>11/15/2013</c:v>
                  </c:pt>
                  <c:pt idx="11">
                    <c:v>11/16/2013</c:v>
                  </c:pt>
                  <c:pt idx="12">
                    <c:v>11/17/2013</c:v>
                  </c:pt>
                  <c:pt idx="13">
                    <c:v>11/18/2013</c:v>
                  </c:pt>
                  <c:pt idx="14">
                    <c:v>11/19/2013</c:v>
                  </c:pt>
                  <c:pt idx="15">
                    <c:v>11/20/2013</c:v>
                  </c:pt>
                  <c:pt idx="16">
                    <c:v>11/21/2013</c:v>
                  </c:pt>
                  <c:pt idx="17">
                    <c:v>11/22/2013</c:v>
                  </c:pt>
                  <c:pt idx="18">
                    <c:v>11/23/2013</c:v>
                  </c:pt>
                  <c:pt idx="19">
                    <c:v>11/24/2013</c:v>
                  </c:pt>
                  <c:pt idx="20">
                    <c:v>11/25/2013</c:v>
                  </c:pt>
                  <c:pt idx="21">
                    <c:v>11/26/2013</c:v>
                  </c:pt>
                  <c:pt idx="22">
                    <c:v>11/27/2013</c:v>
                  </c:pt>
                  <c:pt idx="23">
                    <c:v>11/28/2013</c:v>
                  </c:pt>
                  <c:pt idx="24">
                    <c:v>11/29/2013</c:v>
                  </c:pt>
                  <c:pt idx="25">
                    <c:v>11/30/2013</c:v>
                  </c:pt>
                  <c:pt idx="26">
                    <c:v>12/1/2013</c:v>
                  </c:pt>
                  <c:pt idx="27">
                    <c:v>12/2/2013</c:v>
                  </c:pt>
                  <c:pt idx="28">
                    <c:v>12/3/2013</c:v>
                  </c:pt>
                  <c:pt idx="29">
                    <c:v>12/4/2013</c:v>
                  </c:pt>
                  <c:pt idx="30">
                    <c:v>12/5/2013</c:v>
                  </c:pt>
                  <c:pt idx="31">
                    <c:v>12/6/2013</c:v>
                  </c:pt>
                  <c:pt idx="32">
                    <c:v>12/7/2013</c:v>
                  </c:pt>
                  <c:pt idx="33">
                    <c:v>12/8/2013</c:v>
                  </c:pt>
                  <c:pt idx="34">
                    <c:v>12/9/2013</c:v>
                  </c:pt>
                  <c:pt idx="35">
                    <c:v>12/10/2013</c:v>
                  </c:pt>
                  <c:pt idx="36">
                    <c:v>12/11/2013</c:v>
                  </c:pt>
                  <c:pt idx="37">
                    <c:v>12/12/2013</c:v>
                  </c:pt>
                  <c:pt idx="38">
                    <c:v>12/13/2013</c:v>
                  </c:pt>
                  <c:pt idx="39">
                    <c:v>12/14/2013</c:v>
                  </c:pt>
                  <c:pt idx="40">
                    <c:v>12/15/2013</c:v>
                  </c:pt>
                  <c:pt idx="41">
                    <c:v>12/16/2013</c:v>
                  </c:pt>
                  <c:pt idx="42">
                    <c:v>12/17/2013</c:v>
                  </c:pt>
                  <c:pt idx="43">
                    <c:v>12/18/2013</c:v>
                  </c:pt>
                  <c:pt idx="44">
                    <c:v>12/19/2013</c:v>
                  </c:pt>
                  <c:pt idx="45">
                    <c:v>12/20/2013</c:v>
                  </c:pt>
                  <c:pt idx="46">
                    <c:v>12/21/2013</c:v>
                  </c:pt>
                  <c:pt idx="47">
                    <c:v>12/22/2013</c:v>
                  </c:pt>
                  <c:pt idx="48">
                    <c:v>12/23/2013</c:v>
                  </c:pt>
                  <c:pt idx="49">
                    <c:v>12/24/2013</c:v>
                  </c:pt>
                  <c:pt idx="50">
                    <c:v>12/25/2013</c:v>
                  </c:pt>
                  <c:pt idx="51">
                    <c:v>12/26/2013</c:v>
                  </c:pt>
                  <c:pt idx="52">
                    <c:v>12/27/2013</c:v>
                  </c:pt>
                  <c:pt idx="53">
                    <c:v>12/28/2013</c:v>
                  </c:pt>
                  <c:pt idx="54">
                    <c:v>12/29/2013</c:v>
                  </c:pt>
                  <c:pt idx="55">
                    <c:v>12/30/2013</c:v>
                  </c:pt>
                  <c:pt idx="56">
                    <c:v>12/31/2013</c:v>
                  </c:pt>
                  <c:pt idx="57">
                    <c:v>1/1/2014</c:v>
                  </c:pt>
                  <c:pt idx="58">
                    <c:v>1/2/2014</c:v>
                  </c:pt>
                  <c:pt idx="59">
                    <c:v>1/3/2014</c:v>
                  </c:pt>
                  <c:pt idx="60">
                    <c:v>1/4/2014</c:v>
                  </c:pt>
                  <c:pt idx="61">
                    <c:v>1/5/2014</c:v>
                  </c:pt>
                  <c:pt idx="62">
                    <c:v>1/6/2014</c:v>
                  </c:pt>
                  <c:pt idx="63">
                    <c:v>1/7/2014</c:v>
                  </c:pt>
                  <c:pt idx="64">
                    <c:v>1/8/2014</c:v>
                  </c:pt>
                  <c:pt idx="65">
                    <c:v>1/9/2014</c:v>
                  </c:pt>
                  <c:pt idx="66">
                    <c:v>1/10/2014</c:v>
                  </c:pt>
                  <c:pt idx="67">
                    <c:v>1/11/2014</c:v>
                  </c:pt>
                  <c:pt idx="68">
                    <c:v>1/12/2014</c:v>
                  </c:pt>
                  <c:pt idx="69">
                    <c:v>1/13/2014</c:v>
                  </c:pt>
                  <c:pt idx="70">
                    <c:v>1/14/2014</c:v>
                  </c:pt>
                  <c:pt idx="71">
                    <c:v>1/15/2014</c:v>
                  </c:pt>
                  <c:pt idx="72">
                    <c:v>1/16/2014</c:v>
                  </c:pt>
                  <c:pt idx="73">
                    <c:v>1/17/2014</c:v>
                  </c:pt>
                  <c:pt idx="74">
                    <c:v>1/18/2014</c:v>
                  </c:pt>
                  <c:pt idx="75">
                    <c:v>1/19/2014</c:v>
                  </c:pt>
                  <c:pt idx="76">
                    <c:v>1/20/2014</c:v>
                  </c:pt>
                  <c:pt idx="77">
                    <c:v>1/21/2014</c:v>
                  </c:pt>
                  <c:pt idx="78">
                    <c:v>1/22/2014</c:v>
                  </c:pt>
                  <c:pt idx="79">
                    <c:v>1/23/2014</c:v>
                  </c:pt>
                  <c:pt idx="80">
                    <c:v>1/24/2014</c:v>
                  </c:pt>
                  <c:pt idx="81">
                    <c:v>1/25/2014</c:v>
                  </c:pt>
                  <c:pt idx="82">
                    <c:v>1/26/2014</c:v>
                  </c:pt>
                  <c:pt idx="83">
                    <c:v>1/27/2014</c:v>
                  </c:pt>
                  <c:pt idx="84">
                    <c:v>1/28/2014</c:v>
                  </c:pt>
                  <c:pt idx="85">
                    <c:v>1/29/2014</c:v>
                  </c:pt>
                  <c:pt idx="86">
                    <c:v>1/30/2014</c:v>
                  </c:pt>
                  <c:pt idx="87">
                    <c:v>1/31/2014</c:v>
                  </c:pt>
                  <c:pt idx="88">
                    <c:v>2/1/2014</c:v>
                  </c:pt>
                  <c:pt idx="89">
                    <c:v>2/2/2014</c:v>
                  </c:pt>
                  <c:pt idx="90">
                    <c:v>2/3/2014</c:v>
                  </c:pt>
                  <c:pt idx="91">
                    <c:v>2/4/2014</c:v>
                  </c:pt>
                  <c:pt idx="92">
                    <c:v>2/5/2014</c:v>
                  </c:pt>
                  <c:pt idx="93">
                    <c:v>2/6/2014</c:v>
                  </c:pt>
                  <c:pt idx="94">
                    <c:v>2/7/2014</c:v>
                  </c:pt>
                  <c:pt idx="95">
                    <c:v>2/8/2014</c:v>
                  </c:pt>
                  <c:pt idx="96">
                    <c:v>2/9/2014</c:v>
                  </c:pt>
                  <c:pt idx="97">
                    <c:v>2/10/2014</c:v>
                  </c:pt>
                  <c:pt idx="98">
                    <c:v>2/11/2014</c:v>
                  </c:pt>
                  <c:pt idx="99">
                    <c:v>2/12/2014</c:v>
                  </c:pt>
                  <c:pt idx="100">
                    <c:v>2/13/2014</c:v>
                  </c:pt>
                  <c:pt idx="101">
                    <c:v>2/14/2014</c:v>
                  </c:pt>
                  <c:pt idx="102">
                    <c:v>2/15/2014</c:v>
                  </c:pt>
                  <c:pt idx="103">
                    <c:v>2/16/2014</c:v>
                  </c:pt>
                  <c:pt idx="104">
                    <c:v>2/17/2014</c:v>
                  </c:pt>
                  <c:pt idx="105">
                    <c:v>2/18/2014</c:v>
                  </c:pt>
                  <c:pt idx="106">
                    <c:v>2/19/2014</c:v>
                  </c:pt>
                  <c:pt idx="107">
                    <c:v>2/20/2014</c:v>
                  </c:pt>
                  <c:pt idx="108">
                    <c:v>2/21/2014</c:v>
                  </c:pt>
                  <c:pt idx="109">
                    <c:v>2/22/2014</c:v>
                  </c:pt>
                  <c:pt idx="110">
                    <c:v>2/23/2014</c:v>
                  </c:pt>
                  <c:pt idx="111">
                    <c:v>2/24/2014</c:v>
                  </c:pt>
                  <c:pt idx="112">
                    <c:v>2/25/2014</c:v>
                  </c:pt>
                  <c:pt idx="113">
                    <c:v>2/26/2014</c:v>
                  </c:pt>
                  <c:pt idx="114">
                    <c:v>2/27/2014</c:v>
                  </c:pt>
                  <c:pt idx="115">
                    <c:v>2/28/2014</c:v>
                  </c:pt>
                  <c:pt idx="116">
                    <c:v>3/1/2014</c:v>
                  </c:pt>
                  <c:pt idx="117">
                    <c:v>3/2/2014</c:v>
                  </c:pt>
                  <c:pt idx="118">
                    <c:v>3/3/2014</c:v>
                  </c:pt>
                  <c:pt idx="119">
                    <c:v>3/4/2014</c:v>
                  </c:pt>
                  <c:pt idx="120">
                    <c:v>3/5/2014</c:v>
                  </c:pt>
                  <c:pt idx="121">
                    <c:v>3/6/2014</c:v>
                  </c:pt>
                  <c:pt idx="122">
                    <c:v>3/7/2014</c:v>
                  </c:pt>
                  <c:pt idx="123">
                    <c:v>3/8/2014</c:v>
                  </c:pt>
                  <c:pt idx="124">
                    <c:v>3/9/2014</c:v>
                  </c:pt>
                  <c:pt idx="125">
                    <c:v>3/10/2014</c:v>
                  </c:pt>
                  <c:pt idx="126">
                    <c:v>3/11/2014</c:v>
                  </c:pt>
                  <c:pt idx="127">
                    <c:v>3/12/2014</c:v>
                  </c:pt>
                  <c:pt idx="128">
                    <c:v>3/13/2014</c:v>
                  </c:pt>
                  <c:pt idx="129">
                    <c:v>3/14/2014</c:v>
                  </c:pt>
                  <c:pt idx="130">
                    <c:v>3/15/2014</c:v>
                  </c:pt>
                  <c:pt idx="131">
                    <c:v>3/16/2014</c:v>
                  </c:pt>
                  <c:pt idx="132">
                    <c:v>3/17/2014</c:v>
                  </c:pt>
                  <c:pt idx="133">
                    <c:v>3/18/2014</c:v>
                  </c:pt>
                  <c:pt idx="134">
                    <c:v>3/19/2014</c:v>
                  </c:pt>
                  <c:pt idx="135">
                    <c:v>3/20/2014</c:v>
                  </c:pt>
                  <c:pt idx="136">
                    <c:v>3/21/2014</c:v>
                  </c:pt>
                  <c:pt idx="137">
                    <c:v>3/22/2014</c:v>
                  </c:pt>
                  <c:pt idx="138">
                    <c:v>3/23/2014</c:v>
                  </c:pt>
                  <c:pt idx="139">
                    <c:v>3/24/2014</c:v>
                  </c:pt>
                  <c:pt idx="140">
                    <c:v>3/25/2014</c:v>
                  </c:pt>
                  <c:pt idx="141">
                    <c:v>3/26/2014</c:v>
                  </c:pt>
                  <c:pt idx="142">
                    <c:v>3/27/2014</c:v>
                  </c:pt>
                  <c:pt idx="143">
                    <c:v>3/28/2014</c:v>
                  </c:pt>
                  <c:pt idx="144">
                    <c:v>3/29/2014</c:v>
                  </c:pt>
                  <c:pt idx="145">
                    <c:v>3/30/2014</c:v>
                  </c:pt>
                  <c:pt idx="146">
                    <c:v>3/31/2014</c:v>
                  </c:pt>
                  <c:pt idx="147">
                    <c:v>4/1/2014</c:v>
                  </c:pt>
                  <c:pt idx="148">
                    <c:v>4/2/2014</c:v>
                  </c:pt>
                  <c:pt idx="149">
                    <c:v>4/3/2014</c:v>
                  </c:pt>
                  <c:pt idx="150">
                    <c:v>4/4/2014</c:v>
                  </c:pt>
                  <c:pt idx="151">
                    <c:v>4/5/2014</c:v>
                  </c:pt>
                  <c:pt idx="152">
                    <c:v>4/6/2014</c:v>
                  </c:pt>
                  <c:pt idx="153">
                    <c:v>4/7/2014</c:v>
                  </c:pt>
                  <c:pt idx="154">
                    <c:v>4/8/2014</c:v>
                  </c:pt>
                  <c:pt idx="155">
                    <c:v>4/9/2014</c:v>
                  </c:pt>
                  <c:pt idx="156">
                    <c:v>4/10/2014</c:v>
                  </c:pt>
                  <c:pt idx="157">
                    <c:v>4/11/2014</c:v>
                  </c:pt>
                  <c:pt idx="158">
                    <c:v>4/12/2014</c:v>
                  </c:pt>
                  <c:pt idx="159">
                    <c:v>4/13/2014</c:v>
                  </c:pt>
                  <c:pt idx="160">
                    <c:v>4/14/2014</c:v>
                  </c:pt>
                  <c:pt idx="161">
                    <c:v>4/15/2014</c:v>
                  </c:pt>
                  <c:pt idx="162">
                    <c:v>4/16/2014</c:v>
                  </c:pt>
                  <c:pt idx="163">
                    <c:v>4/17/2014</c:v>
                  </c:pt>
                  <c:pt idx="164">
                    <c:v>4/18/2014</c:v>
                  </c:pt>
                  <c:pt idx="165">
                    <c:v>4/19/2014</c:v>
                  </c:pt>
                  <c:pt idx="166">
                    <c:v>4/20/2014</c:v>
                  </c:pt>
                  <c:pt idx="167">
                    <c:v>4/21/2014</c:v>
                  </c:pt>
                  <c:pt idx="168">
                    <c:v>4/22/2014</c:v>
                  </c:pt>
                  <c:pt idx="169">
                    <c:v>4/23/2014</c:v>
                  </c:pt>
                  <c:pt idx="170">
                    <c:v>4/24/2014</c:v>
                  </c:pt>
                  <c:pt idx="171">
                    <c:v>4/25/2014</c:v>
                  </c:pt>
                  <c:pt idx="172">
                    <c:v>4/26/2014</c:v>
                  </c:pt>
                  <c:pt idx="173">
                    <c:v>4/27/2014</c:v>
                  </c:pt>
                  <c:pt idx="174">
                    <c:v>4/28/2014</c:v>
                  </c:pt>
                  <c:pt idx="175">
                    <c:v>4/29/2014</c:v>
                  </c:pt>
                  <c:pt idx="176">
                    <c:v>4/30/2014</c:v>
                  </c:pt>
                </c:lvl>
                <c:lvl>
                  <c:pt idx="15">
                    <c:v>DOS</c:v>
                  </c:pt>
                  <c:pt idx="101">
                    <c:v>%GL7</c:v>
                  </c:pt>
                  <c:pt idx="108">
                    <c:v>%GL14</c:v>
                  </c:pt>
                  <c:pt idx="115">
                    <c:v>%GL21</c:v>
                  </c:pt>
                  <c:pt idx="134">
                    <c:v>%GL28</c:v>
                  </c:pt>
                  <c:pt idx="141">
                    <c:v>%GL35</c:v>
                  </c:pt>
                  <c:pt idx="148">
                    <c:v>%GL42</c:v>
                  </c:pt>
                  <c:pt idx="155">
                    <c:v>%GL49</c:v>
                  </c:pt>
                </c:lvl>
              </c:multiLvlStrCache>
            </c:multiLvlStrRef>
          </c:cat>
          <c:val>
            <c:numRef>
              <c:f>'env2'!$D$2:$D$178</c:f>
              <c:numCache>
                <c:formatCode>General</c:formatCode>
                <c:ptCount val="177"/>
                <c:pt idx="0">
                  <c:v>3.5</c:v>
                </c:pt>
                <c:pt idx="1">
                  <c:v>3.8</c:v>
                </c:pt>
                <c:pt idx="2">
                  <c:v>3.8</c:v>
                </c:pt>
                <c:pt idx="3">
                  <c:v>3.2</c:v>
                </c:pt>
                <c:pt idx="4">
                  <c:v>3.2</c:v>
                </c:pt>
                <c:pt idx="5">
                  <c:v>2.7</c:v>
                </c:pt>
                <c:pt idx="6">
                  <c:v>3.9</c:v>
                </c:pt>
                <c:pt idx="7">
                  <c:v>4.3</c:v>
                </c:pt>
                <c:pt idx="8">
                  <c:v>4</c:v>
                </c:pt>
                <c:pt idx="9">
                  <c:v>4.2</c:v>
                </c:pt>
                <c:pt idx="10">
                  <c:v>3.9</c:v>
                </c:pt>
                <c:pt idx="11">
                  <c:v>4.7</c:v>
                </c:pt>
                <c:pt idx="12">
                  <c:v>4.5999999999999996</c:v>
                </c:pt>
                <c:pt idx="13">
                  <c:v>4.9000000000000004</c:v>
                </c:pt>
                <c:pt idx="14">
                  <c:v>3.2</c:v>
                </c:pt>
                <c:pt idx="15">
                  <c:v>4.4000000000000004</c:v>
                </c:pt>
                <c:pt idx="16">
                  <c:v>4.2</c:v>
                </c:pt>
                <c:pt idx="17">
                  <c:v>3.6</c:v>
                </c:pt>
                <c:pt idx="18">
                  <c:v>3.1</c:v>
                </c:pt>
                <c:pt idx="19">
                  <c:v>1.6</c:v>
                </c:pt>
                <c:pt idx="20">
                  <c:v>1.9</c:v>
                </c:pt>
                <c:pt idx="21">
                  <c:v>2.6</c:v>
                </c:pt>
                <c:pt idx="22">
                  <c:v>3.9</c:v>
                </c:pt>
                <c:pt idx="23">
                  <c:v>4.5999999999999996</c:v>
                </c:pt>
                <c:pt idx="24">
                  <c:v>2.2999999999999998</c:v>
                </c:pt>
                <c:pt idx="25">
                  <c:v>1.4</c:v>
                </c:pt>
                <c:pt idx="26">
                  <c:v>3.2</c:v>
                </c:pt>
                <c:pt idx="27">
                  <c:v>2.6</c:v>
                </c:pt>
                <c:pt idx="28">
                  <c:v>2.7</c:v>
                </c:pt>
                <c:pt idx="29">
                  <c:v>2.9</c:v>
                </c:pt>
                <c:pt idx="30">
                  <c:v>4.5999999999999996</c:v>
                </c:pt>
                <c:pt idx="31">
                  <c:v>4.0999999999999996</c:v>
                </c:pt>
                <c:pt idx="32">
                  <c:v>4.5</c:v>
                </c:pt>
                <c:pt idx="33">
                  <c:v>3.8</c:v>
                </c:pt>
                <c:pt idx="34">
                  <c:v>2.9</c:v>
                </c:pt>
                <c:pt idx="35">
                  <c:v>3.4</c:v>
                </c:pt>
                <c:pt idx="36">
                  <c:v>3.7</c:v>
                </c:pt>
                <c:pt idx="37">
                  <c:v>3.6</c:v>
                </c:pt>
                <c:pt idx="38">
                  <c:v>3.7</c:v>
                </c:pt>
                <c:pt idx="39">
                  <c:v>3.2</c:v>
                </c:pt>
                <c:pt idx="40">
                  <c:v>3.4</c:v>
                </c:pt>
                <c:pt idx="41">
                  <c:v>3.3</c:v>
                </c:pt>
                <c:pt idx="42">
                  <c:v>3.7</c:v>
                </c:pt>
                <c:pt idx="43">
                  <c:v>3.5</c:v>
                </c:pt>
                <c:pt idx="44">
                  <c:v>2.8</c:v>
                </c:pt>
                <c:pt idx="45">
                  <c:v>2.9</c:v>
                </c:pt>
                <c:pt idx="46">
                  <c:v>3.3</c:v>
                </c:pt>
                <c:pt idx="47">
                  <c:v>4.3</c:v>
                </c:pt>
                <c:pt idx="48">
                  <c:v>4.5</c:v>
                </c:pt>
                <c:pt idx="49">
                  <c:v>3.6</c:v>
                </c:pt>
                <c:pt idx="50">
                  <c:v>2.9</c:v>
                </c:pt>
                <c:pt idx="51">
                  <c:v>3.5</c:v>
                </c:pt>
                <c:pt idx="52">
                  <c:v>3.1</c:v>
                </c:pt>
                <c:pt idx="53">
                  <c:v>3.2</c:v>
                </c:pt>
                <c:pt idx="54">
                  <c:v>2.8</c:v>
                </c:pt>
                <c:pt idx="55">
                  <c:v>3.6</c:v>
                </c:pt>
                <c:pt idx="56">
                  <c:v>4.4000000000000004</c:v>
                </c:pt>
                <c:pt idx="57">
                  <c:v>3.9</c:v>
                </c:pt>
                <c:pt idx="58">
                  <c:v>3.7</c:v>
                </c:pt>
                <c:pt idx="59">
                  <c:v>3.5</c:v>
                </c:pt>
                <c:pt idx="60">
                  <c:v>3.5</c:v>
                </c:pt>
                <c:pt idx="61">
                  <c:v>3.1</c:v>
                </c:pt>
                <c:pt idx="62">
                  <c:v>3.2</c:v>
                </c:pt>
                <c:pt idx="63">
                  <c:v>3</c:v>
                </c:pt>
                <c:pt idx="64">
                  <c:v>4.4000000000000004</c:v>
                </c:pt>
                <c:pt idx="65">
                  <c:v>4.2</c:v>
                </c:pt>
                <c:pt idx="66">
                  <c:v>3</c:v>
                </c:pt>
                <c:pt idx="67">
                  <c:v>4.3</c:v>
                </c:pt>
                <c:pt idx="68">
                  <c:v>3.1</c:v>
                </c:pt>
                <c:pt idx="69">
                  <c:v>4.5999999999999996</c:v>
                </c:pt>
                <c:pt idx="70">
                  <c:v>4.4000000000000004</c:v>
                </c:pt>
                <c:pt idx="71">
                  <c:v>4.5999999999999996</c:v>
                </c:pt>
                <c:pt idx="72">
                  <c:v>3.9</c:v>
                </c:pt>
                <c:pt idx="73">
                  <c:v>4.5999999999999996</c:v>
                </c:pt>
                <c:pt idx="74">
                  <c:v>5.3</c:v>
                </c:pt>
                <c:pt idx="75">
                  <c:v>4.5</c:v>
                </c:pt>
                <c:pt idx="76">
                  <c:v>4.8</c:v>
                </c:pt>
                <c:pt idx="77">
                  <c:v>4.7</c:v>
                </c:pt>
                <c:pt idx="78">
                  <c:v>4</c:v>
                </c:pt>
                <c:pt idx="79">
                  <c:v>4.5</c:v>
                </c:pt>
                <c:pt idx="80">
                  <c:v>4</c:v>
                </c:pt>
                <c:pt idx="81">
                  <c:v>4.0999999999999996</c:v>
                </c:pt>
                <c:pt idx="82">
                  <c:v>4.3</c:v>
                </c:pt>
                <c:pt idx="83">
                  <c:v>4.8</c:v>
                </c:pt>
                <c:pt idx="84">
                  <c:v>3.9</c:v>
                </c:pt>
                <c:pt idx="85">
                  <c:v>4.5999999999999996</c:v>
                </c:pt>
                <c:pt idx="86">
                  <c:v>3.7</c:v>
                </c:pt>
                <c:pt idx="87">
                  <c:v>4.2</c:v>
                </c:pt>
                <c:pt idx="88">
                  <c:v>4.4000000000000004</c:v>
                </c:pt>
                <c:pt idx="89">
                  <c:v>4.0999999999999996</c:v>
                </c:pt>
                <c:pt idx="90">
                  <c:v>4.0999999999999996</c:v>
                </c:pt>
                <c:pt idx="91">
                  <c:v>4.0999999999999996</c:v>
                </c:pt>
                <c:pt idx="92">
                  <c:v>4.9000000000000004</c:v>
                </c:pt>
                <c:pt idx="93">
                  <c:v>5.3</c:v>
                </c:pt>
                <c:pt idx="94">
                  <c:v>4.8</c:v>
                </c:pt>
                <c:pt idx="95">
                  <c:v>5.5</c:v>
                </c:pt>
                <c:pt idx="96">
                  <c:v>5.6</c:v>
                </c:pt>
                <c:pt idx="97">
                  <c:v>5.8</c:v>
                </c:pt>
                <c:pt idx="98">
                  <c:v>5.6</c:v>
                </c:pt>
                <c:pt idx="99">
                  <c:v>5.0999999999999996</c:v>
                </c:pt>
                <c:pt idx="100">
                  <c:v>6.7</c:v>
                </c:pt>
                <c:pt idx="101">
                  <c:v>7.8</c:v>
                </c:pt>
                <c:pt idx="102">
                  <c:v>4.7</c:v>
                </c:pt>
                <c:pt idx="103">
                  <c:v>4.5999999999999996</c:v>
                </c:pt>
                <c:pt idx="104">
                  <c:v>5.3</c:v>
                </c:pt>
                <c:pt idx="105">
                  <c:v>6.1</c:v>
                </c:pt>
                <c:pt idx="106">
                  <c:v>5.8</c:v>
                </c:pt>
                <c:pt idx="107">
                  <c:v>4.5</c:v>
                </c:pt>
                <c:pt idx="108">
                  <c:v>5.6</c:v>
                </c:pt>
                <c:pt idx="109">
                  <c:v>6.1</c:v>
                </c:pt>
                <c:pt idx="110">
                  <c:v>6.9</c:v>
                </c:pt>
                <c:pt idx="111">
                  <c:v>7.2</c:v>
                </c:pt>
                <c:pt idx="112">
                  <c:v>6.8</c:v>
                </c:pt>
                <c:pt idx="113">
                  <c:v>6.8</c:v>
                </c:pt>
                <c:pt idx="114">
                  <c:v>8.5</c:v>
                </c:pt>
                <c:pt idx="115">
                  <c:v>8</c:v>
                </c:pt>
                <c:pt idx="116">
                  <c:v>4.2</c:v>
                </c:pt>
                <c:pt idx="117">
                  <c:v>4.3</c:v>
                </c:pt>
                <c:pt idx="118">
                  <c:v>3.4</c:v>
                </c:pt>
                <c:pt idx="119">
                  <c:v>4.5999999999999996</c:v>
                </c:pt>
                <c:pt idx="120">
                  <c:v>2.5</c:v>
                </c:pt>
                <c:pt idx="121">
                  <c:v>3.2</c:v>
                </c:pt>
                <c:pt idx="122">
                  <c:v>3.4</c:v>
                </c:pt>
                <c:pt idx="123">
                  <c:v>3.3</c:v>
                </c:pt>
                <c:pt idx="124">
                  <c:v>5.0999999999999996</c:v>
                </c:pt>
                <c:pt idx="125">
                  <c:v>4.8</c:v>
                </c:pt>
                <c:pt idx="126">
                  <c:v>6.6</c:v>
                </c:pt>
                <c:pt idx="127">
                  <c:v>9.3000000000000007</c:v>
                </c:pt>
                <c:pt idx="128">
                  <c:v>6.2</c:v>
                </c:pt>
                <c:pt idx="129">
                  <c:v>7.9</c:v>
                </c:pt>
                <c:pt idx="130">
                  <c:v>7.5</c:v>
                </c:pt>
                <c:pt idx="131">
                  <c:v>7.5</c:v>
                </c:pt>
                <c:pt idx="132">
                  <c:v>6.5</c:v>
                </c:pt>
                <c:pt idx="133">
                  <c:v>7.3</c:v>
                </c:pt>
                <c:pt idx="134">
                  <c:v>7.7</c:v>
                </c:pt>
                <c:pt idx="135">
                  <c:v>7.2</c:v>
                </c:pt>
                <c:pt idx="136">
                  <c:v>8</c:v>
                </c:pt>
                <c:pt idx="137">
                  <c:v>8.6</c:v>
                </c:pt>
                <c:pt idx="138">
                  <c:v>8.6</c:v>
                </c:pt>
                <c:pt idx="139">
                  <c:v>8</c:v>
                </c:pt>
                <c:pt idx="140">
                  <c:v>7.2</c:v>
                </c:pt>
                <c:pt idx="141">
                  <c:v>8.9</c:v>
                </c:pt>
                <c:pt idx="142">
                  <c:v>9.4</c:v>
                </c:pt>
                <c:pt idx="143">
                  <c:v>10</c:v>
                </c:pt>
                <c:pt idx="144">
                  <c:v>8.9</c:v>
                </c:pt>
                <c:pt idx="145">
                  <c:v>8.3000000000000007</c:v>
                </c:pt>
                <c:pt idx="146">
                  <c:v>8.5</c:v>
                </c:pt>
                <c:pt idx="147">
                  <c:v>8.3000000000000007</c:v>
                </c:pt>
                <c:pt idx="148">
                  <c:v>8</c:v>
                </c:pt>
                <c:pt idx="149">
                  <c:v>8.3000000000000007</c:v>
                </c:pt>
                <c:pt idx="150">
                  <c:v>8</c:v>
                </c:pt>
                <c:pt idx="151">
                  <c:v>9.1999999999999993</c:v>
                </c:pt>
                <c:pt idx="152">
                  <c:v>9.5</c:v>
                </c:pt>
                <c:pt idx="153">
                  <c:v>9.4</c:v>
                </c:pt>
                <c:pt idx="154">
                  <c:v>9.1999999999999993</c:v>
                </c:pt>
                <c:pt idx="155">
                  <c:v>11.2</c:v>
                </c:pt>
                <c:pt idx="156">
                  <c:v>9.4</c:v>
                </c:pt>
                <c:pt idx="157">
                  <c:v>9.1</c:v>
                </c:pt>
                <c:pt idx="158">
                  <c:v>8.6999999999999993</c:v>
                </c:pt>
                <c:pt idx="159">
                  <c:v>10.7</c:v>
                </c:pt>
                <c:pt idx="160">
                  <c:v>8</c:v>
                </c:pt>
                <c:pt idx="161">
                  <c:v>7.2</c:v>
                </c:pt>
                <c:pt idx="162">
                  <c:v>4.5999999999999996</c:v>
                </c:pt>
                <c:pt idx="163">
                  <c:v>5.8</c:v>
                </c:pt>
                <c:pt idx="164">
                  <c:v>6.3</c:v>
                </c:pt>
                <c:pt idx="165">
                  <c:v>4.7</c:v>
                </c:pt>
                <c:pt idx="166">
                  <c:v>7.2</c:v>
                </c:pt>
                <c:pt idx="167">
                  <c:v>7.4</c:v>
                </c:pt>
                <c:pt idx="168">
                  <c:v>5.6</c:v>
                </c:pt>
                <c:pt idx="169">
                  <c:v>7.8</c:v>
                </c:pt>
                <c:pt idx="170">
                  <c:v>7.8</c:v>
                </c:pt>
                <c:pt idx="171">
                  <c:v>9.6</c:v>
                </c:pt>
                <c:pt idx="172">
                  <c:v>5.8</c:v>
                </c:pt>
                <c:pt idx="173">
                  <c:v>6.9</c:v>
                </c:pt>
                <c:pt idx="174">
                  <c:v>6.7</c:v>
                </c:pt>
                <c:pt idx="175">
                  <c:v>7.4</c:v>
                </c:pt>
                <c:pt idx="176">
                  <c:v>8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747-494E-8B86-A589F440B1D4}"/>
            </c:ext>
          </c:extLst>
        </c:ser>
        <c:ser>
          <c:idx val="3"/>
          <c:order val="3"/>
          <c:tx>
            <c:strRef>
              <c:f>'env2'!$F$1</c:f>
              <c:strCache>
                <c:ptCount val="1"/>
                <c:pt idx="0">
                  <c:v>Min Temp</c:v>
                </c:pt>
              </c:strCache>
            </c:strRef>
          </c:tx>
          <c:spPr>
            <a:ln w="38100"/>
          </c:spPr>
          <c:marker>
            <c:symbol val="none"/>
          </c:marker>
          <c:cat>
            <c:multiLvlStrRef>
              <c:f>'env2'!$A$2:$B$178</c:f>
              <c:multiLvlStrCache>
                <c:ptCount val="177"/>
                <c:lvl>
                  <c:pt idx="0">
                    <c:v>11/5/2013</c:v>
                  </c:pt>
                  <c:pt idx="1">
                    <c:v>11/6/2013</c:v>
                  </c:pt>
                  <c:pt idx="2">
                    <c:v>11/7/2013</c:v>
                  </c:pt>
                  <c:pt idx="3">
                    <c:v>11/8/2013</c:v>
                  </c:pt>
                  <c:pt idx="4">
                    <c:v>11/9/2013</c:v>
                  </c:pt>
                  <c:pt idx="5">
                    <c:v>11/10/2013</c:v>
                  </c:pt>
                  <c:pt idx="6">
                    <c:v>11/11/2013</c:v>
                  </c:pt>
                  <c:pt idx="7">
                    <c:v>11/12/2013</c:v>
                  </c:pt>
                  <c:pt idx="8">
                    <c:v>11/13/2013</c:v>
                  </c:pt>
                  <c:pt idx="9">
                    <c:v>11/14/2013</c:v>
                  </c:pt>
                  <c:pt idx="10">
                    <c:v>11/15/2013</c:v>
                  </c:pt>
                  <c:pt idx="11">
                    <c:v>11/16/2013</c:v>
                  </c:pt>
                  <c:pt idx="12">
                    <c:v>11/17/2013</c:v>
                  </c:pt>
                  <c:pt idx="13">
                    <c:v>11/18/2013</c:v>
                  </c:pt>
                  <c:pt idx="14">
                    <c:v>11/19/2013</c:v>
                  </c:pt>
                  <c:pt idx="15">
                    <c:v>11/20/2013</c:v>
                  </c:pt>
                  <c:pt idx="16">
                    <c:v>11/21/2013</c:v>
                  </c:pt>
                  <c:pt idx="17">
                    <c:v>11/22/2013</c:v>
                  </c:pt>
                  <c:pt idx="18">
                    <c:v>11/23/2013</c:v>
                  </c:pt>
                  <c:pt idx="19">
                    <c:v>11/24/2013</c:v>
                  </c:pt>
                  <c:pt idx="20">
                    <c:v>11/25/2013</c:v>
                  </c:pt>
                  <c:pt idx="21">
                    <c:v>11/26/2013</c:v>
                  </c:pt>
                  <c:pt idx="22">
                    <c:v>11/27/2013</c:v>
                  </c:pt>
                  <c:pt idx="23">
                    <c:v>11/28/2013</c:v>
                  </c:pt>
                  <c:pt idx="24">
                    <c:v>11/29/2013</c:v>
                  </c:pt>
                  <c:pt idx="25">
                    <c:v>11/30/2013</c:v>
                  </c:pt>
                  <c:pt idx="26">
                    <c:v>12/1/2013</c:v>
                  </c:pt>
                  <c:pt idx="27">
                    <c:v>12/2/2013</c:v>
                  </c:pt>
                  <c:pt idx="28">
                    <c:v>12/3/2013</c:v>
                  </c:pt>
                  <c:pt idx="29">
                    <c:v>12/4/2013</c:v>
                  </c:pt>
                  <c:pt idx="30">
                    <c:v>12/5/2013</c:v>
                  </c:pt>
                  <c:pt idx="31">
                    <c:v>12/6/2013</c:v>
                  </c:pt>
                  <c:pt idx="32">
                    <c:v>12/7/2013</c:v>
                  </c:pt>
                  <c:pt idx="33">
                    <c:v>12/8/2013</c:v>
                  </c:pt>
                  <c:pt idx="34">
                    <c:v>12/9/2013</c:v>
                  </c:pt>
                  <c:pt idx="35">
                    <c:v>12/10/2013</c:v>
                  </c:pt>
                  <c:pt idx="36">
                    <c:v>12/11/2013</c:v>
                  </c:pt>
                  <c:pt idx="37">
                    <c:v>12/12/2013</c:v>
                  </c:pt>
                  <c:pt idx="38">
                    <c:v>12/13/2013</c:v>
                  </c:pt>
                  <c:pt idx="39">
                    <c:v>12/14/2013</c:v>
                  </c:pt>
                  <c:pt idx="40">
                    <c:v>12/15/2013</c:v>
                  </c:pt>
                  <c:pt idx="41">
                    <c:v>12/16/2013</c:v>
                  </c:pt>
                  <c:pt idx="42">
                    <c:v>12/17/2013</c:v>
                  </c:pt>
                  <c:pt idx="43">
                    <c:v>12/18/2013</c:v>
                  </c:pt>
                  <c:pt idx="44">
                    <c:v>12/19/2013</c:v>
                  </c:pt>
                  <c:pt idx="45">
                    <c:v>12/20/2013</c:v>
                  </c:pt>
                  <c:pt idx="46">
                    <c:v>12/21/2013</c:v>
                  </c:pt>
                  <c:pt idx="47">
                    <c:v>12/22/2013</c:v>
                  </c:pt>
                  <c:pt idx="48">
                    <c:v>12/23/2013</c:v>
                  </c:pt>
                  <c:pt idx="49">
                    <c:v>12/24/2013</c:v>
                  </c:pt>
                  <c:pt idx="50">
                    <c:v>12/25/2013</c:v>
                  </c:pt>
                  <c:pt idx="51">
                    <c:v>12/26/2013</c:v>
                  </c:pt>
                  <c:pt idx="52">
                    <c:v>12/27/2013</c:v>
                  </c:pt>
                  <c:pt idx="53">
                    <c:v>12/28/2013</c:v>
                  </c:pt>
                  <c:pt idx="54">
                    <c:v>12/29/2013</c:v>
                  </c:pt>
                  <c:pt idx="55">
                    <c:v>12/30/2013</c:v>
                  </c:pt>
                  <c:pt idx="56">
                    <c:v>12/31/2013</c:v>
                  </c:pt>
                  <c:pt idx="57">
                    <c:v>1/1/2014</c:v>
                  </c:pt>
                  <c:pt idx="58">
                    <c:v>1/2/2014</c:v>
                  </c:pt>
                  <c:pt idx="59">
                    <c:v>1/3/2014</c:v>
                  </c:pt>
                  <c:pt idx="60">
                    <c:v>1/4/2014</c:v>
                  </c:pt>
                  <c:pt idx="61">
                    <c:v>1/5/2014</c:v>
                  </c:pt>
                  <c:pt idx="62">
                    <c:v>1/6/2014</c:v>
                  </c:pt>
                  <c:pt idx="63">
                    <c:v>1/7/2014</c:v>
                  </c:pt>
                  <c:pt idx="64">
                    <c:v>1/8/2014</c:v>
                  </c:pt>
                  <c:pt idx="65">
                    <c:v>1/9/2014</c:v>
                  </c:pt>
                  <c:pt idx="66">
                    <c:v>1/10/2014</c:v>
                  </c:pt>
                  <c:pt idx="67">
                    <c:v>1/11/2014</c:v>
                  </c:pt>
                  <c:pt idx="68">
                    <c:v>1/12/2014</c:v>
                  </c:pt>
                  <c:pt idx="69">
                    <c:v>1/13/2014</c:v>
                  </c:pt>
                  <c:pt idx="70">
                    <c:v>1/14/2014</c:v>
                  </c:pt>
                  <c:pt idx="71">
                    <c:v>1/15/2014</c:v>
                  </c:pt>
                  <c:pt idx="72">
                    <c:v>1/16/2014</c:v>
                  </c:pt>
                  <c:pt idx="73">
                    <c:v>1/17/2014</c:v>
                  </c:pt>
                  <c:pt idx="74">
                    <c:v>1/18/2014</c:v>
                  </c:pt>
                  <c:pt idx="75">
                    <c:v>1/19/2014</c:v>
                  </c:pt>
                  <c:pt idx="76">
                    <c:v>1/20/2014</c:v>
                  </c:pt>
                  <c:pt idx="77">
                    <c:v>1/21/2014</c:v>
                  </c:pt>
                  <c:pt idx="78">
                    <c:v>1/22/2014</c:v>
                  </c:pt>
                  <c:pt idx="79">
                    <c:v>1/23/2014</c:v>
                  </c:pt>
                  <c:pt idx="80">
                    <c:v>1/24/2014</c:v>
                  </c:pt>
                  <c:pt idx="81">
                    <c:v>1/25/2014</c:v>
                  </c:pt>
                  <c:pt idx="82">
                    <c:v>1/26/2014</c:v>
                  </c:pt>
                  <c:pt idx="83">
                    <c:v>1/27/2014</c:v>
                  </c:pt>
                  <c:pt idx="84">
                    <c:v>1/28/2014</c:v>
                  </c:pt>
                  <c:pt idx="85">
                    <c:v>1/29/2014</c:v>
                  </c:pt>
                  <c:pt idx="86">
                    <c:v>1/30/2014</c:v>
                  </c:pt>
                  <c:pt idx="87">
                    <c:v>1/31/2014</c:v>
                  </c:pt>
                  <c:pt idx="88">
                    <c:v>2/1/2014</c:v>
                  </c:pt>
                  <c:pt idx="89">
                    <c:v>2/2/2014</c:v>
                  </c:pt>
                  <c:pt idx="90">
                    <c:v>2/3/2014</c:v>
                  </c:pt>
                  <c:pt idx="91">
                    <c:v>2/4/2014</c:v>
                  </c:pt>
                  <c:pt idx="92">
                    <c:v>2/5/2014</c:v>
                  </c:pt>
                  <c:pt idx="93">
                    <c:v>2/6/2014</c:v>
                  </c:pt>
                  <c:pt idx="94">
                    <c:v>2/7/2014</c:v>
                  </c:pt>
                  <c:pt idx="95">
                    <c:v>2/8/2014</c:v>
                  </c:pt>
                  <c:pt idx="96">
                    <c:v>2/9/2014</c:v>
                  </c:pt>
                  <c:pt idx="97">
                    <c:v>2/10/2014</c:v>
                  </c:pt>
                  <c:pt idx="98">
                    <c:v>2/11/2014</c:v>
                  </c:pt>
                  <c:pt idx="99">
                    <c:v>2/12/2014</c:v>
                  </c:pt>
                  <c:pt idx="100">
                    <c:v>2/13/2014</c:v>
                  </c:pt>
                  <c:pt idx="101">
                    <c:v>2/14/2014</c:v>
                  </c:pt>
                  <c:pt idx="102">
                    <c:v>2/15/2014</c:v>
                  </c:pt>
                  <c:pt idx="103">
                    <c:v>2/16/2014</c:v>
                  </c:pt>
                  <c:pt idx="104">
                    <c:v>2/17/2014</c:v>
                  </c:pt>
                  <c:pt idx="105">
                    <c:v>2/18/2014</c:v>
                  </c:pt>
                  <c:pt idx="106">
                    <c:v>2/19/2014</c:v>
                  </c:pt>
                  <c:pt idx="107">
                    <c:v>2/20/2014</c:v>
                  </c:pt>
                  <c:pt idx="108">
                    <c:v>2/21/2014</c:v>
                  </c:pt>
                  <c:pt idx="109">
                    <c:v>2/22/2014</c:v>
                  </c:pt>
                  <c:pt idx="110">
                    <c:v>2/23/2014</c:v>
                  </c:pt>
                  <c:pt idx="111">
                    <c:v>2/24/2014</c:v>
                  </c:pt>
                  <c:pt idx="112">
                    <c:v>2/25/2014</c:v>
                  </c:pt>
                  <c:pt idx="113">
                    <c:v>2/26/2014</c:v>
                  </c:pt>
                  <c:pt idx="114">
                    <c:v>2/27/2014</c:v>
                  </c:pt>
                  <c:pt idx="115">
                    <c:v>2/28/2014</c:v>
                  </c:pt>
                  <c:pt idx="116">
                    <c:v>3/1/2014</c:v>
                  </c:pt>
                  <c:pt idx="117">
                    <c:v>3/2/2014</c:v>
                  </c:pt>
                  <c:pt idx="118">
                    <c:v>3/3/2014</c:v>
                  </c:pt>
                  <c:pt idx="119">
                    <c:v>3/4/2014</c:v>
                  </c:pt>
                  <c:pt idx="120">
                    <c:v>3/5/2014</c:v>
                  </c:pt>
                  <c:pt idx="121">
                    <c:v>3/6/2014</c:v>
                  </c:pt>
                  <c:pt idx="122">
                    <c:v>3/7/2014</c:v>
                  </c:pt>
                  <c:pt idx="123">
                    <c:v>3/8/2014</c:v>
                  </c:pt>
                  <c:pt idx="124">
                    <c:v>3/9/2014</c:v>
                  </c:pt>
                  <c:pt idx="125">
                    <c:v>3/10/2014</c:v>
                  </c:pt>
                  <c:pt idx="126">
                    <c:v>3/11/2014</c:v>
                  </c:pt>
                  <c:pt idx="127">
                    <c:v>3/12/2014</c:v>
                  </c:pt>
                  <c:pt idx="128">
                    <c:v>3/13/2014</c:v>
                  </c:pt>
                  <c:pt idx="129">
                    <c:v>3/14/2014</c:v>
                  </c:pt>
                  <c:pt idx="130">
                    <c:v>3/15/2014</c:v>
                  </c:pt>
                  <c:pt idx="131">
                    <c:v>3/16/2014</c:v>
                  </c:pt>
                  <c:pt idx="132">
                    <c:v>3/17/2014</c:v>
                  </c:pt>
                  <c:pt idx="133">
                    <c:v>3/18/2014</c:v>
                  </c:pt>
                  <c:pt idx="134">
                    <c:v>3/19/2014</c:v>
                  </c:pt>
                  <c:pt idx="135">
                    <c:v>3/20/2014</c:v>
                  </c:pt>
                  <c:pt idx="136">
                    <c:v>3/21/2014</c:v>
                  </c:pt>
                  <c:pt idx="137">
                    <c:v>3/22/2014</c:v>
                  </c:pt>
                  <c:pt idx="138">
                    <c:v>3/23/2014</c:v>
                  </c:pt>
                  <c:pt idx="139">
                    <c:v>3/24/2014</c:v>
                  </c:pt>
                  <c:pt idx="140">
                    <c:v>3/25/2014</c:v>
                  </c:pt>
                  <c:pt idx="141">
                    <c:v>3/26/2014</c:v>
                  </c:pt>
                  <c:pt idx="142">
                    <c:v>3/27/2014</c:v>
                  </c:pt>
                  <c:pt idx="143">
                    <c:v>3/28/2014</c:v>
                  </c:pt>
                  <c:pt idx="144">
                    <c:v>3/29/2014</c:v>
                  </c:pt>
                  <c:pt idx="145">
                    <c:v>3/30/2014</c:v>
                  </c:pt>
                  <c:pt idx="146">
                    <c:v>3/31/2014</c:v>
                  </c:pt>
                  <c:pt idx="147">
                    <c:v>4/1/2014</c:v>
                  </c:pt>
                  <c:pt idx="148">
                    <c:v>4/2/2014</c:v>
                  </c:pt>
                  <c:pt idx="149">
                    <c:v>4/3/2014</c:v>
                  </c:pt>
                  <c:pt idx="150">
                    <c:v>4/4/2014</c:v>
                  </c:pt>
                  <c:pt idx="151">
                    <c:v>4/5/2014</c:v>
                  </c:pt>
                  <c:pt idx="152">
                    <c:v>4/6/2014</c:v>
                  </c:pt>
                  <c:pt idx="153">
                    <c:v>4/7/2014</c:v>
                  </c:pt>
                  <c:pt idx="154">
                    <c:v>4/8/2014</c:v>
                  </c:pt>
                  <c:pt idx="155">
                    <c:v>4/9/2014</c:v>
                  </c:pt>
                  <c:pt idx="156">
                    <c:v>4/10/2014</c:v>
                  </c:pt>
                  <c:pt idx="157">
                    <c:v>4/11/2014</c:v>
                  </c:pt>
                  <c:pt idx="158">
                    <c:v>4/12/2014</c:v>
                  </c:pt>
                  <c:pt idx="159">
                    <c:v>4/13/2014</c:v>
                  </c:pt>
                  <c:pt idx="160">
                    <c:v>4/14/2014</c:v>
                  </c:pt>
                  <c:pt idx="161">
                    <c:v>4/15/2014</c:v>
                  </c:pt>
                  <c:pt idx="162">
                    <c:v>4/16/2014</c:v>
                  </c:pt>
                  <c:pt idx="163">
                    <c:v>4/17/2014</c:v>
                  </c:pt>
                  <c:pt idx="164">
                    <c:v>4/18/2014</c:v>
                  </c:pt>
                  <c:pt idx="165">
                    <c:v>4/19/2014</c:v>
                  </c:pt>
                  <c:pt idx="166">
                    <c:v>4/20/2014</c:v>
                  </c:pt>
                  <c:pt idx="167">
                    <c:v>4/21/2014</c:v>
                  </c:pt>
                  <c:pt idx="168">
                    <c:v>4/22/2014</c:v>
                  </c:pt>
                  <c:pt idx="169">
                    <c:v>4/23/2014</c:v>
                  </c:pt>
                  <c:pt idx="170">
                    <c:v>4/24/2014</c:v>
                  </c:pt>
                  <c:pt idx="171">
                    <c:v>4/25/2014</c:v>
                  </c:pt>
                  <c:pt idx="172">
                    <c:v>4/26/2014</c:v>
                  </c:pt>
                  <c:pt idx="173">
                    <c:v>4/27/2014</c:v>
                  </c:pt>
                  <c:pt idx="174">
                    <c:v>4/28/2014</c:v>
                  </c:pt>
                  <c:pt idx="175">
                    <c:v>4/29/2014</c:v>
                  </c:pt>
                  <c:pt idx="176">
                    <c:v>4/30/2014</c:v>
                  </c:pt>
                </c:lvl>
                <c:lvl>
                  <c:pt idx="15">
                    <c:v>DOS</c:v>
                  </c:pt>
                  <c:pt idx="101">
                    <c:v>%GL7</c:v>
                  </c:pt>
                  <c:pt idx="108">
                    <c:v>%GL14</c:v>
                  </c:pt>
                  <c:pt idx="115">
                    <c:v>%GL21</c:v>
                  </c:pt>
                  <c:pt idx="134">
                    <c:v>%GL28</c:v>
                  </c:pt>
                  <c:pt idx="141">
                    <c:v>%GL35</c:v>
                  </c:pt>
                  <c:pt idx="148">
                    <c:v>%GL42</c:v>
                  </c:pt>
                  <c:pt idx="155">
                    <c:v>%GL49</c:v>
                  </c:pt>
                </c:lvl>
              </c:multiLvlStrCache>
            </c:multiLvlStrRef>
          </c:cat>
          <c:val>
            <c:numRef>
              <c:f>'env2'!$F$2:$F$178</c:f>
              <c:numCache>
                <c:formatCode>General</c:formatCode>
                <c:ptCount val="177"/>
                <c:pt idx="0">
                  <c:v>16.8</c:v>
                </c:pt>
                <c:pt idx="1">
                  <c:v>15</c:v>
                </c:pt>
                <c:pt idx="2">
                  <c:v>15.2</c:v>
                </c:pt>
                <c:pt idx="3">
                  <c:v>15.6</c:v>
                </c:pt>
                <c:pt idx="4">
                  <c:v>15.2</c:v>
                </c:pt>
                <c:pt idx="5">
                  <c:v>15.2</c:v>
                </c:pt>
                <c:pt idx="6">
                  <c:v>13.2</c:v>
                </c:pt>
                <c:pt idx="7">
                  <c:v>11.4</c:v>
                </c:pt>
                <c:pt idx="8">
                  <c:v>12.5</c:v>
                </c:pt>
                <c:pt idx="9">
                  <c:v>11.5</c:v>
                </c:pt>
                <c:pt idx="10">
                  <c:v>10.7</c:v>
                </c:pt>
                <c:pt idx="11">
                  <c:v>10.199999999999999</c:v>
                </c:pt>
                <c:pt idx="12">
                  <c:v>18.399999999999999</c:v>
                </c:pt>
                <c:pt idx="13">
                  <c:v>16.5</c:v>
                </c:pt>
                <c:pt idx="14">
                  <c:v>15.5</c:v>
                </c:pt>
                <c:pt idx="15">
                  <c:v>11.5</c:v>
                </c:pt>
                <c:pt idx="16">
                  <c:v>11</c:v>
                </c:pt>
                <c:pt idx="17">
                  <c:v>14.8</c:v>
                </c:pt>
                <c:pt idx="18">
                  <c:v>20.8</c:v>
                </c:pt>
                <c:pt idx="19">
                  <c:v>21</c:v>
                </c:pt>
                <c:pt idx="20">
                  <c:v>18.7</c:v>
                </c:pt>
                <c:pt idx="21">
                  <c:v>18.5</c:v>
                </c:pt>
                <c:pt idx="22">
                  <c:v>13.4</c:v>
                </c:pt>
                <c:pt idx="23">
                  <c:v>11.6</c:v>
                </c:pt>
                <c:pt idx="24">
                  <c:v>17.5</c:v>
                </c:pt>
                <c:pt idx="25">
                  <c:v>16.5</c:v>
                </c:pt>
                <c:pt idx="26">
                  <c:v>16.5</c:v>
                </c:pt>
                <c:pt idx="27">
                  <c:v>18.399999999999999</c:v>
                </c:pt>
                <c:pt idx="28">
                  <c:v>19.8</c:v>
                </c:pt>
                <c:pt idx="29">
                  <c:v>16.399999999999999</c:v>
                </c:pt>
                <c:pt idx="30">
                  <c:v>13.5</c:v>
                </c:pt>
                <c:pt idx="31">
                  <c:v>11.6</c:v>
                </c:pt>
                <c:pt idx="32">
                  <c:v>8.8000000000000007</c:v>
                </c:pt>
                <c:pt idx="33">
                  <c:v>8.4</c:v>
                </c:pt>
                <c:pt idx="34">
                  <c:v>6.8</c:v>
                </c:pt>
                <c:pt idx="35">
                  <c:v>7</c:v>
                </c:pt>
                <c:pt idx="36">
                  <c:v>7.5</c:v>
                </c:pt>
                <c:pt idx="37">
                  <c:v>9.8000000000000007</c:v>
                </c:pt>
                <c:pt idx="38">
                  <c:v>8.9</c:v>
                </c:pt>
                <c:pt idx="39">
                  <c:v>8.8000000000000007</c:v>
                </c:pt>
                <c:pt idx="40">
                  <c:v>8.1999999999999993</c:v>
                </c:pt>
                <c:pt idx="41">
                  <c:v>8</c:v>
                </c:pt>
                <c:pt idx="42">
                  <c:v>8.1999999999999993</c:v>
                </c:pt>
                <c:pt idx="43">
                  <c:v>8.4</c:v>
                </c:pt>
                <c:pt idx="44">
                  <c:v>8.6</c:v>
                </c:pt>
                <c:pt idx="45">
                  <c:v>9</c:v>
                </c:pt>
                <c:pt idx="46">
                  <c:v>13</c:v>
                </c:pt>
                <c:pt idx="47">
                  <c:v>15.8</c:v>
                </c:pt>
                <c:pt idx="48">
                  <c:v>12.8</c:v>
                </c:pt>
                <c:pt idx="49">
                  <c:v>12</c:v>
                </c:pt>
                <c:pt idx="50">
                  <c:v>11.8</c:v>
                </c:pt>
                <c:pt idx="51">
                  <c:v>11</c:v>
                </c:pt>
                <c:pt idx="52">
                  <c:v>10</c:v>
                </c:pt>
                <c:pt idx="53">
                  <c:v>11</c:v>
                </c:pt>
                <c:pt idx="54">
                  <c:v>14.2</c:v>
                </c:pt>
                <c:pt idx="55">
                  <c:v>14</c:v>
                </c:pt>
                <c:pt idx="56">
                  <c:v>15.4</c:v>
                </c:pt>
                <c:pt idx="57">
                  <c:v>16.399999999999999</c:v>
                </c:pt>
                <c:pt idx="58">
                  <c:v>11.4</c:v>
                </c:pt>
                <c:pt idx="59">
                  <c:v>11</c:v>
                </c:pt>
                <c:pt idx="60">
                  <c:v>10.8</c:v>
                </c:pt>
                <c:pt idx="61">
                  <c:v>13.8</c:v>
                </c:pt>
                <c:pt idx="62">
                  <c:v>14.4</c:v>
                </c:pt>
                <c:pt idx="63">
                  <c:v>16</c:v>
                </c:pt>
                <c:pt idx="64">
                  <c:v>13.2</c:v>
                </c:pt>
                <c:pt idx="65">
                  <c:v>13</c:v>
                </c:pt>
                <c:pt idx="66">
                  <c:v>15.8</c:v>
                </c:pt>
                <c:pt idx="67">
                  <c:v>17.2</c:v>
                </c:pt>
                <c:pt idx="68">
                  <c:v>17</c:v>
                </c:pt>
                <c:pt idx="69">
                  <c:v>14</c:v>
                </c:pt>
                <c:pt idx="70">
                  <c:v>14.2</c:v>
                </c:pt>
                <c:pt idx="71">
                  <c:v>14</c:v>
                </c:pt>
                <c:pt idx="72">
                  <c:v>14.4</c:v>
                </c:pt>
                <c:pt idx="73">
                  <c:v>15.8</c:v>
                </c:pt>
                <c:pt idx="74">
                  <c:v>16</c:v>
                </c:pt>
                <c:pt idx="75">
                  <c:v>18.399999999999999</c:v>
                </c:pt>
                <c:pt idx="76">
                  <c:v>14</c:v>
                </c:pt>
                <c:pt idx="77">
                  <c:v>15</c:v>
                </c:pt>
                <c:pt idx="78">
                  <c:v>16.8</c:v>
                </c:pt>
                <c:pt idx="79">
                  <c:v>17.600000000000001</c:v>
                </c:pt>
                <c:pt idx="80">
                  <c:v>15.6</c:v>
                </c:pt>
                <c:pt idx="81">
                  <c:v>15</c:v>
                </c:pt>
                <c:pt idx="82">
                  <c:v>17</c:v>
                </c:pt>
                <c:pt idx="83">
                  <c:v>14.6</c:v>
                </c:pt>
                <c:pt idx="84">
                  <c:v>12.6</c:v>
                </c:pt>
                <c:pt idx="85">
                  <c:v>16.8</c:v>
                </c:pt>
                <c:pt idx="86">
                  <c:v>15</c:v>
                </c:pt>
                <c:pt idx="87">
                  <c:v>12.5</c:v>
                </c:pt>
                <c:pt idx="88">
                  <c:v>12.1</c:v>
                </c:pt>
                <c:pt idx="89">
                  <c:v>13</c:v>
                </c:pt>
                <c:pt idx="90">
                  <c:v>12.6</c:v>
                </c:pt>
                <c:pt idx="91">
                  <c:v>12.7</c:v>
                </c:pt>
                <c:pt idx="92">
                  <c:v>12.6</c:v>
                </c:pt>
                <c:pt idx="93">
                  <c:v>13.6</c:v>
                </c:pt>
                <c:pt idx="94">
                  <c:v>15.3</c:v>
                </c:pt>
                <c:pt idx="95">
                  <c:v>14.3</c:v>
                </c:pt>
                <c:pt idx="96">
                  <c:v>13.7</c:v>
                </c:pt>
                <c:pt idx="97">
                  <c:v>14</c:v>
                </c:pt>
                <c:pt idx="98">
                  <c:v>12.5</c:v>
                </c:pt>
                <c:pt idx="99">
                  <c:v>16</c:v>
                </c:pt>
                <c:pt idx="100">
                  <c:v>17.100000000000001</c:v>
                </c:pt>
                <c:pt idx="101">
                  <c:v>17.7</c:v>
                </c:pt>
                <c:pt idx="102">
                  <c:v>16.899999999999999</c:v>
                </c:pt>
                <c:pt idx="103">
                  <c:v>17.5</c:v>
                </c:pt>
                <c:pt idx="104">
                  <c:v>11.7</c:v>
                </c:pt>
                <c:pt idx="105">
                  <c:v>11.8</c:v>
                </c:pt>
                <c:pt idx="106">
                  <c:v>14.3</c:v>
                </c:pt>
                <c:pt idx="107">
                  <c:v>17.600000000000001</c:v>
                </c:pt>
                <c:pt idx="108">
                  <c:v>18.2</c:v>
                </c:pt>
                <c:pt idx="109">
                  <c:v>19.2</c:v>
                </c:pt>
                <c:pt idx="110">
                  <c:v>20.5</c:v>
                </c:pt>
                <c:pt idx="111">
                  <c:v>19</c:v>
                </c:pt>
                <c:pt idx="112">
                  <c:v>17.7</c:v>
                </c:pt>
                <c:pt idx="113">
                  <c:v>15.2</c:v>
                </c:pt>
                <c:pt idx="114">
                  <c:v>19.5</c:v>
                </c:pt>
                <c:pt idx="115">
                  <c:v>19.2</c:v>
                </c:pt>
                <c:pt idx="116">
                  <c:v>19.5</c:v>
                </c:pt>
                <c:pt idx="117">
                  <c:v>16.399999999999999</c:v>
                </c:pt>
                <c:pt idx="118">
                  <c:v>19.8</c:v>
                </c:pt>
                <c:pt idx="119">
                  <c:v>18.8</c:v>
                </c:pt>
                <c:pt idx="120">
                  <c:v>17.8</c:v>
                </c:pt>
                <c:pt idx="121">
                  <c:v>18.600000000000001</c:v>
                </c:pt>
                <c:pt idx="122">
                  <c:v>18.8</c:v>
                </c:pt>
                <c:pt idx="123">
                  <c:v>19.8</c:v>
                </c:pt>
                <c:pt idx="124">
                  <c:v>18.399999999999999</c:v>
                </c:pt>
                <c:pt idx="125">
                  <c:v>19</c:v>
                </c:pt>
                <c:pt idx="126">
                  <c:v>20.2</c:v>
                </c:pt>
                <c:pt idx="127">
                  <c:v>20</c:v>
                </c:pt>
                <c:pt idx="128">
                  <c:v>18.2</c:v>
                </c:pt>
                <c:pt idx="129">
                  <c:v>16.8</c:v>
                </c:pt>
                <c:pt idx="130">
                  <c:v>18.5</c:v>
                </c:pt>
                <c:pt idx="131">
                  <c:v>17.8</c:v>
                </c:pt>
                <c:pt idx="132">
                  <c:v>17</c:v>
                </c:pt>
                <c:pt idx="133">
                  <c:v>20</c:v>
                </c:pt>
                <c:pt idx="134">
                  <c:v>18.8</c:v>
                </c:pt>
                <c:pt idx="135">
                  <c:v>20</c:v>
                </c:pt>
                <c:pt idx="136">
                  <c:v>19.2</c:v>
                </c:pt>
                <c:pt idx="137">
                  <c:v>20.399999999999999</c:v>
                </c:pt>
                <c:pt idx="138">
                  <c:v>19.2</c:v>
                </c:pt>
                <c:pt idx="139">
                  <c:v>22.7</c:v>
                </c:pt>
                <c:pt idx="140">
                  <c:v>22.7</c:v>
                </c:pt>
                <c:pt idx="141">
                  <c:v>20</c:v>
                </c:pt>
                <c:pt idx="142">
                  <c:v>21.8</c:v>
                </c:pt>
                <c:pt idx="143">
                  <c:v>18.600000000000001</c:v>
                </c:pt>
                <c:pt idx="144">
                  <c:v>21.8</c:v>
                </c:pt>
                <c:pt idx="145">
                  <c:v>19.8</c:v>
                </c:pt>
                <c:pt idx="146">
                  <c:v>21.6</c:v>
                </c:pt>
                <c:pt idx="147">
                  <c:v>22.8</c:v>
                </c:pt>
                <c:pt idx="148">
                  <c:v>20.399999999999999</c:v>
                </c:pt>
                <c:pt idx="149">
                  <c:v>20.8</c:v>
                </c:pt>
                <c:pt idx="150">
                  <c:v>20.6</c:v>
                </c:pt>
                <c:pt idx="151">
                  <c:v>20.8</c:v>
                </c:pt>
                <c:pt idx="152">
                  <c:v>24</c:v>
                </c:pt>
                <c:pt idx="153">
                  <c:v>23.2</c:v>
                </c:pt>
                <c:pt idx="154">
                  <c:v>22.8</c:v>
                </c:pt>
                <c:pt idx="155">
                  <c:v>25.2</c:v>
                </c:pt>
                <c:pt idx="156">
                  <c:v>22.8</c:v>
                </c:pt>
                <c:pt idx="157">
                  <c:v>22.6</c:v>
                </c:pt>
                <c:pt idx="158">
                  <c:v>23.4</c:v>
                </c:pt>
                <c:pt idx="159">
                  <c:v>25</c:v>
                </c:pt>
                <c:pt idx="160">
                  <c:v>22.8</c:v>
                </c:pt>
                <c:pt idx="161">
                  <c:v>22.8</c:v>
                </c:pt>
                <c:pt idx="162">
                  <c:v>23</c:v>
                </c:pt>
                <c:pt idx="163">
                  <c:v>23.6</c:v>
                </c:pt>
                <c:pt idx="164">
                  <c:v>23</c:v>
                </c:pt>
                <c:pt idx="165">
                  <c:v>22.8</c:v>
                </c:pt>
                <c:pt idx="166">
                  <c:v>22</c:v>
                </c:pt>
                <c:pt idx="167">
                  <c:v>22.8</c:v>
                </c:pt>
                <c:pt idx="168">
                  <c:v>20.8</c:v>
                </c:pt>
                <c:pt idx="169">
                  <c:v>23.2</c:v>
                </c:pt>
                <c:pt idx="170">
                  <c:v>27.2</c:v>
                </c:pt>
                <c:pt idx="171">
                  <c:v>25</c:v>
                </c:pt>
                <c:pt idx="172">
                  <c:v>24.8</c:v>
                </c:pt>
                <c:pt idx="173">
                  <c:v>24.2</c:v>
                </c:pt>
                <c:pt idx="174">
                  <c:v>24.6</c:v>
                </c:pt>
                <c:pt idx="175">
                  <c:v>22.8</c:v>
                </c:pt>
                <c:pt idx="176">
                  <c:v>25.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747-494E-8B86-A589F440B1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2751960"/>
        <c:axId val="352752744"/>
      </c:lineChart>
      <c:lineChart>
        <c:grouping val="standard"/>
        <c:varyColors val="0"/>
        <c:ser>
          <c:idx val="2"/>
          <c:order val="2"/>
          <c:tx>
            <c:strRef>
              <c:f>'env2'!$E$1</c:f>
              <c:strCache>
                <c:ptCount val="1"/>
                <c:pt idx="0">
                  <c:v>Max Temp</c:v>
                </c:pt>
              </c:strCache>
            </c:strRef>
          </c:tx>
          <c:spPr>
            <a:ln w="38100">
              <a:solidFill>
                <a:srgbClr val="56EE20"/>
              </a:solidFill>
            </a:ln>
          </c:spPr>
          <c:marker>
            <c:symbol val="none"/>
          </c:marker>
          <c:cat>
            <c:multiLvlStrRef>
              <c:f>'env2'!$A$2:$B$178</c:f>
              <c:multiLvlStrCache>
                <c:ptCount val="177"/>
                <c:lvl>
                  <c:pt idx="0">
                    <c:v>11/5/2013</c:v>
                  </c:pt>
                  <c:pt idx="1">
                    <c:v>11/6/2013</c:v>
                  </c:pt>
                  <c:pt idx="2">
                    <c:v>11/7/2013</c:v>
                  </c:pt>
                  <c:pt idx="3">
                    <c:v>11/8/2013</c:v>
                  </c:pt>
                  <c:pt idx="4">
                    <c:v>11/9/2013</c:v>
                  </c:pt>
                  <c:pt idx="5">
                    <c:v>11/10/2013</c:v>
                  </c:pt>
                  <c:pt idx="6">
                    <c:v>11/11/2013</c:v>
                  </c:pt>
                  <c:pt idx="7">
                    <c:v>11/12/2013</c:v>
                  </c:pt>
                  <c:pt idx="8">
                    <c:v>11/13/2013</c:v>
                  </c:pt>
                  <c:pt idx="9">
                    <c:v>11/14/2013</c:v>
                  </c:pt>
                  <c:pt idx="10">
                    <c:v>11/15/2013</c:v>
                  </c:pt>
                  <c:pt idx="11">
                    <c:v>11/16/2013</c:v>
                  </c:pt>
                  <c:pt idx="12">
                    <c:v>11/17/2013</c:v>
                  </c:pt>
                  <c:pt idx="13">
                    <c:v>11/18/2013</c:v>
                  </c:pt>
                  <c:pt idx="14">
                    <c:v>11/19/2013</c:v>
                  </c:pt>
                  <c:pt idx="15">
                    <c:v>11/20/2013</c:v>
                  </c:pt>
                  <c:pt idx="16">
                    <c:v>11/21/2013</c:v>
                  </c:pt>
                  <c:pt idx="17">
                    <c:v>11/22/2013</c:v>
                  </c:pt>
                  <c:pt idx="18">
                    <c:v>11/23/2013</c:v>
                  </c:pt>
                  <c:pt idx="19">
                    <c:v>11/24/2013</c:v>
                  </c:pt>
                  <c:pt idx="20">
                    <c:v>11/25/2013</c:v>
                  </c:pt>
                  <c:pt idx="21">
                    <c:v>11/26/2013</c:v>
                  </c:pt>
                  <c:pt idx="22">
                    <c:v>11/27/2013</c:v>
                  </c:pt>
                  <c:pt idx="23">
                    <c:v>11/28/2013</c:v>
                  </c:pt>
                  <c:pt idx="24">
                    <c:v>11/29/2013</c:v>
                  </c:pt>
                  <c:pt idx="25">
                    <c:v>11/30/2013</c:v>
                  </c:pt>
                  <c:pt idx="26">
                    <c:v>12/1/2013</c:v>
                  </c:pt>
                  <c:pt idx="27">
                    <c:v>12/2/2013</c:v>
                  </c:pt>
                  <c:pt idx="28">
                    <c:v>12/3/2013</c:v>
                  </c:pt>
                  <c:pt idx="29">
                    <c:v>12/4/2013</c:v>
                  </c:pt>
                  <c:pt idx="30">
                    <c:v>12/5/2013</c:v>
                  </c:pt>
                  <c:pt idx="31">
                    <c:v>12/6/2013</c:v>
                  </c:pt>
                  <c:pt idx="32">
                    <c:v>12/7/2013</c:v>
                  </c:pt>
                  <c:pt idx="33">
                    <c:v>12/8/2013</c:v>
                  </c:pt>
                  <c:pt idx="34">
                    <c:v>12/9/2013</c:v>
                  </c:pt>
                  <c:pt idx="35">
                    <c:v>12/10/2013</c:v>
                  </c:pt>
                  <c:pt idx="36">
                    <c:v>12/11/2013</c:v>
                  </c:pt>
                  <c:pt idx="37">
                    <c:v>12/12/2013</c:v>
                  </c:pt>
                  <c:pt idx="38">
                    <c:v>12/13/2013</c:v>
                  </c:pt>
                  <c:pt idx="39">
                    <c:v>12/14/2013</c:v>
                  </c:pt>
                  <c:pt idx="40">
                    <c:v>12/15/2013</c:v>
                  </c:pt>
                  <c:pt idx="41">
                    <c:v>12/16/2013</c:v>
                  </c:pt>
                  <c:pt idx="42">
                    <c:v>12/17/2013</c:v>
                  </c:pt>
                  <c:pt idx="43">
                    <c:v>12/18/2013</c:v>
                  </c:pt>
                  <c:pt idx="44">
                    <c:v>12/19/2013</c:v>
                  </c:pt>
                  <c:pt idx="45">
                    <c:v>12/20/2013</c:v>
                  </c:pt>
                  <c:pt idx="46">
                    <c:v>12/21/2013</c:v>
                  </c:pt>
                  <c:pt idx="47">
                    <c:v>12/22/2013</c:v>
                  </c:pt>
                  <c:pt idx="48">
                    <c:v>12/23/2013</c:v>
                  </c:pt>
                  <c:pt idx="49">
                    <c:v>12/24/2013</c:v>
                  </c:pt>
                  <c:pt idx="50">
                    <c:v>12/25/2013</c:v>
                  </c:pt>
                  <c:pt idx="51">
                    <c:v>12/26/2013</c:v>
                  </c:pt>
                  <c:pt idx="52">
                    <c:v>12/27/2013</c:v>
                  </c:pt>
                  <c:pt idx="53">
                    <c:v>12/28/2013</c:v>
                  </c:pt>
                  <c:pt idx="54">
                    <c:v>12/29/2013</c:v>
                  </c:pt>
                  <c:pt idx="55">
                    <c:v>12/30/2013</c:v>
                  </c:pt>
                  <c:pt idx="56">
                    <c:v>12/31/2013</c:v>
                  </c:pt>
                  <c:pt idx="57">
                    <c:v>1/1/2014</c:v>
                  </c:pt>
                  <c:pt idx="58">
                    <c:v>1/2/2014</c:v>
                  </c:pt>
                  <c:pt idx="59">
                    <c:v>1/3/2014</c:v>
                  </c:pt>
                  <c:pt idx="60">
                    <c:v>1/4/2014</c:v>
                  </c:pt>
                  <c:pt idx="61">
                    <c:v>1/5/2014</c:v>
                  </c:pt>
                  <c:pt idx="62">
                    <c:v>1/6/2014</c:v>
                  </c:pt>
                  <c:pt idx="63">
                    <c:v>1/7/2014</c:v>
                  </c:pt>
                  <c:pt idx="64">
                    <c:v>1/8/2014</c:v>
                  </c:pt>
                  <c:pt idx="65">
                    <c:v>1/9/2014</c:v>
                  </c:pt>
                  <c:pt idx="66">
                    <c:v>1/10/2014</c:v>
                  </c:pt>
                  <c:pt idx="67">
                    <c:v>1/11/2014</c:v>
                  </c:pt>
                  <c:pt idx="68">
                    <c:v>1/12/2014</c:v>
                  </c:pt>
                  <c:pt idx="69">
                    <c:v>1/13/2014</c:v>
                  </c:pt>
                  <c:pt idx="70">
                    <c:v>1/14/2014</c:v>
                  </c:pt>
                  <c:pt idx="71">
                    <c:v>1/15/2014</c:v>
                  </c:pt>
                  <c:pt idx="72">
                    <c:v>1/16/2014</c:v>
                  </c:pt>
                  <c:pt idx="73">
                    <c:v>1/17/2014</c:v>
                  </c:pt>
                  <c:pt idx="74">
                    <c:v>1/18/2014</c:v>
                  </c:pt>
                  <c:pt idx="75">
                    <c:v>1/19/2014</c:v>
                  </c:pt>
                  <c:pt idx="76">
                    <c:v>1/20/2014</c:v>
                  </c:pt>
                  <c:pt idx="77">
                    <c:v>1/21/2014</c:v>
                  </c:pt>
                  <c:pt idx="78">
                    <c:v>1/22/2014</c:v>
                  </c:pt>
                  <c:pt idx="79">
                    <c:v>1/23/2014</c:v>
                  </c:pt>
                  <c:pt idx="80">
                    <c:v>1/24/2014</c:v>
                  </c:pt>
                  <c:pt idx="81">
                    <c:v>1/25/2014</c:v>
                  </c:pt>
                  <c:pt idx="82">
                    <c:v>1/26/2014</c:v>
                  </c:pt>
                  <c:pt idx="83">
                    <c:v>1/27/2014</c:v>
                  </c:pt>
                  <c:pt idx="84">
                    <c:v>1/28/2014</c:v>
                  </c:pt>
                  <c:pt idx="85">
                    <c:v>1/29/2014</c:v>
                  </c:pt>
                  <c:pt idx="86">
                    <c:v>1/30/2014</c:v>
                  </c:pt>
                  <c:pt idx="87">
                    <c:v>1/31/2014</c:v>
                  </c:pt>
                  <c:pt idx="88">
                    <c:v>2/1/2014</c:v>
                  </c:pt>
                  <c:pt idx="89">
                    <c:v>2/2/2014</c:v>
                  </c:pt>
                  <c:pt idx="90">
                    <c:v>2/3/2014</c:v>
                  </c:pt>
                  <c:pt idx="91">
                    <c:v>2/4/2014</c:v>
                  </c:pt>
                  <c:pt idx="92">
                    <c:v>2/5/2014</c:v>
                  </c:pt>
                  <c:pt idx="93">
                    <c:v>2/6/2014</c:v>
                  </c:pt>
                  <c:pt idx="94">
                    <c:v>2/7/2014</c:v>
                  </c:pt>
                  <c:pt idx="95">
                    <c:v>2/8/2014</c:v>
                  </c:pt>
                  <c:pt idx="96">
                    <c:v>2/9/2014</c:v>
                  </c:pt>
                  <c:pt idx="97">
                    <c:v>2/10/2014</c:v>
                  </c:pt>
                  <c:pt idx="98">
                    <c:v>2/11/2014</c:v>
                  </c:pt>
                  <c:pt idx="99">
                    <c:v>2/12/2014</c:v>
                  </c:pt>
                  <c:pt idx="100">
                    <c:v>2/13/2014</c:v>
                  </c:pt>
                  <c:pt idx="101">
                    <c:v>2/14/2014</c:v>
                  </c:pt>
                  <c:pt idx="102">
                    <c:v>2/15/2014</c:v>
                  </c:pt>
                  <c:pt idx="103">
                    <c:v>2/16/2014</c:v>
                  </c:pt>
                  <c:pt idx="104">
                    <c:v>2/17/2014</c:v>
                  </c:pt>
                  <c:pt idx="105">
                    <c:v>2/18/2014</c:v>
                  </c:pt>
                  <c:pt idx="106">
                    <c:v>2/19/2014</c:v>
                  </c:pt>
                  <c:pt idx="107">
                    <c:v>2/20/2014</c:v>
                  </c:pt>
                  <c:pt idx="108">
                    <c:v>2/21/2014</c:v>
                  </c:pt>
                  <c:pt idx="109">
                    <c:v>2/22/2014</c:v>
                  </c:pt>
                  <c:pt idx="110">
                    <c:v>2/23/2014</c:v>
                  </c:pt>
                  <c:pt idx="111">
                    <c:v>2/24/2014</c:v>
                  </c:pt>
                  <c:pt idx="112">
                    <c:v>2/25/2014</c:v>
                  </c:pt>
                  <c:pt idx="113">
                    <c:v>2/26/2014</c:v>
                  </c:pt>
                  <c:pt idx="114">
                    <c:v>2/27/2014</c:v>
                  </c:pt>
                  <c:pt idx="115">
                    <c:v>2/28/2014</c:v>
                  </c:pt>
                  <c:pt idx="116">
                    <c:v>3/1/2014</c:v>
                  </c:pt>
                  <c:pt idx="117">
                    <c:v>3/2/2014</c:v>
                  </c:pt>
                  <c:pt idx="118">
                    <c:v>3/3/2014</c:v>
                  </c:pt>
                  <c:pt idx="119">
                    <c:v>3/4/2014</c:v>
                  </c:pt>
                  <c:pt idx="120">
                    <c:v>3/5/2014</c:v>
                  </c:pt>
                  <c:pt idx="121">
                    <c:v>3/6/2014</c:v>
                  </c:pt>
                  <c:pt idx="122">
                    <c:v>3/7/2014</c:v>
                  </c:pt>
                  <c:pt idx="123">
                    <c:v>3/8/2014</c:v>
                  </c:pt>
                  <c:pt idx="124">
                    <c:v>3/9/2014</c:v>
                  </c:pt>
                  <c:pt idx="125">
                    <c:v>3/10/2014</c:v>
                  </c:pt>
                  <c:pt idx="126">
                    <c:v>3/11/2014</c:v>
                  </c:pt>
                  <c:pt idx="127">
                    <c:v>3/12/2014</c:v>
                  </c:pt>
                  <c:pt idx="128">
                    <c:v>3/13/2014</c:v>
                  </c:pt>
                  <c:pt idx="129">
                    <c:v>3/14/2014</c:v>
                  </c:pt>
                  <c:pt idx="130">
                    <c:v>3/15/2014</c:v>
                  </c:pt>
                  <c:pt idx="131">
                    <c:v>3/16/2014</c:v>
                  </c:pt>
                  <c:pt idx="132">
                    <c:v>3/17/2014</c:v>
                  </c:pt>
                  <c:pt idx="133">
                    <c:v>3/18/2014</c:v>
                  </c:pt>
                  <c:pt idx="134">
                    <c:v>3/19/2014</c:v>
                  </c:pt>
                  <c:pt idx="135">
                    <c:v>3/20/2014</c:v>
                  </c:pt>
                  <c:pt idx="136">
                    <c:v>3/21/2014</c:v>
                  </c:pt>
                  <c:pt idx="137">
                    <c:v>3/22/2014</c:v>
                  </c:pt>
                  <c:pt idx="138">
                    <c:v>3/23/2014</c:v>
                  </c:pt>
                  <c:pt idx="139">
                    <c:v>3/24/2014</c:v>
                  </c:pt>
                  <c:pt idx="140">
                    <c:v>3/25/2014</c:v>
                  </c:pt>
                  <c:pt idx="141">
                    <c:v>3/26/2014</c:v>
                  </c:pt>
                  <c:pt idx="142">
                    <c:v>3/27/2014</c:v>
                  </c:pt>
                  <c:pt idx="143">
                    <c:v>3/28/2014</c:v>
                  </c:pt>
                  <c:pt idx="144">
                    <c:v>3/29/2014</c:v>
                  </c:pt>
                  <c:pt idx="145">
                    <c:v>3/30/2014</c:v>
                  </c:pt>
                  <c:pt idx="146">
                    <c:v>3/31/2014</c:v>
                  </c:pt>
                  <c:pt idx="147">
                    <c:v>4/1/2014</c:v>
                  </c:pt>
                  <c:pt idx="148">
                    <c:v>4/2/2014</c:v>
                  </c:pt>
                  <c:pt idx="149">
                    <c:v>4/3/2014</c:v>
                  </c:pt>
                  <c:pt idx="150">
                    <c:v>4/4/2014</c:v>
                  </c:pt>
                  <c:pt idx="151">
                    <c:v>4/5/2014</c:v>
                  </c:pt>
                  <c:pt idx="152">
                    <c:v>4/6/2014</c:v>
                  </c:pt>
                  <c:pt idx="153">
                    <c:v>4/7/2014</c:v>
                  </c:pt>
                  <c:pt idx="154">
                    <c:v>4/8/2014</c:v>
                  </c:pt>
                  <c:pt idx="155">
                    <c:v>4/9/2014</c:v>
                  </c:pt>
                  <c:pt idx="156">
                    <c:v>4/10/2014</c:v>
                  </c:pt>
                  <c:pt idx="157">
                    <c:v>4/11/2014</c:v>
                  </c:pt>
                  <c:pt idx="158">
                    <c:v>4/12/2014</c:v>
                  </c:pt>
                  <c:pt idx="159">
                    <c:v>4/13/2014</c:v>
                  </c:pt>
                  <c:pt idx="160">
                    <c:v>4/14/2014</c:v>
                  </c:pt>
                  <c:pt idx="161">
                    <c:v>4/15/2014</c:v>
                  </c:pt>
                  <c:pt idx="162">
                    <c:v>4/16/2014</c:v>
                  </c:pt>
                  <c:pt idx="163">
                    <c:v>4/17/2014</c:v>
                  </c:pt>
                  <c:pt idx="164">
                    <c:v>4/18/2014</c:v>
                  </c:pt>
                  <c:pt idx="165">
                    <c:v>4/19/2014</c:v>
                  </c:pt>
                  <c:pt idx="166">
                    <c:v>4/20/2014</c:v>
                  </c:pt>
                  <c:pt idx="167">
                    <c:v>4/21/2014</c:v>
                  </c:pt>
                  <c:pt idx="168">
                    <c:v>4/22/2014</c:v>
                  </c:pt>
                  <c:pt idx="169">
                    <c:v>4/23/2014</c:v>
                  </c:pt>
                  <c:pt idx="170">
                    <c:v>4/24/2014</c:v>
                  </c:pt>
                  <c:pt idx="171">
                    <c:v>4/25/2014</c:v>
                  </c:pt>
                  <c:pt idx="172">
                    <c:v>4/26/2014</c:v>
                  </c:pt>
                  <c:pt idx="173">
                    <c:v>4/27/2014</c:v>
                  </c:pt>
                  <c:pt idx="174">
                    <c:v>4/28/2014</c:v>
                  </c:pt>
                  <c:pt idx="175">
                    <c:v>4/29/2014</c:v>
                  </c:pt>
                  <c:pt idx="176">
                    <c:v>4/30/2014</c:v>
                  </c:pt>
                </c:lvl>
                <c:lvl>
                  <c:pt idx="15">
                    <c:v>DOS</c:v>
                  </c:pt>
                  <c:pt idx="101">
                    <c:v>%GL7</c:v>
                  </c:pt>
                  <c:pt idx="108">
                    <c:v>%GL14</c:v>
                  </c:pt>
                  <c:pt idx="115">
                    <c:v>%GL21</c:v>
                  </c:pt>
                  <c:pt idx="134">
                    <c:v>%GL28</c:v>
                  </c:pt>
                  <c:pt idx="141">
                    <c:v>%GL35</c:v>
                  </c:pt>
                  <c:pt idx="148">
                    <c:v>%GL42</c:v>
                  </c:pt>
                  <c:pt idx="155">
                    <c:v>%GL49</c:v>
                  </c:pt>
                </c:lvl>
              </c:multiLvlStrCache>
            </c:multiLvlStrRef>
          </c:cat>
          <c:val>
            <c:numRef>
              <c:f>'env2'!$E$2:$E$178</c:f>
              <c:numCache>
                <c:formatCode>General</c:formatCode>
                <c:ptCount val="177"/>
                <c:pt idx="0">
                  <c:v>29.6</c:v>
                </c:pt>
                <c:pt idx="1">
                  <c:v>28.4</c:v>
                </c:pt>
                <c:pt idx="2">
                  <c:v>28</c:v>
                </c:pt>
                <c:pt idx="3">
                  <c:v>28.8</c:v>
                </c:pt>
                <c:pt idx="4">
                  <c:v>28.2</c:v>
                </c:pt>
                <c:pt idx="5">
                  <c:v>28.6</c:v>
                </c:pt>
                <c:pt idx="6">
                  <c:v>28.2</c:v>
                </c:pt>
                <c:pt idx="7">
                  <c:v>28.4</c:v>
                </c:pt>
                <c:pt idx="8">
                  <c:v>28.6</c:v>
                </c:pt>
                <c:pt idx="9">
                  <c:v>27.3</c:v>
                </c:pt>
                <c:pt idx="10">
                  <c:v>27.2</c:v>
                </c:pt>
                <c:pt idx="11">
                  <c:v>27.2</c:v>
                </c:pt>
                <c:pt idx="12">
                  <c:v>28.2</c:v>
                </c:pt>
                <c:pt idx="13">
                  <c:v>28.8</c:v>
                </c:pt>
                <c:pt idx="14">
                  <c:v>28.5</c:v>
                </c:pt>
                <c:pt idx="15">
                  <c:v>29.3</c:v>
                </c:pt>
                <c:pt idx="16">
                  <c:v>29.5</c:v>
                </c:pt>
                <c:pt idx="17">
                  <c:v>29.6</c:v>
                </c:pt>
                <c:pt idx="18">
                  <c:v>28.8</c:v>
                </c:pt>
                <c:pt idx="19">
                  <c:v>23.2</c:v>
                </c:pt>
                <c:pt idx="20">
                  <c:v>27.3</c:v>
                </c:pt>
                <c:pt idx="21">
                  <c:v>31</c:v>
                </c:pt>
                <c:pt idx="22">
                  <c:v>30.2</c:v>
                </c:pt>
                <c:pt idx="23">
                  <c:v>29.4</c:v>
                </c:pt>
                <c:pt idx="24">
                  <c:v>27</c:v>
                </c:pt>
                <c:pt idx="25">
                  <c:v>23.4</c:v>
                </c:pt>
                <c:pt idx="26">
                  <c:v>28.4</c:v>
                </c:pt>
                <c:pt idx="27">
                  <c:v>29.7</c:v>
                </c:pt>
                <c:pt idx="28">
                  <c:v>28.5</c:v>
                </c:pt>
                <c:pt idx="29">
                  <c:v>27.8</c:v>
                </c:pt>
                <c:pt idx="30">
                  <c:v>28.5</c:v>
                </c:pt>
                <c:pt idx="31">
                  <c:v>27.7</c:v>
                </c:pt>
                <c:pt idx="32">
                  <c:v>26.6</c:v>
                </c:pt>
                <c:pt idx="33">
                  <c:v>26.6</c:v>
                </c:pt>
                <c:pt idx="34">
                  <c:v>27.7</c:v>
                </c:pt>
                <c:pt idx="35">
                  <c:v>28.4</c:v>
                </c:pt>
                <c:pt idx="36">
                  <c:v>28.8</c:v>
                </c:pt>
                <c:pt idx="37">
                  <c:v>29.3</c:v>
                </c:pt>
                <c:pt idx="38">
                  <c:v>28.4</c:v>
                </c:pt>
                <c:pt idx="39">
                  <c:v>28.8</c:v>
                </c:pt>
                <c:pt idx="40">
                  <c:v>27.8</c:v>
                </c:pt>
                <c:pt idx="41">
                  <c:v>28.8</c:v>
                </c:pt>
                <c:pt idx="42">
                  <c:v>28.4</c:v>
                </c:pt>
                <c:pt idx="43">
                  <c:v>28.2</c:v>
                </c:pt>
                <c:pt idx="44">
                  <c:v>27.3</c:v>
                </c:pt>
                <c:pt idx="45">
                  <c:v>29.4</c:v>
                </c:pt>
                <c:pt idx="46">
                  <c:v>29.2</c:v>
                </c:pt>
                <c:pt idx="47">
                  <c:v>27.6</c:v>
                </c:pt>
                <c:pt idx="48">
                  <c:v>26.6</c:v>
                </c:pt>
                <c:pt idx="49">
                  <c:v>25.8</c:v>
                </c:pt>
                <c:pt idx="50">
                  <c:v>25.8</c:v>
                </c:pt>
                <c:pt idx="51">
                  <c:v>27.2</c:v>
                </c:pt>
                <c:pt idx="52">
                  <c:v>26.4</c:v>
                </c:pt>
                <c:pt idx="53">
                  <c:v>27</c:v>
                </c:pt>
                <c:pt idx="54">
                  <c:v>27.6</c:v>
                </c:pt>
                <c:pt idx="55">
                  <c:v>26.6</c:v>
                </c:pt>
                <c:pt idx="56">
                  <c:v>26</c:v>
                </c:pt>
                <c:pt idx="57">
                  <c:v>27</c:v>
                </c:pt>
                <c:pt idx="58">
                  <c:v>26</c:v>
                </c:pt>
                <c:pt idx="59">
                  <c:v>27.2</c:v>
                </c:pt>
                <c:pt idx="60">
                  <c:v>28.2</c:v>
                </c:pt>
                <c:pt idx="61">
                  <c:v>28.2</c:v>
                </c:pt>
                <c:pt idx="62">
                  <c:v>30.4</c:v>
                </c:pt>
                <c:pt idx="63">
                  <c:v>29.2</c:v>
                </c:pt>
                <c:pt idx="64">
                  <c:v>28.3</c:v>
                </c:pt>
                <c:pt idx="65">
                  <c:v>28.4</c:v>
                </c:pt>
                <c:pt idx="66">
                  <c:v>29.2</c:v>
                </c:pt>
                <c:pt idx="67">
                  <c:v>29.4</c:v>
                </c:pt>
                <c:pt idx="68">
                  <c:v>28.8</c:v>
                </c:pt>
                <c:pt idx="69">
                  <c:v>30.5</c:v>
                </c:pt>
                <c:pt idx="70">
                  <c:v>28.2</c:v>
                </c:pt>
                <c:pt idx="71">
                  <c:v>28.2</c:v>
                </c:pt>
                <c:pt idx="72">
                  <c:v>29.7</c:v>
                </c:pt>
                <c:pt idx="73">
                  <c:v>29.5</c:v>
                </c:pt>
                <c:pt idx="74">
                  <c:v>28.7</c:v>
                </c:pt>
                <c:pt idx="75">
                  <c:v>28</c:v>
                </c:pt>
                <c:pt idx="76">
                  <c:v>28.8</c:v>
                </c:pt>
                <c:pt idx="77">
                  <c:v>29</c:v>
                </c:pt>
                <c:pt idx="78">
                  <c:v>28</c:v>
                </c:pt>
                <c:pt idx="79">
                  <c:v>27.2</c:v>
                </c:pt>
                <c:pt idx="80">
                  <c:v>27.5</c:v>
                </c:pt>
                <c:pt idx="81">
                  <c:v>28.2</c:v>
                </c:pt>
                <c:pt idx="82">
                  <c:v>28.6</c:v>
                </c:pt>
                <c:pt idx="83">
                  <c:v>28.4</c:v>
                </c:pt>
                <c:pt idx="84">
                  <c:v>26.9</c:v>
                </c:pt>
                <c:pt idx="85">
                  <c:v>28.4</c:v>
                </c:pt>
                <c:pt idx="86">
                  <c:v>27.8</c:v>
                </c:pt>
                <c:pt idx="87">
                  <c:v>28</c:v>
                </c:pt>
                <c:pt idx="88">
                  <c:v>28</c:v>
                </c:pt>
                <c:pt idx="89">
                  <c:v>27.1</c:v>
                </c:pt>
                <c:pt idx="90">
                  <c:v>28.2</c:v>
                </c:pt>
                <c:pt idx="91">
                  <c:v>30.3</c:v>
                </c:pt>
                <c:pt idx="92">
                  <c:v>32</c:v>
                </c:pt>
                <c:pt idx="93">
                  <c:v>32.1</c:v>
                </c:pt>
                <c:pt idx="94">
                  <c:v>32</c:v>
                </c:pt>
                <c:pt idx="95">
                  <c:v>32.4</c:v>
                </c:pt>
                <c:pt idx="96">
                  <c:v>32</c:v>
                </c:pt>
                <c:pt idx="97">
                  <c:v>32.4</c:v>
                </c:pt>
                <c:pt idx="98">
                  <c:v>32.700000000000003</c:v>
                </c:pt>
                <c:pt idx="99">
                  <c:v>31.2</c:v>
                </c:pt>
                <c:pt idx="100">
                  <c:v>30.6</c:v>
                </c:pt>
                <c:pt idx="101">
                  <c:v>30.6</c:v>
                </c:pt>
                <c:pt idx="102">
                  <c:v>29.8</c:v>
                </c:pt>
                <c:pt idx="103">
                  <c:v>29.5</c:v>
                </c:pt>
                <c:pt idx="104">
                  <c:v>28</c:v>
                </c:pt>
                <c:pt idx="105">
                  <c:v>28.2</c:v>
                </c:pt>
                <c:pt idx="106">
                  <c:v>29.2</c:v>
                </c:pt>
                <c:pt idx="107">
                  <c:v>30.4</c:v>
                </c:pt>
                <c:pt idx="108">
                  <c:v>31.3</c:v>
                </c:pt>
                <c:pt idx="109">
                  <c:v>30.8</c:v>
                </c:pt>
                <c:pt idx="110">
                  <c:v>31.8</c:v>
                </c:pt>
                <c:pt idx="111">
                  <c:v>30</c:v>
                </c:pt>
                <c:pt idx="112">
                  <c:v>29.2</c:v>
                </c:pt>
                <c:pt idx="113">
                  <c:v>30.4</c:v>
                </c:pt>
                <c:pt idx="114">
                  <c:v>31.4</c:v>
                </c:pt>
                <c:pt idx="115">
                  <c:v>32.299999999999997</c:v>
                </c:pt>
                <c:pt idx="116">
                  <c:v>29.8</c:v>
                </c:pt>
                <c:pt idx="117">
                  <c:v>30</c:v>
                </c:pt>
                <c:pt idx="118">
                  <c:v>28.6</c:v>
                </c:pt>
                <c:pt idx="119">
                  <c:v>28.6</c:v>
                </c:pt>
                <c:pt idx="120">
                  <c:v>27</c:v>
                </c:pt>
                <c:pt idx="121">
                  <c:v>27.3</c:v>
                </c:pt>
                <c:pt idx="122">
                  <c:v>27.3</c:v>
                </c:pt>
                <c:pt idx="123">
                  <c:v>28.8</c:v>
                </c:pt>
                <c:pt idx="124">
                  <c:v>28.4</c:v>
                </c:pt>
                <c:pt idx="125">
                  <c:v>29.4</c:v>
                </c:pt>
                <c:pt idx="126">
                  <c:v>28.2</c:v>
                </c:pt>
                <c:pt idx="127">
                  <c:v>32.5</c:v>
                </c:pt>
                <c:pt idx="128">
                  <c:v>31.4</c:v>
                </c:pt>
                <c:pt idx="129">
                  <c:v>33</c:v>
                </c:pt>
                <c:pt idx="130">
                  <c:v>33.5</c:v>
                </c:pt>
                <c:pt idx="131">
                  <c:v>34.5</c:v>
                </c:pt>
                <c:pt idx="132">
                  <c:v>34.299999999999997</c:v>
                </c:pt>
                <c:pt idx="133">
                  <c:v>35.299999999999997</c:v>
                </c:pt>
                <c:pt idx="134">
                  <c:v>35.799999999999997</c:v>
                </c:pt>
                <c:pt idx="135">
                  <c:v>35.799999999999997</c:v>
                </c:pt>
                <c:pt idx="136">
                  <c:v>36.200000000000003</c:v>
                </c:pt>
                <c:pt idx="137">
                  <c:v>36.799999999999997</c:v>
                </c:pt>
                <c:pt idx="138">
                  <c:v>35.200000000000003</c:v>
                </c:pt>
                <c:pt idx="139">
                  <c:v>36.5</c:v>
                </c:pt>
                <c:pt idx="140">
                  <c:v>36.200000000000003</c:v>
                </c:pt>
                <c:pt idx="141">
                  <c:v>37.200000000000003</c:v>
                </c:pt>
                <c:pt idx="142">
                  <c:v>38.200000000000003</c:v>
                </c:pt>
                <c:pt idx="143">
                  <c:v>37.799999999999997</c:v>
                </c:pt>
                <c:pt idx="144">
                  <c:v>37.799999999999997</c:v>
                </c:pt>
                <c:pt idx="145">
                  <c:v>38</c:v>
                </c:pt>
                <c:pt idx="146">
                  <c:v>38.200000000000003</c:v>
                </c:pt>
                <c:pt idx="147">
                  <c:v>38.6</c:v>
                </c:pt>
                <c:pt idx="148">
                  <c:v>36.6</c:v>
                </c:pt>
                <c:pt idx="149">
                  <c:v>35.6</c:v>
                </c:pt>
                <c:pt idx="150">
                  <c:v>36.799999999999997</c:v>
                </c:pt>
                <c:pt idx="151">
                  <c:v>37.700000000000003</c:v>
                </c:pt>
                <c:pt idx="152">
                  <c:v>38.4</c:v>
                </c:pt>
                <c:pt idx="153">
                  <c:v>38.6</c:v>
                </c:pt>
                <c:pt idx="154">
                  <c:v>39</c:v>
                </c:pt>
                <c:pt idx="155">
                  <c:v>38.799999999999997</c:v>
                </c:pt>
                <c:pt idx="156">
                  <c:v>36.4</c:v>
                </c:pt>
                <c:pt idx="157">
                  <c:v>36</c:v>
                </c:pt>
                <c:pt idx="158">
                  <c:v>36.6</c:v>
                </c:pt>
                <c:pt idx="159">
                  <c:v>37.4</c:v>
                </c:pt>
                <c:pt idx="160">
                  <c:v>37.200000000000003</c:v>
                </c:pt>
                <c:pt idx="161">
                  <c:v>36.4</c:v>
                </c:pt>
                <c:pt idx="162">
                  <c:v>35.5</c:v>
                </c:pt>
                <c:pt idx="163">
                  <c:v>36.6</c:v>
                </c:pt>
                <c:pt idx="164">
                  <c:v>37.4</c:v>
                </c:pt>
                <c:pt idx="165">
                  <c:v>33.200000000000003</c:v>
                </c:pt>
                <c:pt idx="166">
                  <c:v>36</c:v>
                </c:pt>
                <c:pt idx="167">
                  <c:v>36.799999999999997</c:v>
                </c:pt>
                <c:pt idx="168">
                  <c:v>36.299999999999997</c:v>
                </c:pt>
                <c:pt idx="169">
                  <c:v>36.799999999999997</c:v>
                </c:pt>
                <c:pt idx="170">
                  <c:v>37.200000000000003</c:v>
                </c:pt>
                <c:pt idx="171">
                  <c:v>38.200000000000003</c:v>
                </c:pt>
                <c:pt idx="172">
                  <c:v>37</c:v>
                </c:pt>
                <c:pt idx="173">
                  <c:v>38.200000000000003</c:v>
                </c:pt>
                <c:pt idx="174">
                  <c:v>37.700000000000003</c:v>
                </c:pt>
                <c:pt idx="175">
                  <c:v>38.200000000000003</c:v>
                </c:pt>
                <c:pt idx="176">
                  <c:v>37.79999999999999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747-494E-8B86-A589F440B1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1122704"/>
        <c:axId val="451128976"/>
      </c:lineChart>
      <c:catAx>
        <c:axId val="3527519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52752744"/>
        <c:crosses val="autoZero"/>
        <c:auto val="1"/>
        <c:lblAlgn val="ctr"/>
        <c:lblOffset val="100"/>
        <c:noMultiLvlLbl val="0"/>
      </c:catAx>
      <c:valAx>
        <c:axId val="35275274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in</a:t>
                </a:r>
                <a:r>
                  <a:rPr lang="en-US" sz="1100" b="0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all</a:t>
                </a:r>
                <a:endParaRPr lang="en-US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352751960"/>
        <c:crosses val="autoZero"/>
        <c:crossBetween val="between"/>
      </c:valAx>
      <c:valAx>
        <c:axId val="45112897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crossAx val="451122704"/>
        <c:crosses val="max"/>
        <c:crossBetween val="between"/>
      </c:valAx>
      <c:catAx>
        <c:axId val="4511227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51128976"/>
        <c:crosses val="autoZero"/>
        <c:auto val="1"/>
        <c:lblAlgn val="ctr"/>
        <c:lblOffset val="100"/>
        <c:noMultiLvlLbl val="0"/>
      </c:catAx>
    </c:plotArea>
    <c:legend>
      <c:legendPos val="r"/>
      <c:layout>
        <c:manualLayout>
          <c:xMode val="edge"/>
          <c:yMode val="edge"/>
          <c:x val="0.88173060098256939"/>
          <c:y val="8.8383838383838384E-2"/>
          <c:w val="0.10402438477241625"/>
          <c:h val="0.182655690765927"/>
        </c:manualLayout>
      </c:layout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30740669611493"/>
          <c:y val="0.19364743809197837"/>
          <c:w val="0.73146612247803999"/>
          <c:h val="0.79485449564706068"/>
        </c:manualLayout>
      </c:layout>
      <c:ofPieChart>
        <c:ofPieType val="bar"/>
        <c:varyColors val="1"/>
        <c:ser>
          <c:idx val="0"/>
          <c:order val="0"/>
          <c:dPt>
            <c:idx val="0"/>
            <c:bubble3D val="0"/>
            <c:spPr>
              <a:solidFill>
                <a:srgbClr val="00FF00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3B2-4DCF-9469-532B571DD633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3B2-4DCF-9469-532B571DD633}"/>
              </c:ext>
            </c:extLst>
          </c:dPt>
          <c:dPt>
            <c:idx val="2"/>
            <c:bubble3D val="0"/>
            <c:spPr>
              <a:solidFill>
                <a:srgbClr val="009900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3B2-4DCF-9469-532B571DD633}"/>
              </c:ext>
            </c:extLst>
          </c:dPt>
          <c:dPt>
            <c:idx val="3"/>
            <c:bubble3D val="0"/>
            <c:spPr>
              <a:solidFill>
                <a:srgbClr val="FF6699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D3B2-4DCF-9469-532B571DD633}"/>
              </c:ext>
            </c:extLst>
          </c:dPt>
          <c:dPt>
            <c:idx val="4"/>
            <c:bubble3D val="0"/>
            <c:spPr>
              <a:solidFill>
                <a:srgbClr val="00B0F0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D3B2-4DCF-9469-532B571DD633}"/>
              </c:ext>
            </c:extLst>
          </c:dPt>
          <c:dPt>
            <c:idx val="5"/>
            <c:bubble3D val="0"/>
            <c:spPr>
              <a:solidFill>
                <a:srgbClr val="FFFF00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D3B2-4DCF-9469-532B571DD633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D3B2-4DCF-9469-532B571DD633}"/>
              </c:ext>
            </c:extLst>
          </c:dPt>
          <c:dPt>
            <c:idx val="7"/>
            <c:bubble3D val="0"/>
            <c:spPr>
              <a:solidFill>
                <a:schemeClr val="accent4">
                  <a:lumMod val="75000"/>
                </a:schemeClr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D3B2-4DCF-9469-532B571DD633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D3B2-4DCF-9469-532B571DD633}"/>
              </c:ext>
            </c:extLst>
          </c:dPt>
          <c:dLbls>
            <c:dLbl>
              <c:idx val="0"/>
              <c:layout>
                <c:manualLayout>
                  <c:x val="1.1915363284247363E-2"/>
                  <c:y val="-9.5943060538287411E-2"/>
                </c:manualLayout>
              </c:layout>
              <c:tx>
                <c:rich>
                  <a:bodyPr/>
                  <a:lstStyle/>
                  <a:p>
                    <a:r>
                      <a:rPr lang="en-US" b="1" dirty="0"/>
                      <a:t>I</a:t>
                    </a:r>
                    <a:r>
                      <a:rPr lang="en-US" dirty="0"/>
                      <a:t>NTERGENIC</a:t>
                    </a:r>
                    <a:r>
                      <a:rPr lang="en-US" baseline="0" dirty="0"/>
                      <a:t> </a:t>
                    </a:r>
                  </a:p>
                  <a:p>
                    <a:r>
                      <a:rPr lang="en-US" baseline="0" dirty="0"/>
                      <a:t>(</a:t>
                    </a:r>
                    <a:r>
                      <a:rPr lang="en-US" dirty="0"/>
                      <a:t>47.72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b="1" dirty="0"/>
                      <a:t>E</a:t>
                    </a:r>
                    <a:r>
                      <a:rPr lang="en-US" dirty="0"/>
                      <a:t>XON</a:t>
                    </a:r>
                    <a:r>
                      <a:rPr lang="en-US" baseline="0" dirty="0"/>
                      <a:t> </a:t>
                    </a:r>
                  </a:p>
                  <a:p>
                    <a:r>
                      <a:rPr lang="en-US" baseline="0" dirty="0"/>
                      <a:t>(</a:t>
                    </a:r>
                    <a:r>
                      <a:rPr lang="en-US" dirty="0"/>
                      <a:t>24.16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b="1" dirty="0"/>
                      <a:t>I</a:t>
                    </a:r>
                    <a:r>
                      <a:rPr lang="en-US" dirty="0"/>
                      <a:t>NTRON (11.32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5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2.5162441585045792E-3"/>
                  <c:y val="-0.17270883259157899"/>
                </c:manualLayout>
              </c:layout>
              <c:tx>
                <c:rich>
                  <a:bodyPr/>
                  <a:lstStyle/>
                  <a:p>
                    <a:r>
                      <a:rPr lang="en-US" b="1" dirty="0"/>
                      <a:t>U</a:t>
                    </a:r>
                    <a:r>
                      <a:rPr lang="en-US" dirty="0"/>
                      <a:t>PSTREAM </a:t>
                    </a:r>
                  </a:p>
                  <a:p>
                    <a:r>
                      <a:rPr lang="en-US" dirty="0"/>
                      <a:t>(8.41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7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b="1" dirty="0" smtClean="0"/>
                      <a:t>D</a:t>
                    </a:r>
                    <a:r>
                      <a:rPr lang="en-US" dirty="0" smtClean="0"/>
                      <a:t>OWNSTREAM</a:t>
                    </a:r>
                    <a:r>
                      <a:rPr lang="en-US" baseline="0" dirty="0" smtClean="0"/>
                      <a:t> </a:t>
                    </a:r>
                  </a:p>
                  <a:p>
                    <a:r>
                      <a:rPr lang="en-US" baseline="0" dirty="0" smtClean="0"/>
                      <a:t>(</a:t>
                    </a:r>
                    <a:r>
                      <a:rPr lang="en-US" dirty="0" smtClean="0"/>
                      <a:t>3.31%)</a:t>
                    </a:r>
                    <a:endParaRPr lang="en-US" dirty="0"/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9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0.13917133963775619"/>
                  <c:y val="-0.2709540111833848"/>
                </c:manualLayout>
              </c:layout>
              <c:tx>
                <c:rich>
                  <a:bodyPr/>
                  <a:lstStyle/>
                  <a:p>
                    <a:r>
                      <a:rPr lang="en-US" b="1" dirty="0"/>
                      <a:t>5</a:t>
                    </a:r>
                    <a:r>
                      <a:rPr lang="en-US" dirty="0"/>
                      <a:t> ˈUTR</a:t>
                    </a:r>
                    <a:r>
                      <a:rPr lang="en-US" baseline="0" dirty="0"/>
                      <a:t> </a:t>
                    </a:r>
                    <a:endParaRPr lang="en-US" baseline="0" dirty="0" smtClean="0"/>
                  </a:p>
                  <a:p>
                    <a:r>
                      <a:rPr lang="en-US" baseline="0" dirty="0" smtClean="0"/>
                      <a:t>(</a:t>
                    </a:r>
                    <a:r>
                      <a:rPr lang="en-US" dirty="0" smtClean="0"/>
                      <a:t>2.32%)</a:t>
                    </a:r>
                    <a:endParaRPr lang="en-US" dirty="0"/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B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b="1" dirty="0"/>
                      <a:t>3</a:t>
                    </a:r>
                    <a:r>
                      <a:rPr lang="en-US" dirty="0"/>
                      <a:t> ˈUTR</a:t>
                    </a:r>
                  </a:p>
                  <a:p>
                    <a:r>
                      <a:rPr lang="en-US" dirty="0"/>
                      <a:t> (2.25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D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2.0521253440880871E-3"/>
                  <c:y val="-3.985507246376814E-2"/>
                </c:manualLayout>
              </c:layout>
              <c:tx>
                <c:rich>
                  <a:bodyPr/>
                  <a:lstStyle/>
                  <a:p>
                    <a:r>
                      <a:rPr lang="en-US" b="1" dirty="0"/>
                      <a:t>S</a:t>
                    </a:r>
                    <a:r>
                      <a:rPr lang="en-US" dirty="0"/>
                      <a:t>PLICE </a:t>
                    </a:r>
                    <a:r>
                      <a:rPr lang="en-US" dirty="0" smtClean="0"/>
                      <a:t>SITE</a:t>
                    </a:r>
                  </a:p>
                  <a:p>
                    <a:r>
                      <a:rPr lang="en-US" dirty="0" smtClean="0"/>
                      <a:t> </a:t>
                    </a:r>
                    <a:r>
                      <a:rPr lang="en-US" dirty="0"/>
                      <a:t>REGION (0.26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F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6.7750677506775324E-3"/>
                  <c:y val="3.2608695652174072E-2"/>
                </c:manualLayout>
              </c:layout>
              <c:tx>
                <c:rich>
                  <a:bodyPr/>
                  <a:lstStyle/>
                  <a:p>
                    <a:r>
                      <a:rPr lang="en-US" b="1" dirty="0"/>
                      <a:t>S</a:t>
                    </a:r>
                    <a:r>
                      <a:rPr lang="en-US" dirty="0"/>
                      <a:t>TART </a:t>
                    </a:r>
                    <a:endParaRPr lang="en-US" dirty="0" smtClean="0"/>
                  </a:p>
                  <a:p>
                    <a:r>
                      <a:rPr lang="en-US" dirty="0" smtClean="0"/>
                      <a:t>GAINED</a:t>
                    </a:r>
                    <a:r>
                      <a:rPr lang="en-US" baseline="0" dirty="0" smtClean="0"/>
                      <a:t> </a:t>
                    </a:r>
                    <a:r>
                      <a:rPr lang="en-US" baseline="0" dirty="0"/>
                      <a:t>(</a:t>
                    </a:r>
                    <a:r>
                      <a:rPr lang="en-US" dirty="0"/>
                      <a:t>0.26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11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/>
              <c:tx>
                <c:rich>
                  <a:bodyPr/>
                  <a:lstStyle/>
                  <a:p>
                    <a:r>
                      <a:rPr lang="en-US" b="1" dirty="0"/>
                      <a:t>O</a:t>
                    </a:r>
                    <a:r>
                      <a:rPr lang="en-US" dirty="0"/>
                      <a:t>ther</a:t>
                    </a:r>
                  </a:p>
                  <a:p>
                    <a:r>
                      <a:rPr lang="en-US" dirty="0"/>
                      <a:t>( 2.78%)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12-D3B2-4DCF-9469-532B571DD63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b="1"/>
                </a:pPr>
                <a:endParaRPr lang="en-US"/>
              </a:p>
            </c:txPr>
            <c:dLblPos val="bestFit"/>
            <c:showLegendKey val="0"/>
            <c:showVal val="1"/>
            <c:showCatName val="1"/>
            <c:showSerName val="0"/>
            <c:showPercent val="0"/>
            <c:showBubbleSize val="0"/>
            <c:showLeaderLines val="1"/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SNPeff_SNPcount!$B$3:$B$11</c:f>
              <c:strCache>
                <c:ptCount val="9"/>
                <c:pt idx="0">
                  <c:v>INTERGENIC</c:v>
                </c:pt>
                <c:pt idx="1">
                  <c:v>EXON</c:v>
                </c:pt>
                <c:pt idx="2">
                  <c:v>INTRON </c:v>
                </c:pt>
                <c:pt idx="3">
                  <c:v>UPSTREAM </c:v>
                </c:pt>
                <c:pt idx="4">
                  <c:v>DOWNSTREAM</c:v>
                </c:pt>
                <c:pt idx="5">
                  <c:v>5 ˈUTR</c:v>
                </c:pt>
                <c:pt idx="6">
                  <c:v>3 ˈUTR</c:v>
                </c:pt>
                <c:pt idx="7">
                  <c:v>SPLICE SITE REGION</c:v>
                </c:pt>
                <c:pt idx="8">
                  <c:v>START GAINED</c:v>
                </c:pt>
              </c:strCache>
            </c:strRef>
          </c:cat>
          <c:val>
            <c:numRef>
              <c:f>SNPeff_SNPcount!$C$3:$C$11</c:f>
              <c:numCache>
                <c:formatCode>0.00</c:formatCode>
                <c:ptCount val="9"/>
                <c:pt idx="0">
                  <c:v>47.716743878226325</c:v>
                </c:pt>
                <c:pt idx="1">
                  <c:v>24.156187954996735</c:v>
                </c:pt>
                <c:pt idx="2">
                  <c:v>11.317008603573791</c:v>
                </c:pt>
                <c:pt idx="3">
                  <c:v>8.4050297816015789</c:v>
                </c:pt>
                <c:pt idx="4">
                  <c:v>3.309066843150223</c:v>
                </c:pt>
                <c:pt idx="5">
                  <c:v>2.3163467902051567</c:v>
                </c:pt>
                <c:pt idx="6">
                  <c:v>2.2501654533421576</c:v>
                </c:pt>
                <c:pt idx="7">
                  <c:v>0.26472534745201853</c:v>
                </c:pt>
                <c:pt idx="8">
                  <c:v>0.264725347452018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3-D3B2-4DCF-9469-532B571DD633}"/>
            </c:ext>
          </c:extLst>
        </c:ser>
        <c:dLbls>
          <c:showLegendKey val="0"/>
          <c:showVal val="1"/>
          <c:showCatName val="1"/>
          <c:showSerName val="0"/>
          <c:showPercent val="0"/>
          <c:showBubbleSize val="0"/>
          <c:showLeaderLines val="1"/>
        </c:dLbls>
        <c:gapWidth val="100"/>
        <c:secondPieSize val="75"/>
        <c:serLines>
          <c:spPr>
            <a:ln w="28575"/>
          </c:spPr>
        </c:serLines>
      </c:ofPieChart>
    </c:plotArea>
    <c:legend>
      <c:legendPos val="l"/>
      <c:layout>
        <c:manualLayout>
          <c:xMode val="edge"/>
          <c:yMode val="edge"/>
          <c:x val="1.016260162601626E-2"/>
          <c:y val="0.2379028300810225"/>
          <c:w val="0.19171321191558371"/>
          <c:h val="0.5531795617939061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200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tic distance </a:t>
            </a:r>
            <a:r>
              <a:rPr lang="en-US" sz="1200" b="0" i="1" u="none" strike="noStrike" baseline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200" b="0" i="0" u="none" strike="noStrik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ysical distance </a:t>
            </a:r>
            <a:endParaRPr lang="en-US" sz="12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2627920834220194"/>
          <c:y val="6.986901164919175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537418399623221"/>
          <c:y val="6.3321651267579979E-2"/>
          <c:w val="0.82848795342890003"/>
          <c:h val="0.79389862394368971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gradFill>
                <a:gsLst>
                  <a:gs pos="0">
                    <a:srgbClr val="000000"/>
                  </a:gs>
                  <a:gs pos="20000">
                    <a:srgbClr val="000040"/>
                  </a:gs>
                  <a:gs pos="50000">
                    <a:srgbClr val="400040"/>
                  </a:gs>
                  <a:gs pos="75000">
                    <a:srgbClr val="8F0040"/>
                  </a:gs>
                  <a:gs pos="89999">
                    <a:srgbClr val="F27300"/>
                  </a:gs>
                  <a:gs pos="100000">
                    <a:srgbClr val="FFBF00"/>
                  </a:gs>
                </a:gsLst>
                <a:lin ang="5400000" scaled="0"/>
              </a:gradFill>
              <a:ln>
                <a:gradFill>
                  <a:gsLst>
                    <a:gs pos="0">
                      <a:srgbClr val="000082"/>
                    </a:gs>
                    <a:gs pos="30000">
                      <a:srgbClr val="66008F"/>
                    </a:gs>
                    <a:gs pos="64999">
                      <a:srgbClr val="BA0066"/>
                    </a:gs>
                    <a:gs pos="89999">
                      <a:srgbClr val="FF0000"/>
                    </a:gs>
                    <a:gs pos="100000">
                      <a:srgbClr val="FF8200"/>
                    </a:gs>
                  </a:gsLst>
                  <a:lin ang="5400000" scaled="0"/>
                </a:gradFill>
              </a:ln>
              <a:scene3d>
                <a:camera prst="orthographicFront"/>
                <a:lightRig rig="threePt" dir="t"/>
              </a:scene3d>
              <a:sp3d>
                <a:bevelB/>
              </a:sp3d>
            </c:spPr>
          </c:marker>
          <c:xVal>
            <c:numRef>
              <c:f>'phy vs gendist'!$D$4:$D$268</c:f>
              <c:numCache>
                <c:formatCode>General</c:formatCode>
                <c:ptCount val="265"/>
                <c:pt idx="0">
                  <c:v>48719070</c:v>
                </c:pt>
                <c:pt idx="1">
                  <c:v>45832539</c:v>
                </c:pt>
                <c:pt idx="2">
                  <c:v>48255426</c:v>
                </c:pt>
                <c:pt idx="3">
                  <c:v>45924600</c:v>
                </c:pt>
                <c:pt idx="4">
                  <c:v>49764198</c:v>
                </c:pt>
                <c:pt idx="5">
                  <c:v>48780999</c:v>
                </c:pt>
                <c:pt idx="6">
                  <c:v>48781003</c:v>
                </c:pt>
                <c:pt idx="7">
                  <c:v>48098678</c:v>
                </c:pt>
                <c:pt idx="8">
                  <c:v>45991208</c:v>
                </c:pt>
                <c:pt idx="9">
                  <c:v>48098791</c:v>
                </c:pt>
                <c:pt idx="10">
                  <c:v>50809263</c:v>
                </c:pt>
                <c:pt idx="11">
                  <c:v>48087353</c:v>
                </c:pt>
                <c:pt idx="12">
                  <c:v>51699119</c:v>
                </c:pt>
                <c:pt idx="13">
                  <c:v>48098807</c:v>
                </c:pt>
                <c:pt idx="14">
                  <c:v>48098802</c:v>
                </c:pt>
                <c:pt idx="15">
                  <c:v>49085931</c:v>
                </c:pt>
                <c:pt idx="16">
                  <c:v>51065106</c:v>
                </c:pt>
                <c:pt idx="17">
                  <c:v>49095753</c:v>
                </c:pt>
                <c:pt idx="18">
                  <c:v>50809289</c:v>
                </c:pt>
                <c:pt idx="19">
                  <c:v>45235333</c:v>
                </c:pt>
                <c:pt idx="20">
                  <c:v>46553315</c:v>
                </c:pt>
                <c:pt idx="21">
                  <c:v>45695389</c:v>
                </c:pt>
                <c:pt idx="22">
                  <c:v>51934952</c:v>
                </c:pt>
                <c:pt idx="23">
                  <c:v>48076362</c:v>
                </c:pt>
                <c:pt idx="24">
                  <c:v>47137453</c:v>
                </c:pt>
                <c:pt idx="25">
                  <c:v>50809328</c:v>
                </c:pt>
                <c:pt idx="26">
                  <c:v>48076342</c:v>
                </c:pt>
                <c:pt idx="27">
                  <c:v>48014895</c:v>
                </c:pt>
                <c:pt idx="28">
                  <c:v>51263932</c:v>
                </c:pt>
                <c:pt idx="29">
                  <c:v>47939440</c:v>
                </c:pt>
                <c:pt idx="30">
                  <c:v>50235747</c:v>
                </c:pt>
                <c:pt idx="31">
                  <c:v>50452521</c:v>
                </c:pt>
                <c:pt idx="32">
                  <c:v>50093128</c:v>
                </c:pt>
                <c:pt idx="33">
                  <c:v>50093129</c:v>
                </c:pt>
                <c:pt idx="34">
                  <c:v>49632608</c:v>
                </c:pt>
                <c:pt idx="35">
                  <c:v>50734011</c:v>
                </c:pt>
                <c:pt idx="36">
                  <c:v>49672890</c:v>
                </c:pt>
                <c:pt idx="37">
                  <c:v>48938062</c:v>
                </c:pt>
                <c:pt idx="38">
                  <c:v>49288320</c:v>
                </c:pt>
                <c:pt idx="39">
                  <c:v>48069066</c:v>
                </c:pt>
                <c:pt idx="40">
                  <c:v>51071502</c:v>
                </c:pt>
                <c:pt idx="41">
                  <c:v>51228412</c:v>
                </c:pt>
                <c:pt idx="42">
                  <c:v>52042465</c:v>
                </c:pt>
                <c:pt idx="43">
                  <c:v>52676228</c:v>
                </c:pt>
                <c:pt idx="44">
                  <c:v>51224387</c:v>
                </c:pt>
                <c:pt idx="45">
                  <c:v>52036901</c:v>
                </c:pt>
                <c:pt idx="46">
                  <c:v>52677221</c:v>
                </c:pt>
                <c:pt idx="47">
                  <c:v>52676281</c:v>
                </c:pt>
                <c:pt idx="48">
                  <c:v>53262363</c:v>
                </c:pt>
                <c:pt idx="49">
                  <c:v>50972176</c:v>
                </c:pt>
                <c:pt idx="50">
                  <c:v>51919897</c:v>
                </c:pt>
                <c:pt idx="51">
                  <c:v>52853071</c:v>
                </c:pt>
                <c:pt idx="52">
                  <c:v>52781712</c:v>
                </c:pt>
                <c:pt idx="53">
                  <c:v>52784725</c:v>
                </c:pt>
                <c:pt idx="54">
                  <c:v>46230564</c:v>
                </c:pt>
                <c:pt idx="55">
                  <c:v>50121434</c:v>
                </c:pt>
                <c:pt idx="56">
                  <c:v>54859431</c:v>
                </c:pt>
                <c:pt idx="57">
                  <c:v>54859409</c:v>
                </c:pt>
                <c:pt idx="58">
                  <c:v>50890593</c:v>
                </c:pt>
                <c:pt idx="59">
                  <c:v>53682073</c:v>
                </c:pt>
                <c:pt idx="60">
                  <c:v>50140543</c:v>
                </c:pt>
                <c:pt idx="61">
                  <c:v>53160198</c:v>
                </c:pt>
                <c:pt idx="62">
                  <c:v>53834366</c:v>
                </c:pt>
                <c:pt idx="63">
                  <c:v>52675727</c:v>
                </c:pt>
                <c:pt idx="64">
                  <c:v>53058516</c:v>
                </c:pt>
                <c:pt idx="65">
                  <c:v>54269620</c:v>
                </c:pt>
                <c:pt idx="66">
                  <c:v>45646835</c:v>
                </c:pt>
                <c:pt idx="67">
                  <c:v>52673863</c:v>
                </c:pt>
                <c:pt idx="68">
                  <c:v>49366136</c:v>
                </c:pt>
                <c:pt idx="69">
                  <c:v>53714284</c:v>
                </c:pt>
                <c:pt idx="70">
                  <c:v>54185069</c:v>
                </c:pt>
                <c:pt idx="71">
                  <c:v>52812930</c:v>
                </c:pt>
                <c:pt idx="72">
                  <c:v>53855394</c:v>
                </c:pt>
                <c:pt idx="73">
                  <c:v>50232566</c:v>
                </c:pt>
                <c:pt idx="74">
                  <c:v>50232568</c:v>
                </c:pt>
                <c:pt idx="75">
                  <c:v>53544398</c:v>
                </c:pt>
                <c:pt idx="76">
                  <c:v>52700141</c:v>
                </c:pt>
                <c:pt idx="77">
                  <c:v>52940776</c:v>
                </c:pt>
                <c:pt idx="78">
                  <c:v>54877607</c:v>
                </c:pt>
                <c:pt idx="79">
                  <c:v>53576112</c:v>
                </c:pt>
                <c:pt idx="80">
                  <c:v>54081973</c:v>
                </c:pt>
                <c:pt idx="81">
                  <c:v>54507175</c:v>
                </c:pt>
                <c:pt idx="82">
                  <c:v>54532995</c:v>
                </c:pt>
                <c:pt idx="83">
                  <c:v>54585199</c:v>
                </c:pt>
                <c:pt idx="84">
                  <c:v>54535306</c:v>
                </c:pt>
                <c:pt idx="85">
                  <c:v>54185546</c:v>
                </c:pt>
                <c:pt idx="86">
                  <c:v>54185539</c:v>
                </c:pt>
                <c:pt idx="87">
                  <c:v>54185186</c:v>
                </c:pt>
                <c:pt idx="88">
                  <c:v>54966382</c:v>
                </c:pt>
                <c:pt idx="89">
                  <c:v>54974701</c:v>
                </c:pt>
                <c:pt idx="90">
                  <c:v>54247479</c:v>
                </c:pt>
                <c:pt idx="91">
                  <c:v>54535502</c:v>
                </c:pt>
                <c:pt idx="92">
                  <c:v>53681243</c:v>
                </c:pt>
                <c:pt idx="93">
                  <c:v>54527903</c:v>
                </c:pt>
                <c:pt idx="94">
                  <c:v>54535745</c:v>
                </c:pt>
                <c:pt idx="95">
                  <c:v>54535807</c:v>
                </c:pt>
                <c:pt idx="96">
                  <c:v>55051409</c:v>
                </c:pt>
                <c:pt idx="97">
                  <c:v>54584527</c:v>
                </c:pt>
                <c:pt idx="98">
                  <c:v>54877733</c:v>
                </c:pt>
                <c:pt idx="99">
                  <c:v>55016723</c:v>
                </c:pt>
                <c:pt idx="100">
                  <c:v>54223864</c:v>
                </c:pt>
                <c:pt idx="101">
                  <c:v>54185408</c:v>
                </c:pt>
                <c:pt idx="102">
                  <c:v>54184947</c:v>
                </c:pt>
                <c:pt idx="103">
                  <c:v>54185417</c:v>
                </c:pt>
                <c:pt idx="104">
                  <c:v>55071264</c:v>
                </c:pt>
                <c:pt idx="105">
                  <c:v>54632304</c:v>
                </c:pt>
                <c:pt idx="106">
                  <c:v>54187184</c:v>
                </c:pt>
                <c:pt idx="107">
                  <c:v>54187185</c:v>
                </c:pt>
                <c:pt idx="108">
                  <c:v>55283533</c:v>
                </c:pt>
                <c:pt idx="109">
                  <c:v>55370553</c:v>
                </c:pt>
                <c:pt idx="110">
                  <c:v>55387439</c:v>
                </c:pt>
                <c:pt idx="111">
                  <c:v>55177860</c:v>
                </c:pt>
                <c:pt idx="112">
                  <c:v>55747507</c:v>
                </c:pt>
                <c:pt idx="113">
                  <c:v>55599913</c:v>
                </c:pt>
                <c:pt idx="114">
                  <c:v>55600708</c:v>
                </c:pt>
                <c:pt idx="115">
                  <c:v>55376713</c:v>
                </c:pt>
                <c:pt idx="116">
                  <c:v>56158623</c:v>
                </c:pt>
                <c:pt idx="117">
                  <c:v>55669377</c:v>
                </c:pt>
                <c:pt idx="118">
                  <c:v>55649047</c:v>
                </c:pt>
                <c:pt idx="119">
                  <c:v>56155818</c:v>
                </c:pt>
                <c:pt idx="120">
                  <c:v>55747741</c:v>
                </c:pt>
                <c:pt idx="121">
                  <c:v>55473978</c:v>
                </c:pt>
                <c:pt idx="122">
                  <c:v>56050653</c:v>
                </c:pt>
                <c:pt idx="123">
                  <c:v>56252649</c:v>
                </c:pt>
                <c:pt idx="124">
                  <c:v>56350371</c:v>
                </c:pt>
                <c:pt idx="125">
                  <c:v>56093654</c:v>
                </c:pt>
                <c:pt idx="126">
                  <c:v>56393810</c:v>
                </c:pt>
                <c:pt idx="127">
                  <c:v>56381792</c:v>
                </c:pt>
                <c:pt idx="128">
                  <c:v>56249651</c:v>
                </c:pt>
                <c:pt idx="129">
                  <c:v>56207658</c:v>
                </c:pt>
                <c:pt idx="130">
                  <c:v>56207637</c:v>
                </c:pt>
                <c:pt idx="131">
                  <c:v>56381721</c:v>
                </c:pt>
                <c:pt idx="132">
                  <c:v>56490707</c:v>
                </c:pt>
                <c:pt idx="133">
                  <c:v>56217191</c:v>
                </c:pt>
                <c:pt idx="134">
                  <c:v>56216248</c:v>
                </c:pt>
                <c:pt idx="135">
                  <c:v>56205739</c:v>
                </c:pt>
                <c:pt idx="136">
                  <c:v>56433597</c:v>
                </c:pt>
                <c:pt idx="137">
                  <c:v>56730378</c:v>
                </c:pt>
                <c:pt idx="138">
                  <c:v>56730380</c:v>
                </c:pt>
                <c:pt idx="139">
                  <c:v>56730384</c:v>
                </c:pt>
                <c:pt idx="140">
                  <c:v>56659463</c:v>
                </c:pt>
                <c:pt idx="141">
                  <c:v>56834308</c:v>
                </c:pt>
                <c:pt idx="142">
                  <c:v>56249757</c:v>
                </c:pt>
                <c:pt idx="143">
                  <c:v>56047792</c:v>
                </c:pt>
                <c:pt idx="144">
                  <c:v>56595416</c:v>
                </c:pt>
                <c:pt idx="145">
                  <c:v>57403166</c:v>
                </c:pt>
                <c:pt idx="146">
                  <c:v>57341007</c:v>
                </c:pt>
                <c:pt idx="147">
                  <c:v>57331278</c:v>
                </c:pt>
                <c:pt idx="148">
                  <c:v>57145296</c:v>
                </c:pt>
                <c:pt idx="149">
                  <c:v>57552456</c:v>
                </c:pt>
                <c:pt idx="150">
                  <c:v>57331300</c:v>
                </c:pt>
                <c:pt idx="151">
                  <c:v>57331385</c:v>
                </c:pt>
                <c:pt idx="152">
                  <c:v>57122482</c:v>
                </c:pt>
                <c:pt idx="153">
                  <c:v>57088032</c:v>
                </c:pt>
                <c:pt idx="154">
                  <c:v>57547037</c:v>
                </c:pt>
                <c:pt idx="155">
                  <c:v>57547066</c:v>
                </c:pt>
                <c:pt idx="156">
                  <c:v>57400347</c:v>
                </c:pt>
                <c:pt idx="157">
                  <c:v>58436230</c:v>
                </c:pt>
                <c:pt idx="158">
                  <c:v>57552719</c:v>
                </c:pt>
                <c:pt idx="159">
                  <c:v>57549720</c:v>
                </c:pt>
                <c:pt idx="160">
                  <c:v>57248800</c:v>
                </c:pt>
                <c:pt idx="161">
                  <c:v>57432493</c:v>
                </c:pt>
                <c:pt idx="162">
                  <c:v>57453669</c:v>
                </c:pt>
                <c:pt idx="163">
                  <c:v>57522978</c:v>
                </c:pt>
                <c:pt idx="164">
                  <c:v>58640688</c:v>
                </c:pt>
                <c:pt idx="165">
                  <c:v>58356424</c:v>
                </c:pt>
                <c:pt idx="166">
                  <c:v>58022779</c:v>
                </c:pt>
                <c:pt idx="167">
                  <c:v>58342553</c:v>
                </c:pt>
                <c:pt idx="168">
                  <c:v>58311699</c:v>
                </c:pt>
                <c:pt idx="169">
                  <c:v>58245122</c:v>
                </c:pt>
                <c:pt idx="170">
                  <c:v>58310536</c:v>
                </c:pt>
                <c:pt idx="171">
                  <c:v>58490384</c:v>
                </c:pt>
                <c:pt idx="172">
                  <c:v>58991881</c:v>
                </c:pt>
                <c:pt idx="173">
                  <c:v>58831404</c:v>
                </c:pt>
                <c:pt idx="174">
                  <c:v>58460662</c:v>
                </c:pt>
                <c:pt idx="175">
                  <c:v>58357039</c:v>
                </c:pt>
                <c:pt idx="176">
                  <c:v>58489833</c:v>
                </c:pt>
                <c:pt idx="177">
                  <c:v>58683017</c:v>
                </c:pt>
                <c:pt idx="178">
                  <c:v>59833299</c:v>
                </c:pt>
                <c:pt idx="179">
                  <c:v>59148610</c:v>
                </c:pt>
                <c:pt idx="180">
                  <c:v>58839857</c:v>
                </c:pt>
                <c:pt idx="181">
                  <c:v>58425747</c:v>
                </c:pt>
                <c:pt idx="182">
                  <c:v>58652548</c:v>
                </c:pt>
                <c:pt idx="183">
                  <c:v>59316155</c:v>
                </c:pt>
                <c:pt idx="184">
                  <c:v>59024190</c:v>
                </c:pt>
                <c:pt idx="185">
                  <c:v>59069052</c:v>
                </c:pt>
                <c:pt idx="186">
                  <c:v>58380486</c:v>
                </c:pt>
                <c:pt idx="187">
                  <c:v>59833250</c:v>
                </c:pt>
                <c:pt idx="188">
                  <c:v>58839711</c:v>
                </c:pt>
                <c:pt idx="189">
                  <c:v>59020155</c:v>
                </c:pt>
                <c:pt idx="190">
                  <c:v>59020363</c:v>
                </c:pt>
                <c:pt idx="191">
                  <c:v>59062420</c:v>
                </c:pt>
                <c:pt idx="192">
                  <c:v>59554262</c:v>
                </c:pt>
                <c:pt idx="193">
                  <c:v>59223134</c:v>
                </c:pt>
                <c:pt idx="194">
                  <c:v>59223139</c:v>
                </c:pt>
                <c:pt idx="195">
                  <c:v>58665801</c:v>
                </c:pt>
                <c:pt idx="196">
                  <c:v>58634237</c:v>
                </c:pt>
                <c:pt idx="197">
                  <c:v>59419567</c:v>
                </c:pt>
                <c:pt idx="198">
                  <c:v>59547620</c:v>
                </c:pt>
                <c:pt idx="199">
                  <c:v>59206763</c:v>
                </c:pt>
                <c:pt idx="200">
                  <c:v>59342804</c:v>
                </c:pt>
                <c:pt idx="201">
                  <c:v>59564696</c:v>
                </c:pt>
                <c:pt idx="202">
                  <c:v>59215385</c:v>
                </c:pt>
                <c:pt idx="203">
                  <c:v>59342820</c:v>
                </c:pt>
                <c:pt idx="204">
                  <c:v>59566700</c:v>
                </c:pt>
                <c:pt idx="205">
                  <c:v>59566699</c:v>
                </c:pt>
                <c:pt idx="206">
                  <c:v>59565625</c:v>
                </c:pt>
                <c:pt idx="207">
                  <c:v>59565627</c:v>
                </c:pt>
                <c:pt idx="208">
                  <c:v>59808039</c:v>
                </c:pt>
                <c:pt idx="209">
                  <c:v>59418734</c:v>
                </c:pt>
                <c:pt idx="210">
                  <c:v>59525199</c:v>
                </c:pt>
                <c:pt idx="211">
                  <c:v>59691336</c:v>
                </c:pt>
                <c:pt idx="212">
                  <c:v>59476045</c:v>
                </c:pt>
                <c:pt idx="213">
                  <c:v>59608554</c:v>
                </c:pt>
                <c:pt idx="214">
                  <c:v>59413371</c:v>
                </c:pt>
                <c:pt idx="215">
                  <c:v>59821802</c:v>
                </c:pt>
                <c:pt idx="216">
                  <c:v>59571506</c:v>
                </c:pt>
                <c:pt idx="217">
                  <c:v>59835807</c:v>
                </c:pt>
                <c:pt idx="218">
                  <c:v>59775260</c:v>
                </c:pt>
                <c:pt idx="219">
                  <c:v>59808110</c:v>
                </c:pt>
                <c:pt idx="220">
                  <c:v>59866581</c:v>
                </c:pt>
                <c:pt idx="221">
                  <c:v>59609220</c:v>
                </c:pt>
                <c:pt idx="222">
                  <c:v>59826585</c:v>
                </c:pt>
                <c:pt idx="223">
                  <c:v>60240796</c:v>
                </c:pt>
                <c:pt idx="224">
                  <c:v>59560739</c:v>
                </c:pt>
                <c:pt idx="225">
                  <c:v>59775456</c:v>
                </c:pt>
                <c:pt idx="226">
                  <c:v>60900987</c:v>
                </c:pt>
                <c:pt idx="227">
                  <c:v>60900986</c:v>
                </c:pt>
                <c:pt idx="228">
                  <c:v>60900982</c:v>
                </c:pt>
                <c:pt idx="229">
                  <c:v>60344348</c:v>
                </c:pt>
                <c:pt idx="230">
                  <c:v>59889374</c:v>
                </c:pt>
                <c:pt idx="231">
                  <c:v>59850910</c:v>
                </c:pt>
                <c:pt idx="232">
                  <c:v>60282257</c:v>
                </c:pt>
                <c:pt idx="233">
                  <c:v>60324251</c:v>
                </c:pt>
                <c:pt idx="234">
                  <c:v>59946988</c:v>
                </c:pt>
                <c:pt idx="235">
                  <c:v>60324214</c:v>
                </c:pt>
                <c:pt idx="236">
                  <c:v>60024056</c:v>
                </c:pt>
                <c:pt idx="237">
                  <c:v>60333532</c:v>
                </c:pt>
                <c:pt idx="238">
                  <c:v>60423900</c:v>
                </c:pt>
                <c:pt idx="239">
                  <c:v>60938250</c:v>
                </c:pt>
                <c:pt idx="240">
                  <c:v>60194381</c:v>
                </c:pt>
                <c:pt idx="241">
                  <c:v>60194379</c:v>
                </c:pt>
                <c:pt idx="242">
                  <c:v>60631094</c:v>
                </c:pt>
                <c:pt idx="243">
                  <c:v>60240729</c:v>
                </c:pt>
                <c:pt idx="244">
                  <c:v>60308140</c:v>
                </c:pt>
                <c:pt idx="245">
                  <c:v>60650722</c:v>
                </c:pt>
                <c:pt idx="246">
                  <c:v>60302611</c:v>
                </c:pt>
                <c:pt idx="247">
                  <c:v>60324265</c:v>
                </c:pt>
                <c:pt idx="248">
                  <c:v>60756251</c:v>
                </c:pt>
                <c:pt idx="249">
                  <c:v>60297335</c:v>
                </c:pt>
                <c:pt idx="250">
                  <c:v>60380079</c:v>
                </c:pt>
                <c:pt idx="251">
                  <c:v>60342880</c:v>
                </c:pt>
                <c:pt idx="252">
                  <c:v>60287963</c:v>
                </c:pt>
                <c:pt idx="253">
                  <c:v>60349808</c:v>
                </c:pt>
                <c:pt idx="254">
                  <c:v>60048878</c:v>
                </c:pt>
                <c:pt idx="255">
                  <c:v>60499001</c:v>
                </c:pt>
                <c:pt idx="256">
                  <c:v>59946860</c:v>
                </c:pt>
                <c:pt idx="257">
                  <c:v>59946877</c:v>
                </c:pt>
                <c:pt idx="258">
                  <c:v>60701880</c:v>
                </c:pt>
                <c:pt idx="259">
                  <c:v>60746656</c:v>
                </c:pt>
                <c:pt idx="260">
                  <c:v>59930523</c:v>
                </c:pt>
                <c:pt idx="261">
                  <c:v>60245187</c:v>
                </c:pt>
                <c:pt idx="262">
                  <c:v>60354221</c:v>
                </c:pt>
                <c:pt idx="263">
                  <c:v>60601449</c:v>
                </c:pt>
                <c:pt idx="264">
                  <c:v>60384475</c:v>
                </c:pt>
              </c:numCache>
            </c:numRef>
          </c:xVal>
          <c:yVal>
            <c:numRef>
              <c:f>'phy vs gendist'!$E$4:$E$268</c:f>
              <c:numCache>
                <c:formatCode>General</c:formatCode>
                <c:ptCount val="265"/>
                <c:pt idx="0">
                  <c:v>0</c:v>
                </c:pt>
                <c:pt idx="1">
                  <c:v>0.57500000000000062</c:v>
                </c:pt>
                <c:pt idx="2">
                  <c:v>1.3740000000000001</c:v>
                </c:pt>
                <c:pt idx="3">
                  <c:v>2.0470000000000002</c:v>
                </c:pt>
                <c:pt idx="4">
                  <c:v>2.6909999999999998</c:v>
                </c:pt>
                <c:pt idx="5">
                  <c:v>4.1179999999999755</c:v>
                </c:pt>
                <c:pt idx="6">
                  <c:v>4.8149999999999755</c:v>
                </c:pt>
                <c:pt idx="7">
                  <c:v>5.7700000000000014</c:v>
                </c:pt>
                <c:pt idx="8">
                  <c:v>6.2469999999999999</c:v>
                </c:pt>
                <c:pt idx="9">
                  <c:v>7.4569999999999999</c:v>
                </c:pt>
                <c:pt idx="10">
                  <c:v>8.0360000000000014</c:v>
                </c:pt>
                <c:pt idx="11">
                  <c:v>8.2060000000000013</c:v>
                </c:pt>
                <c:pt idx="12">
                  <c:v>9.3730000000000047</c:v>
                </c:pt>
                <c:pt idx="13">
                  <c:v>10.331</c:v>
                </c:pt>
                <c:pt idx="14">
                  <c:v>10.366000000000026</c:v>
                </c:pt>
                <c:pt idx="15">
                  <c:v>11.638</c:v>
                </c:pt>
                <c:pt idx="16">
                  <c:v>12.358000000000002</c:v>
                </c:pt>
                <c:pt idx="17">
                  <c:v>12.877000000000002</c:v>
                </c:pt>
                <c:pt idx="18">
                  <c:v>13.419</c:v>
                </c:pt>
                <c:pt idx="19">
                  <c:v>13.877000000000002</c:v>
                </c:pt>
                <c:pt idx="20">
                  <c:v>14.172000000000002</c:v>
                </c:pt>
                <c:pt idx="21">
                  <c:v>14.434000000000001</c:v>
                </c:pt>
                <c:pt idx="22">
                  <c:v>15.06</c:v>
                </c:pt>
                <c:pt idx="23">
                  <c:v>15.53</c:v>
                </c:pt>
                <c:pt idx="24">
                  <c:v>16.084</c:v>
                </c:pt>
                <c:pt idx="25">
                  <c:v>16.652999999999999</c:v>
                </c:pt>
                <c:pt idx="26">
                  <c:v>16.881</c:v>
                </c:pt>
                <c:pt idx="27">
                  <c:v>17.657000000000131</c:v>
                </c:pt>
                <c:pt idx="28">
                  <c:v>18.487999999999989</c:v>
                </c:pt>
                <c:pt idx="29">
                  <c:v>19.402999999999889</c:v>
                </c:pt>
                <c:pt idx="30">
                  <c:v>20.076000000000001</c:v>
                </c:pt>
                <c:pt idx="31">
                  <c:v>20.887</c:v>
                </c:pt>
                <c:pt idx="32">
                  <c:v>21.352</c:v>
                </c:pt>
                <c:pt idx="33">
                  <c:v>21.439999999999987</c:v>
                </c:pt>
                <c:pt idx="34">
                  <c:v>22.033999999999999</c:v>
                </c:pt>
                <c:pt idx="35">
                  <c:v>22.759999999999987</c:v>
                </c:pt>
                <c:pt idx="36">
                  <c:v>23.029</c:v>
                </c:pt>
                <c:pt idx="37">
                  <c:v>23.961999999999989</c:v>
                </c:pt>
                <c:pt idx="38">
                  <c:v>24.664000000000001</c:v>
                </c:pt>
                <c:pt idx="39">
                  <c:v>24.962999999999777</c:v>
                </c:pt>
                <c:pt idx="40">
                  <c:v>25.88</c:v>
                </c:pt>
                <c:pt idx="41">
                  <c:v>26.917999999999999</c:v>
                </c:pt>
                <c:pt idx="42">
                  <c:v>27.524000000000001</c:v>
                </c:pt>
                <c:pt idx="43">
                  <c:v>27.784999999999989</c:v>
                </c:pt>
                <c:pt idx="44">
                  <c:v>28.41</c:v>
                </c:pt>
                <c:pt idx="45">
                  <c:v>29.023</c:v>
                </c:pt>
                <c:pt idx="46">
                  <c:v>29.364999999999988</c:v>
                </c:pt>
                <c:pt idx="47">
                  <c:v>29.715</c:v>
                </c:pt>
                <c:pt idx="48">
                  <c:v>30.175000000000001</c:v>
                </c:pt>
                <c:pt idx="49">
                  <c:v>30.461999999999989</c:v>
                </c:pt>
                <c:pt idx="50">
                  <c:v>30.959</c:v>
                </c:pt>
                <c:pt idx="51">
                  <c:v>31.827000000000005</c:v>
                </c:pt>
                <c:pt idx="52">
                  <c:v>32.291000000000011</c:v>
                </c:pt>
                <c:pt idx="53">
                  <c:v>32.558</c:v>
                </c:pt>
                <c:pt idx="54">
                  <c:v>33.08</c:v>
                </c:pt>
                <c:pt idx="55">
                  <c:v>33.837000000000003</c:v>
                </c:pt>
                <c:pt idx="56">
                  <c:v>33.902000000000001</c:v>
                </c:pt>
                <c:pt idx="57">
                  <c:v>33.948</c:v>
                </c:pt>
                <c:pt idx="58">
                  <c:v>34.686</c:v>
                </c:pt>
                <c:pt idx="59">
                  <c:v>34.972000000000001</c:v>
                </c:pt>
                <c:pt idx="60">
                  <c:v>35.288000000000011</c:v>
                </c:pt>
                <c:pt idx="61">
                  <c:v>35.678000000000011</c:v>
                </c:pt>
                <c:pt idx="62">
                  <c:v>35.758000000000003</c:v>
                </c:pt>
                <c:pt idx="63">
                  <c:v>35.997</c:v>
                </c:pt>
                <c:pt idx="64">
                  <c:v>36.145000000000003</c:v>
                </c:pt>
                <c:pt idx="65">
                  <c:v>36.401000000000003</c:v>
                </c:pt>
                <c:pt idx="66">
                  <c:v>36.843000000000004</c:v>
                </c:pt>
                <c:pt idx="67">
                  <c:v>37.229000000000013</c:v>
                </c:pt>
                <c:pt idx="68">
                  <c:v>37.730000000000011</c:v>
                </c:pt>
                <c:pt idx="69">
                  <c:v>38.079000000000001</c:v>
                </c:pt>
                <c:pt idx="70">
                  <c:v>38.341999999999999</c:v>
                </c:pt>
                <c:pt idx="71">
                  <c:v>38.346000000000004</c:v>
                </c:pt>
                <c:pt idx="72">
                  <c:v>38.660000000000011</c:v>
                </c:pt>
                <c:pt idx="73">
                  <c:v>39.380000000000003</c:v>
                </c:pt>
                <c:pt idx="74">
                  <c:v>39.380000000000003</c:v>
                </c:pt>
                <c:pt idx="75">
                  <c:v>39.394000000000005</c:v>
                </c:pt>
                <c:pt idx="76">
                  <c:v>39.782000000000011</c:v>
                </c:pt>
                <c:pt idx="77">
                  <c:v>40.377000000000002</c:v>
                </c:pt>
                <c:pt idx="78">
                  <c:v>40.677</c:v>
                </c:pt>
                <c:pt idx="79">
                  <c:v>40.760000000000012</c:v>
                </c:pt>
                <c:pt idx="80">
                  <c:v>41.371000000000002</c:v>
                </c:pt>
                <c:pt idx="81">
                  <c:v>42.833000000000006</c:v>
                </c:pt>
                <c:pt idx="82">
                  <c:v>43.957999999999998</c:v>
                </c:pt>
                <c:pt idx="83">
                  <c:v>44.416000000000004</c:v>
                </c:pt>
                <c:pt idx="84">
                  <c:v>44.945</c:v>
                </c:pt>
                <c:pt idx="85">
                  <c:v>45.856999999999999</c:v>
                </c:pt>
                <c:pt idx="86">
                  <c:v>45.984999999999999</c:v>
                </c:pt>
                <c:pt idx="87">
                  <c:v>46.461000000000006</c:v>
                </c:pt>
                <c:pt idx="88">
                  <c:v>47.424000000000007</c:v>
                </c:pt>
                <c:pt idx="89">
                  <c:v>48.021000000000001</c:v>
                </c:pt>
                <c:pt idx="90">
                  <c:v>48.532000000000011</c:v>
                </c:pt>
                <c:pt idx="91">
                  <c:v>49.165000000000013</c:v>
                </c:pt>
                <c:pt idx="92">
                  <c:v>49.555</c:v>
                </c:pt>
                <c:pt idx="93">
                  <c:v>49.678000000000011</c:v>
                </c:pt>
                <c:pt idx="94">
                  <c:v>50.491</c:v>
                </c:pt>
                <c:pt idx="95">
                  <c:v>51.036000000000001</c:v>
                </c:pt>
                <c:pt idx="96">
                  <c:v>51.386000000000003</c:v>
                </c:pt>
                <c:pt idx="97">
                  <c:v>52.221000000000011</c:v>
                </c:pt>
                <c:pt idx="98">
                  <c:v>53.005000000000003</c:v>
                </c:pt>
                <c:pt idx="99">
                  <c:v>53.54</c:v>
                </c:pt>
                <c:pt idx="100">
                  <c:v>54.416000000000004</c:v>
                </c:pt>
                <c:pt idx="101">
                  <c:v>55.076000000000001</c:v>
                </c:pt>
                <c:pt idx="102">
                  <c:v>55.529000000000003</c:v>
                </c:pt>
                <c:pt idx="103">
                  <c:v>55.779000000000003</c:v>
                </c:pt>
                <c:pt idx="104">
                  <c:v>56.465000000000003</c:v>
                </c:pt>
                <c:pt idx="105">
                  <c:v>57.098000000000013</c:v>
                </c:pt>
                <c:pt idx="106">
                  <c:v>57.606000000000002</c:v>
                </c:pt>
                <c:pt idx="107">
                  <c:v>57.743000000000002</c:v>
                </c:pt>
                <c:pt idx="108">
                  <c:v>58.521000000000001</c:v>
                </c:pt>
                <c:pt idx="109">
                  <c:v>60.56</c:v>
                </c:pt>
                <c:pt idx="110">
                  <c:v>62.051000000000002</c:v>
                </c:pt>
                <c:pt idx="111">
                  <c:v>62.658000000000001</c:v>
                </c:pt>
                <c:pt idx="112">
                  <c:v>63.545000000000002</c:v>
                </c:pt>
                <c:pt idx="113">
                  <c:v>64.304999999999993</c:v>
                </c:pt>
                <c:pt idx="114">
                  <c:v>65.956999999999994</c:v>
                </c:pt>
                <c:pt idx="115">
                  <c:v>66.471999999999994</c:v>
                </c:pt>
                <c:pt idx="116">
                  <c:v>67.236999999999995</c:v>
                </c:pt>
                <c:pt idx="117">
                  <c:v>68.043000000000006</c:v>
                </c:pt>
                <c:pt idx="118">
                  <c:v>69.328000000000003</c:v>
                </c:pt>
                <c:pt idx="119">
                  <c:v>70.054999999999993</c:v>
                </c:pt>
                <c:pt idx="120">
                  <c:v>70.634</c:v>
                </c:pt>
                <c:pt idx="121">
                  <c:v>71.482000000000014</c:v>
                </c:pt>
                <c:pt idx="122">
                  <c:v>72.248000000000005</c:v>
                </c:pt>
                <c:pt idx="123">
                  <c:v>73.641000000000005</c:v>
                </c:pt>
                <c:pt idx="124">
                  <c:v>74.202000000000012</c:v>
                </c:pt>
                <c:pt idx="125">
                  <c:v>75.151999999999987</c:v>
                </c:pt>
                <c:pt idx="126">
                  <c:v>76.646000000000001</c:v>
                </c:pt>
                <c:pt idx="127">
                  <c:v>77.203999999999994</c:v>
                </c:pt>
                <c:pt idx="128">
                  <c:v>77.614000000000004</c:v>
                </c:pt>
                <c:pt idx="129">
                  <c:v>78.718999999999994</c:v>
                </c:pt>
                <c:pt idx="130">
                  <c:v>78.724999999999994</c:v>
                </c:pt>
                <c:pt idx="131">
                  <c:v>79.367000000000004</c:v>
                </c:pt>
                <c:pt idx="132">
                  <c:v>80.007999999999996</c:v>
                </c:pt>
                <c:pt idx="133">
                  <c:v>80.751999999999995</c:v>
                </c:pt>
                <c:pt idx="134">
                  <c:v>81.702000000000012</c:v>
                </c:pt>
                <c:pt idx="135">
                  <c:v>82.179999999999978</c:v>
                </c:pt>
                <c:pt idx="136">
                  <c:v>82.728999999999999</c:v>
                </c:pt>
                <c:pt idx="137">
                  <c:v>83.884999999999991</c:v>
                </c:pt>
                <c:pt idx="138">
                  <c:v>84.793000000000006</c:v>
                </c:pt>
                <c:pt idx="139">
                  <c:v>84.947000000000713</c:v>
                </c:pt>
                <c:pt idx="140">
                  <c:v>86.427999999999997</c:v>
                </c:pt>
                <c:pt idx="141">
                  <c:v>86.986999999999995</c:v>
                </c:pt>
                <c:pt idx="142">
                  <c:v>87.778999999999982</c:v>
                </c:pt>
                <c:pt idx="143">
                  <c:v>88.617000000000004</c:v>
                </c:pt>
                <c:pt idx="144">
                  <c:v>89.482000000000014</c:v>
                </c:pt>
                <c:pt idx="145">
                  <c:v>90.683999999999983</c:v>
                </c:pt>
                <c:pt idx="146">
                  <c:v>91.295000000000002</c:v>
                </c:pt>
                <c:pt idx="147">
                  <c:v>92.114999999999995</c:v>
                </c:pt>
                <c:pt idx="148">
                  <c:v>93.121999999999986</c:v>
                </c:pt>
                <c:pt idx="149">
                  <c:v>94.409000000000006</c:v>
                </c:pt>
                <c:pt idx="150">
                  <c:v>94.986999999999995</c:v>
                </c:pt>
                <c:pt idx="151">
                  <c:v>95.617999999999995</c:v>
                </c:pt>
                <c:pt idx="152">
                  <c:v>95.876999999999981</c:v>
                </c:pt>
                <c:pt idx="153">
                  <c:v>96.054999999999993</c:v>
                </c:pt>
                <c:pt idx="154">
                  <c:v>96.424000000000007</c:v>
                </c:pt>
                <c:pt idx="155">
                  <c:v>96.621999999999986</c:v>
                </c:pt>
                <c:pt idx="156">
                  <c:v>97.265000000000001</c:v>
                </c:pt>
                <c:pt idx="157">
                  <c:v>97.875999999999948</c:v>
                </c:pt>
                <c:pt idx="158">
                  <c:v>98.396000000000001</c:v>
                </c:pt>
                <c:pt idx="159">
                  <c:v>98.700999999999993</c:v>
                </c:pt>
                <c:pt idx="160">
                  <c:v>99.043999999999997</c:v>
                </c:pt>
                <c:pt idx="161">
                  <c:v>99.60799999999999</c:v>
                </c:pt>
                <c:pt idx="162">
                  <c:v>100.398</c:v>
                </c:pt>
                <c:pt idx="163">
                  <c:v>101.24400000000065</c:v>
                </c:pt>
                <c:pt idx="164">
                  <c:v>102.44000000000032</c:v>
                </c:pt>
                <c:pt idx="165">
                  <c:v>103.07799999999999</c:v>
                </c:pt>
                <c:pt idx="166">
                  <c:v>103.62299999999998</c:v>
                </c:pt>
                <c:pt idx="167">
                  <c:v>104.41200000000002</c:v>
                </c:pt>
                <c:pt idx="168">
                  <c:v>104.80200000000001</c:v>
                </c:pt>
                <c:pt idx="169">
                  <c:v>105.596</c:v>
                </c:pt>
                <c:pt idx="170">
                  <c:v>105.94000000000032</c:v>
                </c:pt>
                <c:pt idx="171">
                  <c:v>106.67599999999995</c:v>
                </c:pt>
                <c:pt idx="172">
                  <c:v>107.17199999999998</c:v>
                </c:pt>
                <c:pt idx="173">
                  <c:v>107.396</c:v>
                </c:pt>
                <c:pt idx="174">
                  <c:v>107.79600000000002</c:v>
                </c:pt>
                <c:pt idx="175">
                  <c:v>108.032</c:v>
                </c:pt>
                <c:pt idx="176">
                  <c:v>108.357</c:v>
                </c:pt>
                <c:pt idx="177">
                  <c:v>108.61499999999999</c:v>
                </c:pt>
                <c:pt idx="178">
                  <c:v>109.008</c:v>
                </c:pt>
                <c:pt idx="179">
                  <c:v>109.224</c:v>
                </c:pt>
                <c:pt idx="180">
                  <c:v>109.46599999999999</c:v>
                </c:pt>
                <c:pt idx="181">
                  <c:v>109.74900000000002</c:v>
                </c:pt>
                <c:pt idx="182">
                  <c:v>109.90100000000002</c:v>
                </c:pt>
                <c:pt idx="183">
                  <c:v>110.12499999999999</c:v>
                </c:pt>
                <c:pt idx="184">
                  <c:v>110.337</c:v>
                </c:pt>
                <c:pt idx="185">
                  <c:v>110.52800000000001</c:v>
                </c:pt>
                <c:pt idx="186">
                  <c:v>110.886</c:v>
                </c:pt>
                <c:pt idx="187">
                  <c:v>111.191</c:v>
                </c:pt>
                <c:pt idx="188">
                  <c:v>111.35899999999998</c:v>
                </c:pt>
                <c:pt idx="189">
                  <c:v>111.735</c:v>
                </c:pt>
                <c:pt idx="190">
                  <c:v>112.08199999999999</c:v>
                </c:pt>
                <c:pt idx="191">
                  <c:v>112.3</c:v>
                </c:pt>
                <c:pt idx="192">
                  <c:v>112.633</c:v>
                </c:pt>
                <c:pt idx="193">
                  <c:v>113.02200000000001</c:v>
                </c:pt>
                <c:pt idx="194">
                  <c:v>113.057</c:v>
                </c:pt>
                <c:pt idx="195">
                  <c:v>113.28400000000002</c:v>
                </c:pt>
                <c:pt idx="196">
                  <c:v>113.523</c:v>
                </c:pt>
                <c:pt idx="197">
                  <c:v>113.69799999999999</c:v>
                </c:pt>
                <c:pt idx="198">
                  <c:v>113.992</c:v>
                </c:pt>
                <c:pt idx="199">
                  <c:v>114.32499999999999</c:v>
                </c:pt>
                <c:pt idx="200">
                  <c:v>114.593</c:v>
                </c:pt>
                <c:pt idx="201">
                  <c:v>114.809</c:v>
                </c:pt>
                <c:pt idx="202">
                  <c:v>115.101</c:v>
                </c:pt>
                <c:pt idx="203">
                  <c:v>115.321</c:v>
                </c:pt>
                <c:pt idx="204">
                  <c:v>115.589</c:v>
                </c:pt>
                <c:pt idx="205">
                  <c:v>115.63200000000001</c:v>
                </c:pt>
                <c:pt idx="206">
                  <c:v>116.20699999999999</c:v>
                </c:pt>
                <c:pt idx="207">
                  <c:v>116.20699999999999</c:v>
                </c:pt>
                <c:pt idx="208">
                  <c:v>116.518</c:v>
                </c:pt>
                <c:pt idx="209">
                  <c:v>116.702</c:v>
                </c:pt>
                <c:pt idx="210">
                  <c:v>116.94100000000067</c:v>
                </c:pt>
                <c:pt idx="211">
                  <c:v>117.319</c:v>
                </c:pt>
                <c:pt idx="212">
                  <c:v>117.456</c:v>
                </c:pt>
                <c:pt idx="213">
                  <c:v>117.745</c:v>
                </c:pt>
                <c:pt idx="214">
                  <c:v>117.99400000000065</c:v>
                </c:pt>
                <c:pt idx="215">
                  <c:v>118.15600000000001</c:v>
                </c:pt>
                <c:pt idx="216">
                  <c:v>118.271</c:v>
                </c:pt>
                <c:pt idx="217">
                  <c:v>118.57499999999999</c:v>
                </c:pt>
                <c:pt idx="218">
                  <c:v>118.72799999999999</c:v>
                </c:pt>
                <c:pt idx="219">
                  <c:v>119.005</c:v>
                </c:pt>
                <c:pt idx="220">
                  <c:v>119.28700000000002</c:v>
                </c:pt>
                <c:pt idx="221">
                  <c:v>119.54100000000012</c:v>
                </c:pt>
                <c:pt idx="222">
                  <c:v>119.86799999999999</c:v>
                </c:pt>
                <c:pt idx="223">
                  <c:v>120.04400000000012</c:v>
                </c:pt>
                <c:pt idx="224">
                  <c:v>120.32499999999999</c:v>
                </c:pt>
                <c:pt idx="225">
                  <c:v>120.61799999999999</c:v>
                </c:pt>
                <c:pt idx="226">
                  <c:v>120.867</c:v>
                </c:pt>
                <c:pt idx="227">
                  <c:v>121.02</c:v>
                </c:pt>
                <c:pt idx="228">
                  <c:v>121.03400000000002</c:v>
                </c:pt>
                <c:pt idx="229">
                  <c:v>121.363</c:v>
                </c:pt>
                <c:pt idx="230">
                  <c:v>121.67999999999998</c:v>
                </c:pt>
                <c:pt idx="231">
                  <c:v>121.91100000000066</c:v>
                </c:pt>
                <c:pt idx="232">
                  <c:v>122.169</c:v>
                </c:pt>
                <c:pt idx="233">
                  <c:v>122.46000000000002</c:v>
                </c:pt>
                <c:pt idx="234">
                  <c:v>122.798</c:v>
                </c:pt>
                <c:pt idx="235">
                  <c:v>122.95099999999999</c:v>
                </c:pt>
                <c:pt idx="236">
                  <c:v>123.601</c:v>
                </c:pt>
                <c:pt idx="237">
                  <c:v>124.099</c:v>
                </c:pt>
                <c:pt idx="238">
                  <c:v>124.349</c:v>
                </c:pt>
                <c:pt idx="239">
                  <c:v>124.648</c:v>
                </c:pt>
                <c:pt idx="240">
                  <c:v>124.892</c:v>
                </c:pt>
                <c:pt idx="241">
                  <c:v>124.97799999999999</c:v>
                </c:pt>
                <c:pt idx="242">
                  <c:v>125.224</c:v>
                </c:pt>
                <c:pt idx="243">
                  <c:v>125.46299999999999</c:v>
                </c:pt>
                <c:pt idx="244">
                  <c:v>125.703</c:v>
                </c:pt>
                <c:pt idx="245">
                  <c:v>126.24700000000065</c:v>
                </c:pt>
                <c:pt idx="246">
                  <c:v>126.61</c:v>
                </c:pt>
                <c:pt idx="247">
                  <c:v>127.04300000000002</c:v>
                </c:pt>
                <c:pt idx="248">
                  <c:v>127.63500000000001</c:v>
                </c:pt>
                <c:pt idx="249">
                  <c:v>128.102</c:v>
                </c:pt>
                <c:pt idx="250">
                  <c:v>128.37300000000002</c:v>
                </c:pt>
                <c:pt idx="251">
                  <c:v>128.94200000000001</c:v>
                </c:pt>
                <c:pt idx="252">
                  <c:v>129.512</c:v>
                </c:pt>
                <c:pt idx="253">
                  <c:v>129.798</c:v>
                </c:pt>
                <c:pt idx="254">
                  <c:v>130.06300000000002</c:v>
                </c:pt>
                <c:pt idx="255">
                  <c:v>130.34</c:v>
                </c:pt>
                <c:pt idx="256">
                  <c:v>130.88700000000131</c:v>
                </c:pt>
                <c:pt idx="257">
                  <c:v>131.167</c:v>
                </c:pt>
                <c:pt idx="258">
                  <c:v>131.9</c:v>
                </c:pt>
                <c:pt idx="259">
                  <c:v>132.22399999999999</c:v>
                </c:pt>
                <c:pt idx="260">
                  <c:v>132.57900000000001</c:v>
                </c:pt>
                <c:pt idx="261">
                  <c:v>133.34300000000002</c:v>
                </c:pt>
                <c:pt idx="262">
                  <c:v>133.71099999999998</c:v>
                </c:pt>
                <c:pt idx="263">
                  <c:v>133.934</c:v>
                </c:pt>
                <c:pt idx="264">
                  <c:v>135.692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F33-4AFC-9B2E-C67E5BAE5D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3729096"/>
        <c:axId val="353727136"/>
      </c:scatterChart>
      <c:valAx>
        <c:axId val="353729096"/>
        <c:scaling>
          <c:orientation val="minMax"/>
          <c:min val="450000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hysicl map distance </a:t>
                </a:r>
              </a:p>
            </c:rich>
          </c:tx>
          <c:layout>
            <c:manualLayout>
              <c:xMode val="edge"/>
              <c:yMode val="edge"/>
              <c:x val="0.40391120351529092"/>
              <c:y val="0.942288416778091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353727136"/>
        <c:crosses val="autoZero"/>
        <c:crossBetween val="midCat"/>
      </c:valAx>
      <c:valAx>
        <c:axId val="353727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53729096"/>
        <c:crosses val="autoZero"/>
        <c:crossBetween val="midCat"/>
      </c:valAx>
      <c:spPr>
        <a:ln w="3175">
          <a:gradFill>
            <a:gsLst>
              <a:gs pos="0">
                <a:schemeClr val="tx1"/>
              </a:gs>
              <a:gs pos="50000">
                <a:srgbClr val="4F81BD">
                  <a:tint val="44500"/>
                  <a:satMod val="160000"/>
                </a:srgbClr>
              </a:gs>
              <a:gs pos="100000">
                <a:srgbClr val="4F81BD">
                  <a:tint val="23500"/>
                  <a:satMod val="160000"/>
                </a:srgbClr>
              </a:gs>
            </a:gsLst>
            <a:lin ang="5400000" scaled="0"/>
          </a:gradFill>
        </a:ln>
      </c:spPr>
    </c:plotArea>
    <c:plotVisOnly val="1"/>
    <c:dispBlanksAs val="gap"/>
    <c:showDLblsOverMax val="0"/>
  </c:chart>
  <c:spPr>
    <a:solidFill>
      <a:schemeClr val="lt1"/>
    </a:solidFill>
    <a:ln w="25400" cap="flat" cmpd="sng" algn="ctr">
      <a:solidFill>
        <a:schemeClr val="dk1"/>
      </a:solidFill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9744</cdr:x>
      <cdr:y>0.32432</cdr:y>
    </cdr:from>
    <cdr:to>
      <cdr:x>1</cdr:x>
      <cdr:y>0.48649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8001000" y="18288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88034</cdr:x>
      <cdr:y>0.42037</cdr:y>
    </cdr:from>
    <cdr:to>
      <cdr:x>0.91453</cdr:x>
      <cdr:y>0.58253</cdr:y>
    </cdr:to>
    <cdr:sp macro="" textlink="">
      <cdr:nvSpPr>
        <cdr:cNvPr id="3" name="TextBox 2"/>
        <cdr:cNvSpPr txBox="1"/>
      </cdr:nvSpPr>
      <cdr:spPr>
        <a:xfrm xmlns:a="http://schemas.openxmlformats.org/drawingml/2006/main" rot="16200000">
          <a:off x="7543800" y="2675184"/>
          <a:ext cx="914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Max Temp</a:t>
          </a:r>
          <a:endParaRPr lang="en-US" sz="11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906</cdr:x>
      <cdr:y>0.95092</cdr:y>
    </cdr:from>
    <cdr:to>
      <cdr:x>0.39316</cdr:x>
      <cdr:y>1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2590800" y="5362021"/>
          <a:ext cx="914400" cy="276779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Date  of sowing (DOS)</a:t>
          </a:r>
          <a:endParaRPr lang="en-US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359</cdr:x>
      <cdr:y>0.14453</cdr:y>
    </cdr:from>
    <cdr:to>
      <cdr:x>0.45299</cdr:x>
      <cdr:y>0.30362</cdr:y>
    </cdr:to>
    <cdr:sp macro="" textlink="">
      <cdr:nvSpPr>
        <cdr:cNvPr id="2" name="Down Arrow 1"/>
        <cdr:cNvSpPr/>
      </cdr:nvSpPr>
      <cdr:spPr>
        <a:xfrm xmlns:a="http://schemas.openxmlformats.org/drawingml/2006/main">
          <a:off x="3886200" y="726882"/>
          <a:ext cx="152364" cy="800095"/>
        </a:xfrm>
        <a:prstGeom xmlns:a="http://schemas.openxmlformats.org/drawingml/2006/main" prst="downArrow">
          <a:avLst/>
        </a:prstGeom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9516</cdr:x>
      <cdr:y>0.15181</cdr:y>
    </cdr:from>
    <cdr:to>
      <cdr:x>0.61226</cdr:x>
      <cdr:y>0.33363</cdr:y>
    </cdr:to>
    <cdr:sp macro="" textlink="">
      <cdr:nvSpPr>
        <cdr:cNvPr id="3" name="Down Arrow 2"/>
        <cdr:cNvSpPr/>
      </cdr:nvSpPr>
      <cdr:spPr>
        <a:xfrm xmlns:a="http://schemas.openxmlformats.org/drawingml/2006/main">
          <a:off x="5306076" y="763488"/>
          <a:ext cx="152453" cy="914409"/>
        </a:xfrm>
        <a:prstGeom xmlns:a="http://schemas.openxmlformats.org/drawingml/2006/main" prst="downArrow">
          <a:avLst/>
        </a:prstGeom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7449</cdr:x>
      <cdr:y>0.31979</cdr:y>
    </cdr:from>
    <cdr:to>
      <cdr:x>0.90868</cdr:x>
      <cdr:y>0.5016</cdr:y>
    </cdr:to>
    <cdr:sp macro="" textlink="">
      <cdr:nvSpPr>
        <cdr:cNvPr id="4" name="TextBox 1"/>
        <cdr:cNvSpPr txBox="1"/>
      </cdr:nvSpPr>
      <cdr:spPr>
        <a:xfrm xmlns:a="http://schemas.openxmlformats.org/drawingml/2006/main" rot="16200000">
          <a:off x="7491662" y="1913068"/>
          <a:ext cx="914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Max Temp</a:t>
          </a:r>
          <a:endParaRPr lang="en-US" sz="11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1343</cdr:x>
      <cdr:y>0.08249</cdr:y>
    </cdr:from>
    <cdr:to>
      <cdr:x>0.04115</cdr:x>
      <cdr:y>0.9023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9804" y="271848"/>
          <a:ext cx="164757" cy="27020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200" b="1" dirty="0" err="1">
              <a:latin typeface="Times New Roman" panose="02020603050405020304" pitchFamily="18" charset="0"/>
              <a:cs typeface="Times New Roman" panose="02020603050405020304" pitchFamily="18" charset="0"/>
            </a:rPr>
            <a:t>Geneticmap</a:t>
          </a:r>
          <a:r>
            <a:rPr lang="en-US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distance</a:t>
          </a:r>
          <a:endParaRPr lang="en-US" sz="12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1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EB4BF1-62CD-45D4-890B-0EEB5637F433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FEC8C5-B62F-4098-8A27-C8A6029993A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691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46A14C-94BE-48A7-B7EE-728564C06EE1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7091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46A14C-94BE-48A7-B7EE-728564C06EE1}" type="slidenum">
              <a:rPr lang="en-US" smtClean="0">
                <a:solidFill>
                  <a:prstClr val="black"/>
                </a:solidFill>
              </a:rPr>
              <a:pPr/>
              <a:t>4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41157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46A14C-94BE-48A7-B7EE-728564C06EE1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53405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Proportion</a:t>
            </a:r>
            <a:r>
              <a:rPr lang="en-US" baseline="0" dirty="0" smtClean="0"/>
              <a:t> of A SCORES  for  SSRs and SNP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BEDD27-3CDD-43D3-A825-57E358168586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56296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46A14C-94BE-48A7-B7EE-728564C06EE1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036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jpe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9770074"/>
              </p:ext>
            </p:extLst>
          </p:nvPr>
        </p:nvGraphicFramePr>
        <p:xfrm>
          <a:off x="781050" y="685800"/>
          <a:ext cx="7829550" cy="48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itle 1"/>
          <p:cNvSpPr txBox="1">
            <a:spLocks/>
          </p:cNvSpPr>
          <p:nvPr/>
        </p:nvSpPr>
        <p:spPr>
          <a:xfrm>
            <a:off x="1524000" y="5638800"/>
            <a:ext cx="5943600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Supplementary Figure S1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cent green leaf area  (%GL) trait variation </a:t>
            </a:r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in parents and progeny for E1, E2 and across season</a:t>
            </a: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-940548" y="2540748"/>
            <a:ext cx="2920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scores for days after flowering (DAF)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16836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189167" y="457200"/>
            <a:ext cx="5620707" cy="5494694"/>
            <a:chOff x="1189167" y="1143000"/>
            <a:chExt cx="5620707" cy="5494694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600200" y="1143000"/>
              <a:ext cx="5181600" cy="518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2695074" y="6360695"/>
              <a:ext cx="411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SSRs Proportion of ‘B’ score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 rot="16200000">
              <a:off x="-767834" y="3328601"/>
              <a:ext cx="4191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P‘s  Proportion of ‘B’ scor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1219200" y="6096000"/>
            <a:ext cx="5943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S7  </a:t>
            </a:r>
            <a:r>
              <a:rPr lang="en-US" sz="1200" dirty="0" smtClean="0">
                <a:latin typeface="Times New Roman" panose="02020603050405020304" pitchFamily="18" charset="0"/>
                <a:cs typeface="Times New Roman" pitchFamily="18" charset="0"/>
              </a:rPr>
              <a:t>Proportion of ‘B’ alleles of SNPs plotted against proportion ‘B’ alleles of SSRs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7200" y="98172"/>
            <a:ext cx="8312343" cy="5846932"/>
            <a:chOff x="484785" y="7737"/>
            <a:chExt cx="8312343" cy="6590314"/>
          </a:xfrm>
        </p:grpSpPr>
        <p:sp>
          <p:nvSpPr>
            <p:cNvPr id="6" name="TextBox 5"/>
            <p:cNvSpPr txBox="1"/>
            <p:nvPr/>
          </p:nvSpPr>
          <p:spPr>
            <a:xfrm>
              <a:off x="528211" y="5774222"/>
              <a:ext cx="7848600" cy="728469"/>
            </a:xfrm>
            <a:prstGeom prst="rect">
              <a:avLst/>
            </a:prstGeom>
            <a:noFill/>
          </p:spPr>
          <p:txBody>
            <a:bodyPr wrap="square" lIns="91407" tIns="45704" rIns="91407" bIns="45704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itchFamily="18" charset="0"/>
                </a:rPr>
                <a:t>Supplementary Figure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8 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ltering of SNPs and Linkage map development on SBI-10L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rseshoe effect of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P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rkers. Red dot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cat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ly scattered markers with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rg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ssing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, whil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ee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ts indicate markers with sufficient data points aligned to map order,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ce matrix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ot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 the horseshoe arch aligned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rkers, and   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746877" y="7737"/>
              <a:ext cx="184664" cy="312181"/>
            </a:xfrm>
            <a:prstGeom prst="rect">
              <a:avLst/>
            </a:prstGeom>
            <a:noFill/>
          </p:spPr>
          <p:txBody>
            <a:bodyPr wrap="none" lIns="91407" tIns="45704" rIns="91407" bIns="45704" rtlCol="0">
              <a:spAutoFit/>
            </a:bodyPr>
            <a:lstStyle/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4314012" y="700601"/>
              <a:ext cx="4483116" cy="4100273"/>
              <a:chOff x="4314012" y="700601"/>
              <a:chExt cx="4483116" cy="4100273"/>
            </a:xfrm>
          </p:grpSpPr>
          <p:pic>
            <p:nvPicPr>
              <p:cNvPr id="3" name="Picture 2" descr="C:\Users\admin\Desktop\Downloads\Picture1.pn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5263" t="6059"/>
              <a:stretch>
                <a:fillRect/>
              </a:stretch>
            </p:blipFill>
            <p:spPr bwMode="auto">
              <a:xfrm>
                <a:off x="4599585" y="1185406"/>
                <a:ext cx="4197543" cy="3615468"/>
              </a:xfrm>
              <a:prstGeom prst="rect">
                <a:avLst/>
              </a:prstGeom>
              <a:noFill/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4904385" y="700601"/>
                <a:ext cx="2738955" cy="312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itchFamily="18" charset="0"/>
                  </a:rPr>
                  <a:t>(</a:t>
                </a:r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 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itchFamily="18" charset="0"/>
                  </a:rPr>
                  <a:t>SSR and SNP marker distance matrix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3599119" y="2673291"/>
                <a:ext cx="17067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anose="02020603050405020304" pitchFamily="18" charset="0"/>
                    <a:cs typeface="Times New Roman" pitchFamily="18" charset="0"/>
                  </a:rPr>
                  <a:t>SSR </a:t>
                </a:r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and SNP markers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484785" y="381000"/>
              <a:ext cx="3592054" cy="4419875"/>
              <a:chOff x="484783" y="381000"/>
              <a:chExt cx="3592054" cy="4419875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484783" y="381000"/>
                <a:ext cx="3592054" cy="4419875"/>
                <a:chOff x="484783" y="381000"/>
                <a:chExt cx="3592054" cy="4419875"/>
              </a:xfrm>
            </p:grpSpPr>
            <p:pic>
              <p:nvPicPr>
                <p:cNvPr id="5" name="Picture 1" descr="C:\Users\admin\Desktop\Downloads\horshoe effect1 (1).jp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t="6250"/>
                <a:stretch>
                  <a:fillRect/>
                </a:stretch>
              </p:blipFill>
              <p:spPr bwMode="auto">
                <a:xfrm>
                  <a:off x="484783" y="1185406"/>
                  <a:ext cx="3592054" cy="3615469"/>
                </a:xfrm>
                <a:prstGeom prst="rect">
                  <a:avLst/>
                </a:prstGeom>
                <a:noFill/>
              </p:spPr>
            </p:pic>
            <p:sp>
              <p:nvSpPr>
                <p:cNvPr id="12" name="Rectangle 11"/>
                <p:cNvSpPr/>
                <p:nvPr/>
              </p:nvSpPr>
              <p:spPr>
                <a:xfrm>
                  <a:off x="1493004" y="381000"/>
                  <a:ext cx="228600" cy="15240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6" name="TextBox 15"/>
              <p:cNvSpPr txBox="1"/>
              <p:nvPr/>
            </p:nvSpPr>
            <p:spPr>
              <a:xfrm>
                <a:off x="771516" y="731695"/>
                <a:ext cx="2941831" cy="312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itchFamily="18" charset="0"/>
                  </a:rPr>
                  <a:t>(A) 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itchFamily="18" charset="0"/>
                  </a:rPr>
                  <a:t>Horseshoe effect of markers in PCA plot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20" name="Flowchart: Process 19"/>
            <p:cNvSpPr/>
            <p:nvPr/>
          </p:nvSpPr>
          <p:spPr>
            <a:xfrm>
              <a:off x="5490873" y="6502690"/>
              <a:ext cx="725092" cy="95361"/>
            </a:xfrm>
            <a:prstGeom prst="flowChartProcess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Times New Roman" panose="02020603050405020304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75274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2617839629"/>
              </p:ext>
            </p:extLst>
          </p:nvPr>
        </p:nvGraphicFramePr>
        <p:xfrm>
          <a:off x="1066800" y="990600"/>
          <a:ext cx="6781800" cy="403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71600" y="5041232"/>
            <a:ext cx="5791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9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etic map distances plotted against physical map distances on SBI-10L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b="4482"/>
          <a:stretch/>
        </p:blipFill>
        <p:spPr>
          <a:xfrm>
            <a:off x="0" y="164562"/>
            <a:ext cx="9144000" cy="623623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990600" y="6409944"/>
            <a:ext cx="6884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S10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y-gree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QTLs LOD scores for both the seasons and across season analysis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084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28600" y="1524000"/>
            <a:ext cx="8686800" cy="3124200"/>
            <a:chOff x="381000" y="4495800"/>
            <a:chExt cx="8458200" cy="2133600"/>
          </a:xfrm>
        </p:grpSpPr>
        <p:graphicFrame>
          <p:nvGraphicFramePr>
            <p:cNvPr id="2" name="Chart 1"/>
            <p:cNvGraphicFramePr/>
            <p:nvPr>
              <p:extLst>
                <p:ext uri="{D42A27DB-BD31-4B8C-83A1-F6EECF244321}">
                  <p14:modId xmlns:p14="http://schemas.microsoft.com/office/powerpoint/2010/main" val="445179938"/>
                </p:ext>
              </p:extLst>
            </p:nvPr>
          </p:nvGraphicFramePr>
          <p:xfrm>
            <a:off x="381000" y="4495800"/>
            <a:ext cx="4229100" cy="2133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>
              <p:extLst>
                <p:ext uri="{D42A27DB-BD31-4B8C-83A1-F6EECF244321}">
                  <p14:modId xmlns:p14="http://schemas.microsoft.com/office/powerpoint/2010/main" val="2843884618"/>
                </p:ext>
              </p:extLst>
            </p:nvPr>
          </p:nvGraphicFramePr>
          <p:xfrm>
            <a:off x="4610100" y="4495800"/>
            <a:ext cx="4229100" cy="2133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8" name="TextBox 7"/>
          <p:cNvSpPr txBox="1"/>
          <p:nvPr/>
        </p:nvSpPr>
        <p:spPr>
          <a:xfrm>
            <a:off x="685800" y="4876800"/>
            <a:ext cx="7239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S2 </a:t>
            </a:r>
            <a:r>
              <a:rPr lang="en-US" sz="1200" dirty="0" smtClean="0">
                <a:latin typeface="Times New Roman" panose="02020603050405020304" pitchFamily="18" charset="0"/>
                <a:cs typeface="Times New Roman" pitchFamily="18" charset="0"/>
              </a:rPr>
              <a:t>Stay-green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ime period for parents and progeny for E1 &amp; E2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9328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28600" y="200579"/>
            <a:ext cx="8915400" cy="5638800"/>
            <a:chOff x="228600" y="810179"/>
            <a:chExt cx="8915400" cy="5638800"/>
          </a:xfrm>
        </p:grpSpPr>
        <p:graphicFrame>
          <p:nvGraphicFramePr>
            <p:cNvPr id="2" name="Chart 1"/>
            <p:cNvGraphicFramePr/>
            <p:nvPr>
              <p:extLst/>
            </p:nvPr>
          </p:nvGraphicFramePr>
          <p:xfrm>
            <a:off x="228600" y="810179"/>
            <a:ext cx="8915400" cy="563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Down Arrow 2"/>
            <p:cNvSpPr/>
            <p:nvPr/>
          </p:nvSpPr>
          <p:spPr>
            <a:xfrm>
              <a:off x="4419600" y="1676400"/>
              <a:ext cx="152400" cy="457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Down Arrow 3"/>
            <p:cNvSpPr/>
            <p:nvPr/>
          </p:nvSpPr>
          <p:spPr>
            <a:xfrm>
              <a:off x="5943600" y="1676400"/>
              <a:ext cx="152400" cy="457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572000" y="1444823"/>
              <a:ext cx="14198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ing period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474094" y="5827725"/>
            <a:ext cx="7603106" cy="646298"/>
          </a:xfrm>
          <a:prstGeom prst="rect">
            <a:avLst/>
          </a:prstGeom>
          <a:noFill/>
        </p:spPr>
        <p:txBody>
          <a:bodyPr wrap="square" lIns="91407" tIns="45704" rIns="91407" bIns="45704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S3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 and B)  Interaction of Environment and Phenotype under terminal drought stress conditions. 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 E1 plott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infall, evaporation, maximum temperature, minimum temperature and flowering perio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ys of sowing with the interval of %GL weekl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ores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3552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04537" y="990600"/>
            <a:ext cx="8915400" cy="5029200"/>
            <a:chOff x="228600" y="1371600"/>
            <a:chExt cx="8915400" cy="5029200"/>
          </a:xfrm>
        </p:grpSpPr>
        <p:graphicFrame>
          <p:nvGraphicFramePr>
            <p:cNvPr id="2" name="Chart 1"/>
            <p:cNvGraphicFramePr/>
            <p:nvPr>
              <p:extLst/>
            </p:nvPr>
          </p:nvGraphicFramePr>
          <p:xfrm>
            <a:off x="228600" y="1371600"/>
            <a:ext cx="8915400" cy="5029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4191000" y="1978223"/>
              <a:ext cx="14198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lang="en-US" sz="14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ing period</a:t>
              </a:r>
              <a:endPara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838200" y="6019800"/>
            <a:ext cx="7162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S3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Contd.,)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vironment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2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otting rainfall, evaporation, maximum temperature, minimum temperature and flowering period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ys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sowing with the interval of %GL weekly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ores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1"/>
          <p:cNvSpPr txBox="1"/>
          <p:nvPr/>
        </p:nvSpPr>
        <p:spPr>
          <a:xfrm>
            <a:off x="2438400" y="5722239"/>
            <a:ext cx="914400" cy="276779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defTabSz="914400"/>
            <a:r>
              <a:rPr lang="en-U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e  of sowing (DOS)</a:t>
            </a:r>
            <a:endParaRPr 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4237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/>
          <p:cNvSpPr txBox="1"/>
          <p:nvPr/>
        </p:nvSpPr>
        <p:spPr>
          <a:xfrm>
            <a:off x="846573" y="6437189"/>
            <a:ext cx="74290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Figure S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distribution for Percent green leaf area (%GL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1, E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ason phenotyp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,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			P1=RSG04008-6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P2=J2614-11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143000" y="914400"/>
            <a:ext cx="6801396" cy="5410200"/>
            <a:chOff x="990600" y="990600"/>
            <a:chExt cx="6801396" cy="5410200"/>
          </a:xfrm>
        </p:grpSpPr>
        <p:grpSp>
          <p:nvGrpSpPr>
            <p:cNvPr id="3" name="Group 14"/>
            <p:cNvGrpSpPr/>
            <p:nvPr/>
          </p:nvGrpSpPr>
          <p:grpSpPr>
            <a:xfrm>
              <a:off x="990600" y="990600"/>
              <a:ext cx="3383280" cy="2590800"/>
              <a:chOff x="0" y="148167"/>
              <a:chExt cx="3429000" cy="2518833"/>
            </a:xfrm>
          </p:grpSpPr>
          <p:pic>
            <p:nvPicPr>
              <p:cNvPr id="2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/>
              <a:srcRect t="4578" b="17602"/>
              <a:stretch/>
            </p:blipFill>
            <p:spPr bwMode="auto">
              <a:xfrm>
                <a:off x="0" y="148167"/>
                <a:ext cx="3429000" cy="25188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2133600" y="1600200"/>
                <a:ext cx="2888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1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447800" y="1600200"/>
                <a:ext cx="2888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2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048000" y="533400"/>
                <a:ext cx="2888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1</a:t>
                </a:r>
                <a:endParaRPr lang="en-US" sz="8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514600" y="1676400"/>
                <a:ext cx="2888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2</a:t>
                </a:r>
                <a:endParaRPr lang="en-US" sz="800" dirty="0"/>
              </a:p>
            </p:txBody>
          </p:sp>
        </p:grpSp>
        <p:grpSp>
          <p:nvGrpSpPr>
            <p:cNvPr id="4" name="Group 23"/>
            <p:cNvGrpSpPr/>
            <p:nvPr/>
          </p:nvGrpSpPr>
          <p:grpSpPr>
            <a:xfrm>
              <a:off x="4386946" y="990600"/>
              <a:ext cx="3383280" cy="2601686"/>
              <a:chOff x="3528044" y="71966"/>
              <a:chExt cx="2798287" cy="2457148"/>
            </a:xfrm>
          </p:grpSpPr>
          <p:pic>
            <p:nvPicPr>
              <p:cNvPr id="17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/>
              <a:srcRect t="4335" b="15966"/>
              <a:stretch/>
            </p:blipFill>
            <p:spPr bwMode="auto">
              <a:xfrm>
                <a:off x="3528044" y="71966"/>
                <a:ext cx="2798287" cy="24571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5120909" y="2095350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1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922832" y="1572985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2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346722" y="904119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1</a:t>
                </a:r>
                <a:endParaRPr lang="en-US" sz="8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424037" y="865392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2</a:t>
                </a:r>
                <a:endParaRPr lang="en-US" sz="800" dirty="0"/>
              </a:p>
            </p:txBody>
          </p:sp>
        </p:grpSp>
        <p:grpSp>
          <p:nvGrpSpPr>
            <p:cNvPr id="5" name="Group 24"/>
            <p:cNvGrpSpPr/>
            <p:nvPr/>
          </p:nvGrpSpPr>
          <p:grpSpPr>
            <a:xfrm>
              <a:off x="1066800" y="3779054"/>
              <a:ext cx="3383280" cy="2621746"/>
              <a:chOff x="6227288" y="194280"/>
              <a:chExt cx="2916712" cy="2548920"/>
            </a:xfrm>
          </p:grpSpPr>
          <p:pic>
            <p:nvPicPr>
              <p:cNvPr id="12" name="Picture 2"/>
              <p:cNvPicPr>
                <a:picLocks noChangeAspect="1" noChangeArrowheads="1"/>
              </p:cNvPicPr>
              <p:nvPr/>
            </p:nvPicPr>
            <p:blipFill rotWithShape="1">
              <a:blip r:embed="rId4" cstate="print"/>
              <a:srcRect t="4612" b="17006"/>
              <a:stretch/>
            </p:blipFill>
            <p:spPr bwMode="auto">
              <a:xfrm>
                <a:off x="6227288" y="224366"/>
                <a:ext cx="2916712" cy="25188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7391400" y="1981200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1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7467600" y="1828800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2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7899438" y="220816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1</a:t>
                </a:r>
                <a:endParaRPr lang="en-US" sz="8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8028340" y="194280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2</a:t>
                </a:r>
                <a:endParaRPr lang="en-US" sz="800" dirty="0"/>
              </a:p>
            </p:txBody>
          </p:sp>
        </p:grpSp>
        <p:grpSp>
          <p:nvGrpSpPr>
            <p:cNvPr id="6" name="Group 29"/>
            <p:cNvGrpSpPr/>
            <p:nvPr/>
          </p:nvGrpSpPr>
          <p:grpSpPr>
            <a:xfrm>
              <a:off x="4408716" y="3733800"/>
              <a:ext cx="3383280" cy="2653145"/>
              <a:chOff x="526338" y="3307965"/>
              <a:chExt cx="3581400" cy="3169034"/>
            </a:xfrm>
          </p:grpSpPr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 rotWithShape="1">
              <a:blip r:embed="rId5" cstate="print"/>
              <a:srcRect t="2726" b="16961"/>
              <a:stretch/>
            </p:blipFill>
            <p:spPr bwMode="auto">
              <a:xfrm>
                <a:off x="526338" y="3307965"/>
                <a:ext cx="3581400" cy="31690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2149538" y="5257800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1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209800" y="5181600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FF0000"/>
                    </a:solidFill>
                  </a:rPr>
                  <a:t>P2</a:t>
                </a:r>
                <a:endParaRPr lang="en-US" sz="8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971800" y="4038599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1</a:t>
                </a:r>
                <a:endParaRPr lang="en-US" sz="8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835338" y="3962400"/>
                <a:ext cx="2888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P2</a:t>
                </a:r>
                <a:endParaRPr lang="en-US" sz="800" dirty="0"/>
              </a:p>
            </p:txBody>
          </p:sp>
        </p:grpSp>
      </p:grpSp>
      <p:sp>
        <p:nvSpPr>
          <p:cNvPr id="33" name="TextBox 32"/>
          <p:cNvSpPr txBox="1"/>
          <p:nvPr/>
        </p:nvSpPr>
        <p:spPr>
          <a:xfrm>
            <a:off x="1718128" y="1010446"/>
            <a:ext cx="12241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7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F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192815" y="3751596"/>
            <a:ext cx="13010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28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F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828800" y="3733800"/>
            <a:ext cx="1293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21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F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192814" y="1010446"/>
            <a:ext cx="1293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14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F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617363" y="3455936"/>
            <a:ext cx="7809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7 DAF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782314" y="3409484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14 DAF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694472" y="6240826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21 DAF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900716" y="6198659"/>
            <a:ext cx="877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28 DAF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1" name="Group 94"/>
          <p:cNvGrpSpPr/>
          <p:nvPr/>
        </p:nvGrpSpPr>
        <p:grpSpPr>
          <a:xfrm>
            <a:off x="8077200" y="776210"/>
            <a:ext cx="859450" cy="468471"/>
            <a:chOff x="304800" y="3017679"/>
            <a:chExt cx="859450" cy="468471"/>
          </a:xfrm>
        </p:grpSpPr>
        <p:grpSp>
          <p:nvGrpSpPr>
            <p:cNvPr id="42" name="Group 91"/>
            <p:cNvGrpSpPr/>
            <p:nvPr/>
          </p:nvGrpSpPr>
          <p:grpSpPr>
            <a:xfrm>
              <a:off x="304800" y="3017679"/>
              <a:ext cx="859450" cy="246221"/>
              <a:chOff x="304800" y="3017679"/>
              <a:chExt cx="859450" cy="246221"/>
            </a:xfrm>
          </p:grpSpPr>
          <p:sp>
            <p:nvSpPr>
              <p:cNvPr id="46" name="Flowchart: Process 45"/>
              <p:cNvSpPr/>
              <p:nvPr/>
            </p:nvSpPr>
            <p:spPr>
              <a:xfrm>
                <a:off x="304800" y="3048000"/>
                <a:ext cx="381000" cy="152400"/>
              </a:xfrm>
              <a:prstGeom prst="flowChartProcess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641350" y="3017679"/>
                <a:ext cx="5229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E1 /13</a:t>
                </a:r>
                <a:endParaRPr lang="en-US" sz="1000" dirty="0"/>
              </a:p>
            </p:txBody>
          </p:sp>
        </p:grpSp>
        <p:grpSp>
          <p:nvGrpSpPr>
            <p:cNvPr id="43" name="Group 93"/>
            <p:cNvGrpSpPr/>
            <p:nvPr/>
          </p:nvGrpSpPr>
          <p:grpSpPr>
            <a:xfrm>
              <a:off x="304800" y="3239929"/>
              <a:ext cx="846750" cy="246221"/>
              <a:chOff x="304800" y="3239929"/>
              <a:chExt cx="846750" cy="246221"/>
            </a:xfrm>
          </p:grpSpPr>
          <p:sp>
            <p:nvSpPr>
              <p:cNvPr id="44" name="Flowchart: Process 43"/>
              <p:cNvSpPr/>
              <p:nvPr/>
            </p:nvSpPr>
            <p:spPr>
              <a:xfrm>
                <a:off x="304800" y="3276600"/>
                <a:ext cx="381000" cy="152400"/>
              </a:xfrm>
              <a:prstGeom prst="flowChartProcess">
                <a:avLst/>
              </a:prstGeom>
              <a:solidFill>
                <a:srgbClr val="0EBE1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628650" y="3239929"/>
                <a:ext cx="5229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E2 /14</a:t>
                </a:r>
                <a:endParaRPr lang="en-US" sz="1000" dirty="0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463526"/>
            <a:ext cx="8001000" cy="339651"/>
          </a:xfrm>
        </p:spPr>
        <p:txBody>
          <a:bodyPr>
            <a:normAutofit fontScale="90000"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4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Contd.,) frequency distribution for Percent green leaf area (%GL) E1,E2 season phenotyping dat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1=RSG04008-6, P2=J2614-11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2" name="Group 94"/>
          <p:cNvGrpSpPr/>
          <p:nvPr/>
        </p:nvGrpSpPr>
        <p:grpSpPr>
          <a:xfrm>
            <a:off x="6749144" y="3867241"/>
            <a:ext cx="859450" cy="468471"/>
            <a:chOff x="304800" y="3017679"/>
            <a:chExt cx="859450" cy="468471"/>
          </a:xfrm>
        </p:grpSpPr>
        <p:grpSp>
          <p:nvGrpSpPr>
            <p:cNvPr id="23" name="Group 91"/>
            <p:cNvGrpSpPr/>
            <p:nvPr/>
          </p:nvGrpSpPr>
          <p:grpSpPr>
            <a:xfrm>
              <a:off x="304800" y="3017679"/>
              <a:ext cx="859450" cy="246221"/>
              <a:chOff x="304800" y="3017679"/>
              <a:chExt cx="859450" cy="246221"/>
            </a:xfrm>
          </p:grpSpPr>
          <p:sp>
            <p:nvSpPr>
              <p:cNvPr id="27" name="Flowchart: Process 26"/>
              <p:cNvSpPr/>
              <p:nvPr/>
            </p:nvSpPr>
            <p:spPr>
              <a:xfrm>
                <a:off x="304800" y="3048000"/>
                <a:ext cx="381000" cy="152400"/>
              </a:xfrm>
              <a:prstGeom prst="flowChartProcess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641350" y="3017679"/>
                <a:ext cx="5229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E1 /13</a:t>
                </a:r>
                <a:endParaRPr lang="en-US" sz="1000" dirty="0"/>
              </a:p>
            </p:txBody>
          </p:sp>
        </p:grpSp>
        <p:grpSp>
          <p:nvGrpSpPr>
            <p:cNvPr id="24" name="Group 93"/>
            <p:cNvGrpSpPr/>
            <p:nvPr/>
          </p:nvGrpSpPr>
          <p:grpSpPr>
            <a:xfrm>
              <a:off x="304800" y="3239929"/>
              <a:ext cx="846750" cy="246221"/>
              <a:chOff x="304800" y="3239929"/>
              <a:chExt cx="846750" cy="246221"/>
            </a:xfrm>
          </p:grpSpPr>
          <p:sp>
            <p:nvSpPr>
              <p:cNvPr id="25" name="Flowchart: Process 24"/>
              <p:cNvSpPr/>
              <p:nvPr/>
            </p:nvSpPr>
            <p:spPr>
              <a:xfrm>
                <a:off x="304800" y="3276600"/>
                <a:ext cx="381000" cy="152400"/>
              </a:xfrm>
              <a:prstGeom prst="flowChartProcess">
                <a:avLst/>
              </a:prstGeom>
              <a:solidFill>
                <a:srgbClr val="0EBE1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628650" y="3239929"/>
                <a:ext cx="5229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E2 /14</a:t>
                </a:r>
                <a:endParaRPr lang="en-US" sz="1000" dirty="0"/>
              </a:p>
            </p:txBody>
          </p:sp>
        </p:grpSp>
      </p:grpSp>
      <p:grpSp>
        <p:nvGrpSpPr>
          <p:cNvPr id="32" name="Group 31"/>
          <p:cNvGrpSpPr/>
          <p:nvPr/>
        </p:nvGrpSpPr>
        <p:grpSpPr>
          <a:xfrm>
            <a:off x="304800" y="184665"/>
            <a:ext cx="7645398" cy="6400801"/>
            <a:chOff x="304800" y="533399"/>
            <a:chExt cx="7645398" cy="6400801"/>
          </a:xfrm>
        </p:grpSpPr>
        <p:grpSp>
          <p:nvGrpSpPr>
            <p:cNvPr id="3" name="Group 2"/>
            <p:cNvGrpSpPr/>
            <p:nvPr/>
          </p:nvGrpSpPr>
          <p:grpSpPr>
            <a:xfrm>
              <a:off x="304800" y="533399"/>
              <a:ext cx="7645398" cy="6400801"/>
              <a:chOff x="228602" y="315687"/>
              <a:chExt cx="7645398" cy="6400801"/>
            </a:xfrm>
          </p:grpSpPr>
          <p:grpSp>
            <p:nvGrpSpPr>
              <p:cNvPr id="4" name="Group 19"/>
              <p:cNvGrpSpPr/>
              <p:nvPr/>
            </p:nvGrpSpPr>
            <p:grpSpPr>
              <a:xfrm>
                <a:off x="4114800" y="391887"/>
                <a:ext cx="3759200" cy="3219992"/>
                <a:chOff x="-265176" y="655322"/>
                <a:chExt cx="3984752" cy="3506214"/>
              </a:xfrm>
            </p:grpSpPr>
            <p:pic>
              <p:nvPicPr>
                <p:cNvPr id="1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/>
                <a:srcRect t="4049" b="16087"/>
                <a:stretch/>
              </p:blipFill>
              <p:spPr bwMode="auto">
                <a:xfrm>
                  <a:off x="-265176" y="655322"/>
                  <a:ext cx="3984752" cy="350621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1407962" y="2136986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srgbClr val="FF0000"/>
                      </a:solidFill>
                    </a:rPr>
                    <a:t>P1</a:t>
                  </a:r>
                  <a:endParaRPr lang="en-US" sz="8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996442" y="1556172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srgbClr val="FF0000"/>
                      </a:solidFill>
                    </a:rPr>
                    <a:t>P2</a:t>
                  </a:r>
                  <a:endParaRPr lang="en-US" sz="8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1581043" y="3713479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P1</a:t>
                  </a:r>
                  <a:endParaRPr lang="en-US" sz="800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446459" y="2219959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P2</a:t>
                  </a:r>
                  <a:endParaRPr lang="en-US" sz="800" dirty="0"/>
                </a:p>
              </p:txBody>
            </p:sp>
          </p:grpSp>
          <p:grpSp>
            <p:nvGrpSpPr>
              <p:cNvPr id="5" name="Group 22"/>
              <p:cNvGrpSpPr/>
              <p:nvPr/>
            </p:nvGrpSpPr>
            <p:grpSpPr>
              <a:xfrm>
                <a:off x="1828800" y="3744688"/>
                <a:ext cx="4389120" cy="2971800"/>
                <a:chOff x="5273523" y="350764"/>
                <a:chExt cx="3692432" cy="3302000"/>
              </a:xfrm>
            </p:grpSpPr>
            <p:pic>
              <p:nvPicPr>
                <p:cNvPr id="1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/>
                <a:srcRect t="4460" b="14373"/>
                <a:stretch/>
              </p:blipFill>
              <p:spPr bwMode="auto">
                <a:xfrm>
                  <a:off x="5273523" y="350764"/>
                  <a:ext cx="3692432" cy="3302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3" name="TextBox 12"/>
                <p:cNvSpPr txBox="1"/>
                <p:nvPr/>
              </p:nvSpPr>
              <p:spPr>
                <a:xfrm>
                  <a:off x="6876143" y="677332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srgbClr val="FF0000"/>
                      </a:solidFill>
                    </a:rPr>
                    <a:t>P1</a:t>
                  </a:r>
                  <a:endParaRPr lang="en-US" sz="8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7132562" y="592665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srgbClr val="FF0000"/>
                      </a:solidFill>
                    </a:rPr>
                    <a:t>P2</a:t>
                  </a:r>
                  <a:endParaRPr lang="en-US" sz="8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6459072" y="2539998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P1</a:t>
                  </a:r>
                  <a:endParaRPr lang="en-US" sz="800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7517190" y="2116665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P2</a:t>
                  </a:r>
                  <a:endParaRPr lang="en-US" sz="800" dirty="0"/>
                </a:p>
              </p:txBody>
            </p:sp>
          </p:grpSp>
          <p:grpSp>
            <p:nvGrpSpPr>
              <p:cNvPr id="6" name="Group 23"/>
              <p:cNvGrpSpPr/>
              <p:nvPr/>
            </p:nvGrpSpPr>
            <p:grpSpPr>
              <a:xfrm>
                <a:off x="228602" y="315687"/>
                <a:ext cx="3713355" cy="3219991"/>
                <a:chOff x="4724402" y="3516087"/>
                <a:chExt cx="3713355" cy="3219991"/>
              </a:xfrm>
            </p:grpSpPr>
            <p:pic>
              <p:nvPicPr>
                <p:cNvPr id="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/>
                <a:srcRect t="3992" b="17304"/>
                <a:stretch/>
              </p:blipFill>
              <p:spPr bwMode="auto">
                <a:xfrm>
                  <a:off x="4724402" y="3516087"/>
                  <a:ext cx="3713355" cy="321999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8" name="TextBox 7"/>
                <p:cNvSpPr txBox="1"/>
                <p:nvPr/>
              </p:nvSpPr>
              <p:spPr>
                <a:xfrm>
                  <a:off x="6324602" y="4343399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srgbClr val="FF0000"/>
                      </a:solidFill>
                    </a:rPr>
                    <a:t>P1</a:t>
                  </a:r>
                  <a:endParaRPr lang="en-US" sz="8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6553202" y="4495799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srgbClr val="FF0000"/>
                      </a:solidFill>
                    </a:rPr>
                    <a:t>P2</a:t>
                  </a:r>
                  <a:endParaRPr lang="en-US" sz="8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7249888" y="3809999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P1</a:t>
                  </a:r>
                  <a:endParaRPr lang="en-US" sz="800" dirty="0"/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6977746" y="5347155"/>
                  <a:ext cx="2888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P2</a:t>
                  </a:r>
                  <a:endParaRPr lang="en-US" sz="800" dirty="0"/>
                </a:p>
              </p:txBody>
            </p:sp>
          </p:grpSp>
        </p:grpSp>
        <p:sp>
          <p:nvSpPr>
            <p:cNvPr id="29" name="TextBox 28"/>
            <p:cNvSpPr txBox="1"/>
            <p:nvPr/>
          </p:nvSpPr>
          <p:spPr>
            <a:xfrm>
              <a:off x="964640" y="605135"/>
              <a:ext cx="12850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35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F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891339" y="668702"/>
              <a:ext cx="12754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42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F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190998" y="3984322"/>
              <a:ext cx="13010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G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49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F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1395590" y="3383047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35 DAF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068969" y="3385338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42 DAF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152654" y="6327445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GL 49 DAF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220" y="6172200"/>
            <a:ext cx="7696200" cy="381000"/>
          </a:xfrm>
        </p:spPr>
        <p:txBody>
          <a:bodyPr>
            <a:no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itchFamily="18" charset="0"/>
              </a:rPr>
              <a:t>Figure S5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distribution for Perc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leaf area (%G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ro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as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typing data 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=RSG04008-6, P2=J2614-11 </a:t>
            </a:r>
          </a:p>
        </p:txBody>
      </p:sp>
      <p:grpSp>
        <p:nvGrpSpPr>
          <p:cNvPr id="3" name="Group 7"/>
          <p:cNvGrpSpPr/>
          <p:nvPr/>
        </p:nvGrpSpPr>
        <p:grpSpPr>
          <a:xfrm>
            <a:off x="457200" y="457200"/>
            <a:ext cx="4114800" cy="2438400"/>
            <a:chOff x="1" y="177800"/>
            <a:chExt cx="4876800" cy="2844800"/>
          </a:xfrm>
        </p:grpSpPr>
        <p:pic>
          <p:nvPicPr>
            <p:cNvPr id="16" name="Picture 3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t="5556" b="5556"/>
            <a:stretch/>
          </p:blipFill>
          <p:spPr bwMode="auto">
            <a:xfrm>
              <a:off x="1" y="177800"/>
              <a:ext cx="4876800" cy="284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TextBox 5"/>
            <p:cNvSpPr txBox="1"/>
            <p:nvPr/>
          </p:nvSpPr>
          <p:spPr>
            <a:xfrm>
              <a:off x="3200400" y="2133600"/>
              <a:ext cx="410750" cy="3231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6"/>
            <p:cNvSpPr txBox="1"/>
            <p:nvPr/>
          </p:nvSpPr>
          <p:spPr>
            <a:xfrm>
              <a:off x="2514600" y="2057400"/>
              <a:ext cx="410750" cy="3231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Group 10"/>
          <p:cNvGrpSpPr/>
          <p:nvPr/>
        </p:nvGrpSpPr>
        <p:grpSpPr>
          <a:xfrm>
            <a:off x="4648200" y="457200"/>
            <a:ext cx="4114800" cy="2438400"/>
            <a:chOff x="4936355" y="452967"/>
            <a:chExt cx="4207645" cy="2370666"/>
          </a:xfrm>
        </p:grpSpPr>
        <p:pic>
          <p:nvPicPr>
            <p:cNvPr id="13" name="Picture 3"/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t="5556" b="5556"/>
            <a:stretch/>
          </p:blipFill>
          <p:spPr bwMode="auto">
            <a:xfrm>
              <a:off x="4936355" y="452967"/>
              <a:ext cx="4207645" cy="2370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7010400" y="1752600"/>
              <a:ext cx="354390" cy="2693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553200" y="1752600"/>
              <a:ext cx="354390" cy="2693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Group 12"/>
          <p:cNvGrpSpPr/>
          <p:nvPr/>
        </p:nvGrpSpPr>
        <p:grpSpPr>
          <a:xfrm>
            <a:off x="228600" y="3276600"/>
            <a:ext cx="4448082" cy="2514600"/>
            <a:chOff x="0" y="3733800"/>
            <a:chExt cx="4448082" cy="2514600"/>
          </a:xfrm>
        </p:grpSpPr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4" cstate="print"/>
            <a:srcRect t="5405" b="5405"/>
            <a:stretch/>
          </p:blipFill>
          <p:spPr bwMode="auto">
            <a:xfrm>
              <a:off x="0" y="3733800"/>
              <a:ext cx="4448082" cy="2514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1669267" y="4447401"/>
              <a:ext cx="5469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,P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Group 15"/>
          <p:cNvGrpSpPr/>
          <p:nvPr/>
        </p:nvGrpSpPr>
        <p:grpSpPr>
          <a:xfrm>
            <a:off x="4427554" y="3200401"/>
            <a:ext cx="4716446" cy="2667000"/>
            <a:chOff x="4427554" y="3733801"/>
            <a:chExt cx="4716446" cy="2667000"/>
          </a:xfrm>
        </p:grpSpPr>
        <p:pic>
          <p:nvPicPr>
            <p:cNvPr id="8" name="Picture 2"/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t="5098" b="5690"/>
            <a:stretch/>
          </p:blipFill>
          <p:spPr bwMode="auto">
            <a:xfrm>
              <a:off x="4427554" y="3733801"/>
              <a:ext cx="4716446" cy="266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6553200" y="4495800"/>
              <a:ext cx="343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72200" y="4495800"/>
              <a:ext cx="343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609600" y="545068"/>
            <a:ext cx="5291801" cy="3096399"/>
            <a:chOff x="609600" y="1002268"/>
            <a:chExt cx="5291801" cy="3096399"/>
          </a:xfrm>
        </p:grpSpPr>
        <p:sp>
          <p:nvSpPr>
            <p:cNvPr id="19" name="TextBox 18"/>
            <p:cNvSpPr txBox="1"/>
            <p:nvPr/>
          </p:nvSpPr>
          <p:spPr>
            <a:xfrm>
              <a:off x="762000" y="1002268"/>
              <a:ext cx="9179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GL 7 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953000" y="1002268"/>
              <a:ext cx="9484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GL 14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09600" y="3810000"/>
              <a:ext cx="9564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%GL 2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807494" y="3821668"/>
              <a:ext cx="9564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GL 28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2072010" y="2823002"/>
            <a:ext cx="5212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7 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047427" y="2857585"/>
            <a:ext cx="5790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14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889267" y="5736967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21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263056" y="5791200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28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282920" y="457200"/>
            <a:ext cx="8641080" cy="5562600"/>
            <a:chOff x="304800" y="881746"/>
            <a:chExt cx="8641080" cy="5562600"/>
          </a:xfrm>
        </p:grpSpPr>
        <p:grpSp>
          <p:nvGrpSpPr>
            <p:cNvPr id="3" name="Group 15"/>
            <p:cNvGrpSpPr/>
            <p:nvPr/>
          </p:nvGrpSpPr>
          <p:grpSpPr>
            <a:xfrm>
              <a:off x="304800" y="881746"/>
              <a:ext cx="8641080" cy="5562600"/>
              <a:chOff x="304800" y="881746"/>
              <a:chExt cx="8641080" cy="5562600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/>
              <a:srcRect t="5556" b="5556"/>
              <a:stretch/>
            </p:blipFill>
            <p:spPr bwMode="auto">
              <a:xfrm>
                <a:off x="304800" y="881746"/>
                <a:ext cx="4327864" cy="2438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2286000" y="1981200"/>
                <a:ext cx="5469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,P2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" name="Group 8"/>
              <p:cNvGrpSpPr/>
              <p:nvPr/>
            </p:nvGrpSpPr>
            <p:grpSpPr>
              <a:xfrm>
                <a:off x="4648200" y="957946"/>
                <a:ext cx="4297680" cy="2362200"/>
                <a:chOff x="4816135" y="272146"/>
                <a:chExt cx="4327865" cy="2362200"/>
              </a:xfrm>
            </p:grpSpPr>
            <p:pic>
              <p:nvPicPr>
                <p:cNvPr id="13" name="Picture 12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/>
                <a:srcRect t="7142" b="6746"/>
                <a:stretch/>
              </p:blipFill>
              <p:spPr bwMode="auto">
                <a:xfrm>
                  <a:off x="4816135" y="272146"/>
                  <a:ext cx="4327865" cy="23622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4" name="TextBox 6"/>
                <p:cNvSpPr txBox="1"/>
                <p:nvPr/>
              </p:nvSpPr>
              <p:spPr>
                <a:xfrm>
                  <a:off x="6477000" y="1905000"/>
                  <a:ext cx="3490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1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TextBox 7"/>
                <p:cNvSpPr txBox="1"/>
                <p:nvPr/>
              </p:nvSpPr>
              <p:spPr>
                <a:xfrm>
                  <a:off x="6934200" y="457200"/>
                  <a:ext cx="3490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2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" name="Group 12"/>
              <p:cNvGrpSpPr/>
              <p:nvPr/>
            </p:nvGrpSpPr>
            <p:grpSpPr>
              <a:xfrm>
                <a:off x="2362200" y="3624947"/>
                <a:ext cx="4297680" cy="2819399"/>
                <a:chOff x="100243" y="3696481"/>
                <a:chExt cx="4928957" cy="2752270"/>
              </a:xfrm>
            </p:grpSpPr>
            <p:grpSp>
              <p:nvGrpSpPr>
                <p:cNvPr id="8" name="Group 11"/>
                <p:cNvGrpSpPr/>
                <p:nvPr/>
              </p:nvGrpSpPr>
              <p:grpSpPr>
                <a:xfrm>
                  <a:off x="100243" y="3696481"/>
                  <a:ext cx="4928957" cy="2752270"/>
                  <a:chOff x="100243" y="3696481"/>
                  <a:chExt cx="4928957" cy="2752270"/>
                </a:xfrm>
              </p:grpSpPr>
              <p:pic>
                <p:nvPicPr>
                  <p:cNvPr id="11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/>
                  <a:srcRect t="6123" b="5783"/>
                  <a:stretch/>
                </p:blipFill>
                <p:spPr bwMode="auto">
                  <a:xfrm>
                    <a:off x="100243" y="3696481"/>
                    <a:ext cx="4928957" cy="275227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1180635" y="5819001"/>
                    <a:ext cx="397477" cy="2704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1</a:t>
                    </a:r>
                    <a:endPara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0" name="TextBox 9"/>
                <p:cNvSpPr txBox="1"/>
                <p:nvPr/>
              </p:nvSpPr>
              <p:spPr>
                <a:xfrm>
                  <a:off x="2209800" y="4191000"/>
                  <a:ext cx="397477" cy="2704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2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16" name="TextBox 15"/>
            <p:cNvSpPr txBox="1"/>
            <p:nvPr/>
          </p:nvSpPr>
          <p:spPr>
            <a:xfrm>
              <a:off x="685800" y="990600"/>
              <a:ext cx="9403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)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%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35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029200" y="1066800"/>
              <a:ext cx="9403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4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743200" y="3733800"/>
              <a:ext cx="9660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G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49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" name="Title 1"/>
          <p:cNvSpPr>
            <a:spLocks noGrp="1"/>
          </p:cNvSpPr>
          <p:nvPr>
            <p:ph type="title"/>
          </p:nvPr>
        </p:nvSpPr>
        <p:spPr>
          <a:xfrm>
            <a:off x="1752600" y="6182088"/>
            <a:ext cx="6045000" cy="334962"/>
          </a:xfrm>
        </p:spPr>
        <p:txBody>
          <a:bodyPr>
            <a:no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ontd.,) f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quenc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for Percent green leaf area (%GL) across season phenotyping dat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=RSG04008-6, P2=J2614-11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067399" y="2794607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3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432704" y="285900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4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236762" y="595969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49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47800" y="4800600"/>
            <a:ext cx="7090785" cy="461633"/>
          </a:xfrm>
          <a:prstGeom prst="rect">
            <a:avLst/>
          </a:prstGeom>
          <a:noFill/>
        </p:spPr>
        <p:txBody>
          <a:bodyPr wrap="none" lIns="91407" tIns="45704" rIns="91407" bIns="45704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N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n SBI-10L. Classification of SNPs showing percent SNPs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ic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ir coding effects 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I-10L SNP effect on SBI-10L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/>
          <p:cNvGraphicFramePr/>
          <p:nvPr>
            <p:extLst/>
          </p:nvPr>
        </p:nvGraphicFramePr>
        <p:xfrm>
          <a:off x="838200" y="1066800"/>
          <a:ext cx="7498080" cy="350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139611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19</TotalTime>
  <Words>700</Words>
  <Application>Microsoft Office PowerPoint</Application>
  <PresentationFormat>On-screen Show (4:3)</PresentationFormat>
  <Paragraphs>137</Paragraphs>
  <Slides>13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ry Figure S4 (Contd.,) frequency distribution for Percent green leaf area (%GL) E1,E2 season phenotyping data  P1=RSG04008-6, P2=J2614-11</vt:lpstr>
      <vt:lpstr>Supplementary Figure S5  frequency distribution for Percent green leaf area (%GL) across season phenotyping data , P1=RSG04008-6, P2=J2614-11 </vt:lpstr>
      <vt:lpstr>Supplementary Figure S5  (Contd.,) frequency distribution for Percent green leaf area (%GL) across season phenotyping data , P1=RSG04008-6, P2=J2614-11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 1 a,b,c,d -%GL trait variation</dc:title>
  <dc:creator>admin</dc:creator>
  <cp:lastModifiedBy>Usha Kiranmayee</cp:lastModifiedBy>
  <cp:revision>98</cp:revision>
  <dcterms:created xsi:type="dcterms:W3CDTF">2006-08-16T00:00:00Z</dcterms:created>
  <dcterms:modified xsi:type="dcterms:W3CDTF">2020-08-17T07:15:10Z</dcterms:modified>
</cp:coreProperties>
</file>